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media/image12.tif" ContentType="image/jpeg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80" r:id="rId1"/>
  </p:sldMasterIdLst>
  <p:notesMasterIdLst>
    <p:notesMasterId r:id="rId9"/>
  </p:notesMasterIdLst>
  <p:sldIdLst>
    <p:sldId id="259" r:id="rId2"/>
    <p:sldId id="256" r:id="rId3"/>
    <p:sldId id="258" r:id="rId4"/>
    <p:sldId id="260" r:id="rId5"/>
    <p:sldId id="263" r:id="rId6"/>
    <p:sldId id="264" r:id="rId7"/>
    <p:sldId id="262" r:id="rId8"/>
  </p:sldIdLst>
  <p:sldSz cx="19799300" cy="23399750"/>
  <p:notesSz cx="6858000" cy="9144000"/>
  <p:defaultTextStyle>
    <a:defPPr>
      <a:defRPr lang="zh-CN"/>
    </a:defPPr>
    <a:lvl1pPr marL="0" algn="l" defTabSz="1413835" rtl="0" eaLnBrk="1" latinLnBrk="0" hangingPunct="1">
      <a:defRPr sz="2784" kern="1200">
        <a:solidFill>
          <a:schemeClr val="tx1"/>
        </a:solidFill>
        <a:latin typeface="+mn-lt"/>
        <a:ea typeface="+mn-ea"/>
        <a:cs typeface="+mn-cs"/>
      </a:defRPr>
    </a:lvl1pPr>
    <a:lvl2pPr marL="706917" algn="l" defTabSz="1413835" rtl="0" eaLnBrk="1" latinLnBrk="0" hangingPunct="1">
      <a:defRPr sz="2784" kern="1200">
        <a:solidFill>
          <a:schemeClr val="tx1"/>
        </a:solidFill>
        <a:latin typeface="+mn-lt"/>
        <a:ea typeface="+mn-ea"/>
        <a:cs typeface="+mn-cs"/>
      </a:defRPr>
    </a:lvl2pPr>
    <a:lvl3pPr marL="1413835" algn="l" defTabSz="1413835" rtl="0" eaLnBrk="1" latinLnBrk="0" hangingPunct="1">
      <a:defRPr sz="2784" kern="1200">
        <a:solidFill>
          <a:schemeClr val="tx1"/>
        </a:solidFill>
        <a:latin typeface="+mn-lt"/>
        <a:ea typeface="+mn-ea"/>
        <a:cs typeface="+mn-cs"/>
      </a:defRPr>
    </a:lvl3pPr>
    <a:lvl4pPr marL="2120752" algn="l" defTabSz="1413835" rtl="0" eaLnBrk="1" latinLnBrk="0" hangingPunct="1">
      <a:defRPr sz="2784" kern="1200">
        <a:solidFill>
          <a:schemeClr val="tx1"/>
        </a:solidFill>
        <a:latin typeface="+mn-lt"/>
        <a:ea typeface="+mn-ea"/>
        <a:cs typeface="+mn-cs"/>
      </a:defRPr>
    </a:lvl4pPr>
    <a:lvl5pPr marL="2827671" algn="l" defTabSz="1413835" rtl="0" eaLnBrk="1" latinLnBrk="0" hangingPunct="1">
      <a:defRPr sz="2784" kern="1200">
        <a:solidFill>
          <a:schemeClr val="tx1"/>
        </a:solidFill>
        <a:latin typeface="+mn-lt"/>
        <a:ea typeface="+mn-ea"/>
        <a:cs typeface="+mn-cs"/>
      </a:defRPr>
    </a:lvl5pPr>
    <a:lvl6pPr marL="3534587" algn="l" defTabSz="1413835" rtl="0" eaLnBrk="1" latinLnBrk="0" hangingPunct="1">
      <a:defRPr sz="2784" kern="1200">
        <a:solidFill>
          <a:schemeClr val="tx1"/>
        </a:solidFill>
        <a:latin typeface="+mn-lt"/>
        <a:ea typeface="+mn-ea"/>
        <a:cs typeface="+mn-cs"/>
      </a:defRPr>
    </a:lvl6pPr>
    <a:lvl7pPr marL="4241504" algn="l" defTabSz="1413835" rtl="0" eaLnBrk="1" latinLnBrk="0" hangingPunct="1">
      <a:defRPr sz="2784" kern="1200">
        <a:solidFill>
          <a:schemeClr val="tx1"/>
        </a:solidFill>
        <a:latin typeface="+mn-lt"/>
        <a:ea typeface="+mn-ea"/>
        <a:cs typeface="+mn-cs"/>
      </a:defRPr>
    </a:lvl7pPr>
    <a:lvl8pPr marL="4948422" algn="l" defTabSz="1413835" rtl="0" eaLnBrk="1" latinLnBrk="0" hangingPunct="1">
      <a:defRPr sz="2784" kern="1200">
        <a:solidFill>
          <a:schemeClr val="tx1"/>
        </a:solidFill>
        <a:latin typeface="+mn-lt"/>
        <a:ea typeface="+mn-ea"/>
        <a:cs typeface="+mn-cs"/>
      </a:defRPr>
    </a:lvl8pPr>
    <a:lvl9pPr marL="5655339" algn="l" defTabSz="1413835" rtl="0" eaLnBrk="1" latinLnBrk="0" hangingPunct="1">
      <a:defRPr sz="2784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964" userDrawn="1">
          <p15:clr>
            <a:srgbClr val="A4A3A4"/>
          </p15:clr>
        </p15:guide>
        <p15:guide id="2" pos="10681" userDrawn="1">
          <p15:clr>
            <a:srgbClr val="A4A3A4"/>
          </p15:clr>
        </p15:guide>
        <p15:guide id="3" pos="181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浅色样式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30" d="100"/>
          <a:sy n="30" d="100"/>
        </p:scale>
        <p:origin x="672" y="156"/>
      </p:cViewPr>
      <p:guideLst>
        <p:guide orient="horz" pos="5964"/>
        <p:guide pos="10681"/>
        <p:guide pos="181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F:\paper%201\&#25237;&#31295;\&#19968;&#23457;\rnaseq&#20998;&#26512;\GO%20&#22270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F:\paper%201\&#25237;&#31295;\&#19968;&#23457;\q-PCR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21776;&#23157;&#23071;\&#21776;&#23157;&#23071;-&#30805;\T616\SiRNR1%20q-PCR\RNR1%205873%209230%2019295%202016-5-5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21776;&#23157;&#23071;\&#21776;&#23157;&#23071;-&#30805;\T616\SiRNR1%20q-PCR\RNR1%205873%209230%2019295%202016-5-5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21776;&#23157;&#23071;\&#21776;&#23157;&#23071;-&#30805;\T616\SiRNR1%20q-PCR\RNR1%205873%209230%2019295%202016-5-5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21776;&#23157;&#23071;\&#21776;&#23157;&#23071;-&#30805;\T616\SiRNR1%20q-PCR\DNA&#22797;&#21046;&#19982;&#32454;&#32990;&#21608;&#26399;%202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F:\paper%201\&#25237;&#31295;\&#19968;&#23457;\q-PCR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F:\paper%201\&#25237;&#31295;\&#19968;&#23457;\q-PCR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F:\paper%201\&#25237;&#31295;\&#19968;&#23457;\q-PCR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F:\paper%201\&#25237;&#31295;\&#19968;&#23457;\q-PCR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1.3162393693884934E-2"/>
          <c:y val="4.9095103745113992E-2"/>
          <c:w val="0.97367521261223011"/>
          <c:h val="0.3819189491895453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2!$E$1</c:f>
              <c:strCache>
                <c:ptCount val="1"/>
                <c:pt idx="0">
                  <c:v>down-regulated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accent1">
                  <a:lumMod val="50000"/>
                </a:schemeClr>
              </a:solidFill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-5400000" spcFirstLastPara="1" vertOverflow="clip" horzOverflow="clip" vert="horz" wrap="square" lIns="38100" tIns="19050" rIns="38100" bIns="19050" anchor="ctr" anchorCtr="1">
                <a:spAutoFit/>
              </a:bodyPr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zh-CN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Sheet2!$C$2:$C$21</c:f>
              <c:strCache>
                <c:ptCount val="20"/>
                <c:pt idx="0">
                  <c:v>mitotic cell cycle</c:v>
                </c:pt>
                <c:pt idx="1">
                  <c:v>cytokinesis by cell plate formation</c:v>
                </c:pt>
                <c:pt idx="2">
                  <c:v>histone H3-K9 methylation</c:v>
                </c:pt>
                <c:pt idx="3">
                  <c:v>cell division</c:v>
                </c:pt>
                <c:pt idx="4">
                  <c:v>cell cycle process</c:v>
                </c:pt>
                <c:pt idx="5">
                  <c:v>chromatin organization</c:v>
                </c:pt>
                <c:pt idx="6">
                  <c:v>covalent chromatin modification</c:v>
                </c:pt>
                <c:pt idx="7">
                  <c:v>histone methylation</c:v>
                </c:pt>
                <c:pt idx="8">
                  <c:v>regulation of cell cycle</c:v>
                </c:pt>
                <c:pt idx="9">
                  <c:v>cell proliferation</c:v>
                </c:pt>
                <c:pt idx="10">
                  <c:v>protein methylation</c:v>
                </c:pt>
                <c:pt idx="11">
                  <c:v>DNA replication</c:v>
                </c:pt>
                <c:pt idx="12">
                  <c:v>microtubule-based process</c:v>
                </c:pt>
                <c:pt idx="13">
                  <c:v>single-organism organelle organization</c:v>
                </c:pt>
                <c:pt idx="14">
                  <c:v>DNA replication initiation</c:v>
                </c:pt>
                <c:pt idx="15">
                  <c:v>macromolecular complex subunit organization</c:v>
                </c:pt>
                <c:pt idx="16">
                  <c:v>microtubule cytoskeleton organization</c:v>
                </c:pt>
                <c:pt idx="17">
                  <c:v>regulation of cell cycle phase transition</c:v>
                </c:pt>
                <c:pt idx="18">
                  <c:v>organelle organization</c:v>
                </c:pt>
                <c:pt idx="19">
                  <c:v>regulation of mitotic cell cycle</c:v>
                </c:pt>
              </c:strCache>
            </c:strRef>
          </c:cat>
          <c:val>
            <c:numRef>
              <c:f>Sheet2!$E$2:$E$21</c:f>
              <c:numCache>
                <c:formatCode>General</c:formatCode>
                <c:ptCount val="20"/>
                <c:pt idx="0">
                  <c:v>37</c:v>
                </c:pt>
                <c:pt idx="1">
                  <c:v>28</c:v>
                </c:pt>
                <c:pt idx="2">
                  <c:v>25</c:v>
                </c:pt>
                <c:pt idx="3">
                  <c:v>35</c:v>
                </c:pt>
                <c:pt idx="4">
                  <c:v>39</c:v>
                </c:pt>
                <c:pt idx="5">
                  <c:v>41</c:v>
                </c:pt>
                <c:pt idx="6">
                  <c:v>34</c:v>
                </c:pt>
                <c:pt idx="7">
                  <c:v>27</c:v>
                </c:pt>
                <c:pt idx="8">
                  <c:v>27</c:v>
                </c:pt>
                <c:pt idx="9">
                  <c:v>20</c:v>
                </c:pt>
                <c:pt idx="10">
                  <c:v>27</c:v>
                </c:pt>
                <c:pt idx="11">
                  <c:v>28</c:v>
                </c:pt>
                <c:pt idx="12">
                  <c:v>27</c:v>
                </c:pt>
                <c:pt idx="13">
                  <c:v>46</c:v>
                </c:pt>
                <c:pt idx="14">
                  <c:v>17</c:v>
                </c:pt>
                <c:pt idx="15">
                  <c:v>46</c:v>
                </c:pt>
                <c:pt idx="16">
                  <c:v>22</c:v>
                </c:pt>
                <c:pt idx="17">
                  <c:v>15</c:v>
                </c:pt>
                <c:pt idx="18">
                  <c:v>57</c:v>
                </c:pt>
                <c:pt idx="19">
                  <c:v>16</c:v>
                </c:pt>
              </c:numCache>
            </c:numRef>
          </c:val>
        </c:ser>
        <c:ser>
          <c:idx val="1"/>
          <c:order val="1"/>
          <c:tx>
            <c:strRef>
              <c:f>Sheet2!$F$1</c:f>
              <c:strCache>
                <c:ptCount val="1"/>
                <c:pt idx="0">
                  <c:v>up-regulated</c:v>
                </c:pt>
              </c:strCache>
            </c:strRef>
          </c:tx>
          <c:spPr>
            <a:solidFill>
              <a:schemeClr val="accent2"/>
            </a:solidFill>
            <a:ln>
              <a:solidFill>
                <a:schemeClr val="accent2"/>
              </a:solidFill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-5400000" spcFirstLastPara="1" vertOverflow="clip" horzOverflow="clip" vert="horz" wrap="square" lIns="38100" tIns="19050" rIns="38100" bIns="19050" anchor="ctr" anchorCtr="1">
                <a:spAutoFit/>
              </a:bodyPr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zh-CN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Sheet2!$C$2:$C$21</c:f>
              <c:strCache>
                <c:ptCount val="20"/>
                <c:pt idx="0">
                  <c:v>mitotic cell cycle</c:v>
                </c:pt>
                <c:pt idx="1">
                  <c:v>cytokinesis by cell plate formation</c:v>
                </c:pt>
                <c:pt idx="2">
                  <c:v>histone H3-K9 methylation</c:v>
                </c:pt>
                <c:pt idx="3">
                  <c:v>cell division</c:v>
                </c:pt>
                <c:pt idx="4">
                  <c:v>cell cycle process</c:v>
                </c:pt>
                <c:pt idx="5">
                  <c:v>chromatin organization</c:v>
                </c:pt>
                <c:pt idx="6">
                  <c:v>covalent chromatin modification</c:v>
                </c:pt>
                <c:pt idx="7">
                  <c:v>histone methylation</c:v>
                </c:pt>
                <c:pt idx="8">
                  <c:v>regulation of cell cycle</c:v>
                </c:pt>
                <c:pt idx="9">
                  <c:v>cell proliferation</c:v>
                </c:pt>
                <c:pt idx="10">
                  <c:v>protein methylation</c:v>
                </c:pt>
                <c:pt idx="11">
                  <c:v>DNA replication</c:v>
                </c:pt>
                <c:pt idx="12">
                  <c:v>microtubule-based process</c:v>
                </c:pt>
                <c:pt idx="13">
                  <c:v>single-organism organelle organization</c:v>
                </c:pt>
                <c:pt idx="14">
                  <c:v>DNA replication initiation</c:v>
                </c:pt>
                <c:pt idx="15">
                  <c:v>macromolecular complex subunit organization</c:v>
                </c:pt>
                <c:pt idx="16">
                  <c:v>microtubule cytoskeleton organization</c:v>
                </c:pt>
                <c:pt idx="17">
                  <c:v>regulation of cell cycle phase transition</c:v>
                </c:pt>
                <c:pt idx="18">
                  <c:v>organelle organization</c:v>
                </c:pt>
                <c:pt idx="19">
                  <c:v>regulation of mitotic cell cycle</c:v>
                </c:pt>
              </c:strCache>
            </c:strRef>
          </c:cat>
          <c:val>
            <c:numRef>
              <c:f>Sheet2!$F$2:$F$21</c:f>
              <c:numCache>
                <c:formatCode>General</c:formatCode>
                <c:ptCount val="2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</c:v>
                </c:pt>
                <c:pt idx="9">
                  <c:v>1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2</c:v>
                </c:pt>
                <c:pt idx="14">
                  <c:v>0</c:v>
                </c:pt>
                <c:pt idx="15">
                  <c:v>2</c:v>
                </c:pt>
                <c:pt idx="16">
                  <c:v>0</c:v>
                </c:pt>
                <c:pt idx="17">
                  <c:v>0</c:v>
                </c:pt>
                <c:pt idx="18">
                  <c:v>2</c:v>
                </c:pt>
                <c:pt idx="19">
                  <c:v>0</c:v>
                </c:pt>
              </c:numCache>
            </c:numRef>
          </c:val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-20"/>
        <c:axId val="286633328"/>
        <c:axId val="286636688"/>
      </c:barChart>
      <c:catAx>
        <c:axId val="28663332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5400000" spcFirstLastPara="1" vertOverflow="ellipsis" wrap="square" anchor="t" anchorCtr="0"/>
          <a:lstStyle/>
          <a:p>
            <a:pPr>
              <a:defRPr sz="1800" b="1" i="0" u="none" strike="noStrike" kern="1200" cap="none" spc="120" normalizeH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286636688"/>
        <c:crossesAt val="-1"/>
        <c:auto val="1"/>
        <c:lblAlgn val="ctr"/>
        <c:lblOffset val="100"/>
        <c:noMultiLvlLbl val="0"/>
      </c:catAx>
      <c:valAx>
        <c:axId val="286636688"/>
        <c:scaling>
          <c:orientation val="minMax"/>
          <c:min val="0"/>
        </c:scaling>
        <c:delete val="1"/>
        <c:axPos val="l"/>
        <c:numFmt formatCode="General" sourceLinked="1"/>
        <c:majorTickMark val="none"/>
        <c:minorTickMark val="none"/>
        <c:tickLblPos val="nextTo"/>
        <c:crossAx val="28663332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lang="en-US" altLang="zh-CN" sz="2400" b="1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 sz="2400" b="1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OsCDK2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lang="en-US" altLang="zh-CN" sz="2400" b="1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0.1076477298004388"/>
          <c:y val="0.13480136849861624"/>
          <c:w val="0.84095694933674503"/>
          <c:h val="0.5664228536948109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5!$A$16</c:f>
              <c:strCache>
                <c:ptCount val="1"/>
                <c:pt idx="0">
                  <c:v>OsCDK2</c:v>
                </c:pt>
              </c:strCache>
            </c:strRef>
          </c:tx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5!$B$31:$J$31</c:f>
                <c:numCache>
                  <c:formatCode>General</c:formatCode>
                  <c:ptCount val="9"/>
                  <c:pt idx="0">
                    <c:v>0.11631438258947835</c:v>
                  </c:pt>
                  <c:pt idx="1">
                    <c:v>0.28988587269430766</c:v>
                  </c:pt>
                  <c:pt idx="2">
                    <c:v>0.14535115190297176</c:v>
                  </c:pt>
                  <c:pt idx="3">
                    <c:v>0.13943440545724581</c:v>
                  </c:pt>
                  <c:pt idx="4">
                    <c:v>7.1505309205709466E-2</c:v>
                  </c:pt>
                  <c:pt idx="5">
                    <c:v>0.22700449188195343</c:v>
                  </c:pt>
                  <c:pt idx="6">
                    <c:v>7.1300356092266537E-2</c:v>
                  </c:pt>
                  <c:pt idx="7">
                    <c:v>0.14978468903985531</c:v>
                  </c:pt>
                  <c:pt idx="8">
                    <c:v>0.14930722973591193</c:v>
                  </c:pt>
                </c:numCache>
              </c:numRef>
            </c:plus>
            <c:minus>
              <c:numRef>
                <c:f>Sheet5!$B$46:$J$46</c:f>
                <c:numCache>
                  <c:formatCode>General</c:formatCode>
                  <c:ptCount val="9"/>
                  <c:pt idx="0">
                    <c:v>0.14326625554995087</c:v>
                  </c:pt>
                  <c:pt idx="1">
                    <c:v>0.27307818628465697</c:v>
                  </c:pt>
                  <c:pt idx="2">
                    <c:v>0.21688380794135287</c:v>
                  </c:pt>
                  <c:pt idx="3">
                    <c:v>9.4013079668092844E-2</c:v>
                  </c:pt>
                  <c:pt idx="4">
                    <c:v>6.652014733347808E-2</c:v>
                  </c:pt>
                  <c:pt idx="5">
                    <c:v>0.16211529678504871</c:v>
                  </c:pt>
                  <c:pt idx="6">
                    <c:v>5.9184132077759466E-2</c:v>
                  </c:pt>
                  <c:pt idx="7">
                    <c:v>0.12462276846553116</c:v>
                  </c:pt>
                  <c:pt idx="8">
                    <c:v>0.16310016298680297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5!$B$2:$J$2</c:f>
              <c:strCache>
                <c:ptCount val="9"/>
                <c:pt idx="0">
                  <c:v>OsC1-4 T1-W</c:v>
                </c:pt>
                <c:pt idx="1">
                  <c:v>OsC2-12 T1-W</c:v>
                </c:pt>
                <c:pt idx="2">
                  <c:v>OsC1-8 T2-W</c:v>
                </c:pt>
                <c:pt idx="3">
                  <c:v>OsC1-4 T1-1</c:v>
                </c:pt>
                <c:pt idx="4">
                  <c:v>OsC1-4 T1-2</c:v>
                </c:pt>
                <c:pt idx="5">
                  <c:v>OsC2-12 T1-1</c:v>
                </c:pt>
                <c:pt idx="6">
                  <c:v>OsC2-12 T1-2</c:v>
                </c:pt>
                <c:pt idx="7">
                  <c:v>OsC1-8 T2-1</c:v>
                </c:pt>
                <c:pt idx="8">
                  <c:v>OsC1-8 T2-2</c:v>
                </c:pt>
              </c:strCache>
            </c:strRef>
          </c:cat>
          <c:val>
            <c:numRef>
              <c:f>Sheet5!$B$16:$J$16</c:f>
              <c:numCache>
                <c:formatCode>General</c:formatCode>
                <c:ptCount val="9"/>
                <c:pt idx="0">
                  <c:v>2.0312399766225364</c:v>
                </c:pt>
                <c:pt idx="1">
                  <c:v>1.6035439478172024</c:v>
                </c:pt>
                <c:pt idx="2">
                  <c:v>1.6362383670633402</c:v>
                </c:pt>
                <c:pt idx="3">
                  <c:v>0.18070751295721324</c:v>
                </c:pt>
                <c:pt idx="4">
                  <c:v>0.25547036782837029</c:v>
                </c:pt>
                <c:pt idx="5">
                  <c:v>0.36602730418139701</c:v>
                </c:pt>
                <c:pt idx="6">
                  <c:v>0.29260099416816249</c:v>
                </c:pt>
                <c:pt idx="7">
                  <c:v>0.50830388288207906</c:v>
                </c:pt>
                <c:pt idx="8">
                  <c:v>0.7403364268283213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87209648"/>
        <c:axId val="287215248"/>
      </c:barChart>
      <c:catAx>
        <c:axId val="2872096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1" i="1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287215248"/>
        <c:crosses val="autoZero"/>
        <c:auto val="1"/>
        <c:lblAlgn val="ctr"/>
        <c:lblOffset val="100"/>
        <c:noMultiLvlLbl val="0"/>
      </c:catAx>
      <c:valAx>
        <c:axId val="28721524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19050">
            <a:solidFill>
              <a:schemeClr val="tx1">
                <a:lumMod val="65000"/>
                <a:lumOff val="3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2872096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zh-CN" sz="2400" b="1" i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iSTL1</a:t>
            </a:r>
            <a:endParaRPr lang="zh-CN" altLang="en-US" sz="2400" b="1" i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45686920713510915"/>
          <c:y val="2.670864340070431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0.10396241337921863"/>
          <c:y val="0.15372752066327167"/>
          <c:w val="0.79743748880661325"/>
          <c:h val="0.720083953468075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J$22</c:f>
              <c:strCache>
                <c:ptCount val="1"/>
                <c:pt idx="0">
                  <c:v>Yugu 1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-2.861001508220874E-3"/>
                  <c:y val="-5.3779200388452415E-2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zh-CN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both"/>
            <c:errValType val="cust"/>
            <c:noEndCap val="0"/>
            <c:plus>
              <c:numRef>
                <c:f>Sheet1!$E$3:$E$6</c:f>
                <c:numCache>
                  <c:formatCode>General</c:formatCode>
                  <c:ptCount val="4"/>
                  <c:pt idx="0">
                    <c:v>0.12726882415637908</c:v>
                  </c:pt>
                  <c:pt idx="1">
                    <c:v>5.6867307645906973E-3</c:v>
                  </c:pt>
                  <c:pt idx="2">
                    <c:v>4.2977410510474517E-3</c:v>
                  </c:pt>
                  <c:pt idx="3">
                    <c:v>4.0260927267767532E-2</c:v>
                  </c:pt>
                </c:numCache>
              </c:numRef>
            </c:plus>
            <c:minus>
              <c:numRef>
                <c:f>Sheet1!$H$3:$H$6</c:f>
                <c:numCache>
                  <c:formatCode>General</c:formatCode>
                  <c:ptCount val="4"/>
                  <c:pt idx="0">
                    <c:v>0.11874680193380582</c:v>
                  </c:pt>
                  <c:pt idx="1">
                    <c:v>5.2939676729837626E-3</c:v>
                  </c:pt>
                  <c:pt idx="2">
                    <c:v>4.055527653305302E-3</c:v>
                  </c:pt>
                  <c:pt idx="3">
                    <c:v>3.6619973583115528E-2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J$19:$M$19</c:f>
              <c:strCache>
                <c:ptCount val="4"/>
                <c:pt idx="0">
                  <c:v>LB</c:v>
                </c:pt>
                <c:pt idx="1">
                  <c:v>LMB</c:v>
                </c:pt>
                <c:pt idx="2">
                  <c:v>LMA</c:v>
                </c:pt>
                <c:pt idx="3">
                  <c:v>LA</c:v>
                </c:pt>
              </c:strCache>
            </c:strRef>
          </c:cat>
          <c:val>
            <c:numRef>
              <c:f>Sheet1!$C$22:$C$25</c:f>
              <c:numCache>
                <c:formatCode>0.00_ </c:formatCode>
                <c:ptCount val="4"/>
                <c:pt idx="0">
                  <c:v>1.7733778978439165</c:v>
                </c:pt>
                <c:pt idx="1">
                  <c:v>7.6650198239185729E-2</c:v>
                </c:pt>
                <c:pt idx="2">
                  <c:v>7.19597175124988E-2</c:v>
                </c:pt>
                <c:pt idx="3">
                  <c:v>0.40493623942328816</c:v>
                </c:pt>
              </c:numCache>
            </c:numRef>
          </c:val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00"/>
        <c:overlap val="-50"/>
        <c:axId val="277896256"/>
        <c:axId val="277901296"/>
      </c:barChart>
      <c:catAx>
        <c:axId val="2778962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277901296"/>
        <c:crosses val="autoZero"/>
        <c:auto val="1"/>
        <c:lblAlgn val="ctr"/>
        <c:lblOffset val="100"/>
        <c:noMultiLvlLbl val="0"/>
      </c:catAx>
      <c:valAx>
        <c:axId val="277901296"/>
        <c:scaling>
          <c:orientation val="minMax"/>
        </c:scaling>
        <c:delete val="0"/>
        <c:axPos val="l"/>
        <c:numFmt formatCode="0.00_ 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277896256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59613381827684353"/>
          <c:y val="0.15290372393908411"/>
          <c:w val="0.36002707814025892"/>
          <c:h val="0.1517678137042321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en-US" altLang="zh-CN" sz="2400" b="1" i="0" u="none" strike="noStrike" kern="1200" spc="0" baseline="0" dirty="0" smtClean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 sz="2400" b="1" i="0" u="none" strike="noStrike" kern="1200" baseline="0" dirty="0" smtClean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iSTL1-2</a:t>
            </a:r>
          </a:p>
        </c:rich>
      </c:tx>
      <c:layout>
        <c:manualLayout>
          <c:xMode val="edge"/>
          <c:yMode val="edge"/>
          <c:x val="0.42569558207943164"/>
          <c:y val="4.28763389583359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en-US" altLang="zh-CN" sz="2400" b="1" i="0" u="none" strike="noStrike" kern="1200" spc="0" baseline="0" dirty="0" smtClean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0.14583220925111059"/>
          <c:y val="0.15840654379764468"/>
          <c:w val="0.87786329833770782"/>
          <c:h val="0.6738714697817920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J$22</c:f>
              <c:strCache>
                <c:ptCount val="1"/>
                <c:pt idx="0">
                  <c:v>Yugu 1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-9.3678289085299404E-3"/>
                  <c:y val="-4.1004125380929402E-2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3"/>
              <c:layout>
                <c:manualLayout>
                  <c:x val="-1.249043854470655E-2"/>
                  <c:y val="-1.9135258511100386E-2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zh-CN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both"/>
            <c:errValType val="cust"/>
            <c:noEndCap val="0"/>
            <c:plus>
              <c:numRef>
                <c:f>Sheet1!$F$3:$F$6</c:f>
                <c:numCache>
                  <c:formatCode>General</c:formatCode>
                  <c:ptCount val="4"/>
                  <c:pt idx="0">
                    <c:v>5.1112300851867354E-2</c:v>
                  </c:pt>
                  <c:pt idx="1">
                    <c:v>5.0908546096389076E-3</c:v>
                  </c:pt>
                  <c:pt idx="2">
                    <c:v>2.5963908878444512E-3</c:v>
                  </c:pt>
                  <c:pt idx="3">
                    <c:v>2.5963167094937067E-2</c:v>
                  </c:pt>
                </c:numCache>
              </c:numRef>
            </c:plus>
            <c:minus>
              <c:numRef>
                <c:f>Sheet1!$I$3:$I$6</c:f>
                <c:numCache>
                  <c:formatCode>General</c:formatCode>
                  <c:ptCount val="4"/>
                  <c:pt idx="0">
                    <c:v>4.7585262481570911E-2</c:v>
                  </c:pt>
                  <c:pt idx="1">
                    <c:v>4.6299460994486258E-3</c:v>
                  </c:pt>
                  <c:pt idx="2">
                    <c:v>2.3937890281045746E-3</c:v>
                  </c:pt>
                  <c:pt idx="3">
                    <c:v>2.4236206101130309E-2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J$19:$M$19</c:f>
              <c:strCache>
                <c:ptCount val="4"/>
                <c:pt idx="0">
                  <c:v>LB</c:v>
                </c:pt>
                <c:pt idx="1">
                  <c:v>LMB</c:v>
                </c:pt>
                <c:pt idx="2">
                  <c:v>LMA</c:v>
                </c:pt>
                <c:pt idx="3">
                  <c:v>LA</c:v>
                </c:pt>
              </c:strCache>
            </c:strRef>
          </c:cat>
          <c:val>
            <c:numRef>
              <c:f>Sheet1!$B$39:$B$42</c:f>
              <c:numCache>
                <c:formatCode>0.00_ </c:formatCode>
                <c:ptCount val="4"/>
                <c:pt idx="0">
                  <c:v>0.68958485752701082</c:v>
                </c:pt>
                <c:pt idx="1">
                  <c:v>5.1138961250740182E-2</c:v>
                </c:pt>
                <c:pt idx="2">
                  <c:v>3.0676974179667447E-2</c:v>
                </c:pt>
                <c:pt idx="3">
                  <c:v>0.3643676209292329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50"/>
        <c:axId val="277900176"/>
        <c:axId val="215414112"/>
      </c:barChart>
      <c:catAx>
        <c:axId val="2779001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215414112"/>
        <c:crosses val="autoZero"/>
        <c:auto val="1"/>
        <c:lblAlgn val="ctr"/>
        <c:lblOffset val="100"/>
        <c:noMultiLvlLbl val="0"/>
      </c:catAx>
      <c:valAx>
        <c:axId val="215414112"/>
        <c:scaling>
          <c:orientation val="minMax"/>
          <c:max val="1"/>
        </c:scaling>
        <c:delete val="0"/>
        <c:axPos val="l"/>
        <c:numFmt formatCode="0.00_ 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277900176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legend>
      <c:legendPos val="t"/>
      <c:legendEntry>
        <c:idx val="0"/>
        <c:txPr>
          <a:bodyPr rot="0" spcFirstLastPara="1" vertOverflow="ellipsis" vert="horz" wrap="square" anchor="ctr" anchorCtr="1"/>
          <a:lstStyle/>
          <a:p>
            <a:pPr>
              <a:defRPr lang="zh-CN" altLang="en-US" sz="1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</c:legendEntry>
      <c:layout>
        <c:manualLayout>
          <c:xMode val="edge"/>
          <c:yMode val="edge"/>
          <c:x val="0.62206391711463005"/>
          <c:y val="0.17943663560397893"/>
          <c:w val="0.31548389016183725"/>
          <c:h val="0.1357311885772192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zh-CN" altLang="en-US" sz="18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en-US" altLang="zh-CN" sz="2400" b="1" i="0" u="none" strike="noStrike" kern="1200" spc="0" baseline="0" dirty="0" smtClean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 sz="2400" b="1" i="0" u="none" strike="noStrike" kern="1200" baseline="0" dirty="0" smtClean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iSTL1-3</a:t>
            </a:r>
          </a:p>
        </c:rich>
      </c:tx>
      <c:layout>
        <c:manualLayout>
          <c:xMode val="edge"/>
          <c:yMode val="edge"/>
          <c:x val="0.42609538263603752"/>
          <c:y val="0.1018518518518518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en-US" altLang="zh-CN" sz="2400" b="1" i="0" u="none" strike="noStrike" kern="1200" spc="0" baseline="0" dirty="0" smtClean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0.10219659869381863"/>
          <c:y val="0.20549697305328032"/>
          <c:w val="0.84040987648381771"/>
          <c:h val="0.6826665293325201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J$22</c:f>
              <c:strCache>
                <c:ptCount val="1"/>
                <c:pt idx="0">
                  <c:v>Yugu 1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zh-CN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both"/>
            <c:errValType val="cust"/>
            <c:noEndCap val="0"/>
            <c:plus>
              <c:numRef>
                <c:f>Sheet1!$G$3:$G$6</c:f>
                <c:numCache>
                  <c:formatCode>General</c:formatCode>
                  <c:ptCount val="4"/>
                  <c:pt idx="0">
                    <c:v>1.9151591395745252E-3</c:v>
                  </c:pt>
                  <c:pt idx="1">
                    <c:v>7.0054409873465738E-4</c:v>
                  </c:pt>
                  <c:pt idx="2">
                    <c:v>3.2453668200582361E-4</c:v>
                  </c:pt>
                  <c:pt idx="3">
                    <c:v>3.9058356519478671E-3</c:v>
                  </c:pt>
                </c:numCache>
              </c:numRef>
            </c:plus>
            <c:minus>
              <c:numRef>
                <c:f>Sheet1!$J$3:$J$6</c:f>
                <c:numCache>
                  <c:formatCode>General</c:formatCode>
                  <c:ptCount val="4"/>
                  <c:pt idx="0">
                    <c:v>1.6407605937905738E-3</c:v>
                  </c:pt>
                  <c:pt idx="1">
                    <c:v>3.8824870745232274E-4</c:v>
                  </c:pt>
                  <c:pt idx="2">
                    <c:v>2.3494250306113249E-4</c:v>
                  </c:pt>
                  <c:pt idx="3">
                    <c:v>3.364151764104744E-3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J$19:$M$19</c:f>
              <c:strCache>
                <c:ptCount val="4"/>
                <c:pt idx="0">
                  <c:v>LB</c:v>
                </c:pt>
                <c:pt idx="1">
                  <c:v>LMB</c:v>
                </c:pt>
                <c:pt idx="2">
                  <c:v>LMA</c:v>
                </c:pt>
                <c:pt idx="3">
                  <c:v>LA</c:v>
                </c:pt>
              </c:strCache>
            </c:strRef>
          </c:cat>
          <c:val>
            <c:numRef>
              <c:f>Sheet1!$I$33:$I$36</c:f>
              <c:numCache>
                <c:formatCode>0.00_);[Red]\(0.00\)</c:formatCode>
                <c:ptCount val="4"/>
                <c:pt idx="0">
                  <c:v>1.1451655613094013E-2</c:v>
                </c:pt>
                <c:pt idx="1">
                  <c:v>8.7092332592635232E-4</c:v>
                </c:pt>
                <c:pt idx="2">
                  <c:v>8.5103140967084405E-4</c:v>
                </c:pt>
                <c:pt idx="3">
                  <c:v>2.4257365215576317E-2</c:v>
                </c:pt>
              </c:numCache>
            </c:numRef>
          </c:val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00"/>
        <c:overlap val="-27"/>
        <c:axId val="215409632"/>
        <c:axId val="292231952"/>
      </c:barChart>
      <c:catAx>
        <c:axId val="2154096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292231952"/>
        <c:crosses val="autoZero"/>
        <c:auto val="1"/>
        <c:lblAlgn val="ctr"/>
        <c:lblOffset val="100"/>
        <c:noMultiLvlLbl val="0"/>
      </c:catAx>
      <c:valAx>
        <c:axId val="292231952"/>
        <c:scaling>
          <c:orientation val="minMax"/>
          <c:max val="0.5"/>
          <c:min val="0"/>
        </c:scaling>
        <c:delete val="0"/>
        <c:axPos val="l"/>
        <c:numFmt formatCode="0.00_);[Red]\(0.00\)" sourceLinked="1"/>
        <c:majorTickMark val="out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215409632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legend>
      <c:legendPos val="t"/>
      <c:legendEntry>
        <c:idx val="0"/>
        <c:txPr>
          <a:bodyPr rot="0" spcFirstLastPara="1" vertOverflow="ellipsis" vert="horz" wrap="square" anchor="ctr" anchorCtr="1"/>
          <a:lstStyle/>
          <a:p>
            <a:pPr>
              <a:defRPr lang="zh-CN" altLang="en-US" sz="1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</c:legendEntry>
      <c:layout>
        <c:manualLayout>
          <c:xMode val="edge"/>
          <c:yMode val="edge"/>
          <c:x val="0.62233057115710733"/>
          <c:y val="0.21979653580069639"/>
          <c:w val="0.32668334395708803"/>
          <c:h val="0.1346665879981446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zh-CN" altLang="en-US" sz="18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en-US" altLang="zh-CN" sz="2400" b="1" i="0" u="none" strike="noStrike" kern="1200" spc="0" baseline="0" dirty="0" smtClean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 sz="2000" b="1" i="0" u="none" strike="noStrike" kern="1200" baseline="0" dirty="0" smtClean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Relative expression level of genes in the leaf base of Yugu1 and sistl1 </a:t>
            </a:r>
          </a:p>
        </c:rich>
      </c:tx>
      <c:layout>
        <c:manualLayout>
          <c:xMode val="edge"/>
          <c:yMode val="edge"/>
          <c:x val="0.16948215016854384"/>
          <c:y val="4.1046395019167046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en-US" altLang="zh-CN" sz="2400" b="1" i="0" u="none" strike="noStrike" kern="1200" spc="0" baseline="0" dirty="0" smtClean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0.1126498334561402"/>
          <c:y val="0.15825880896627426"/>
          <c:w val="0.88735016654385979"/>
          <c:h val="0.741311353552162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2!$J$93</c:f>
              <c:strCache>
                <c:ptCount val="1"/>
                <c:pt idx="0">
                  <c:v>Yugu 1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1.2731334408019993E-17"/>
                  <c:y val="-4.2061577306138132E-2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"/>
              <c:layout>
                <c:manualLayout>
                  <c:x val="0"/>
                  <c:y val="-2.9136771523356066E-2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4"/>
              <c:layout>
                <c:manualLayout>
                  <c:x val="-2.0370135052831988E-16"/>
                  <c:y val="-1.1471339265310399E-2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zh-CN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both"/>
            <c:errValType val="cust"/>
            <c:noEndCap val="0"/>
            <c:plus>
              <c:numRef>
                <c:f>Sheet2!$K$96:$O$96</c:f>
                <c:numCache>
                  <c:formatCode>General</c:formatCode>
                  <c:ptCount val="5"/>
                  <c:pt idx="0">
                    <c:v>0.12726882415637908</c:v>
                  </c:pt>
                  <c:pt idx="1">
                    <c:v>5.1112300851867354E-2</c:v>
                  </c:pt>
                  <c:pt idx="2">
                    <c:v>1.9151591395745252E-3</c:v>
                  </c:pt>
                  <c:pt idx="3">
                    <c:v>7.306875665510193E-3</c:v>
                  </c:pt>
                  <c:pt idx="4">
                    <c:v>4.3615712629892278E-2</c:v>
                  </c:pt>
                </c:numCache>
              </c:numRef>
            </c:plus>
            <c:minus>
              <c:numRef>
                <c:f>Sheet2!$K$96:$O$96</c:f>
                <c:numCache>
                  <c:formatCode>General</c:formatCode>
                  <c:ptCount val="5"/>
                  <c:pt idx="0">
                    <c:v>0.12726882415637908</c:v>
                  </c:pt>
                  <c:pt idx="1">
                    <c:v>5.1112300851867354E-2</c:v>
                  </c:pt>
                  <c:pt idx="2">
                    <c:v>1.9151591395745252E-3</c:v>
                  </c:pt>
                  <c:pt idx="3">
                    <c:v>7.306875665510193E-3</c:v>
                  </c:pt>
                  <c:pt idx="4">
                    <c:v>4.3615712629892278E-2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2!$K$92:$O$92</c:f>
              <c:strCache>
                <c:ptCount val="5"/>
                <c:pt idx="0">
                  <c:v>SiSTL1</c:v>
                </c:pt>
                <c:pt idx="1">
                  <c:v>SiSTL1-2</c:v>
                </c:pt>
                <c:pt idx="2">
                  <c:v>SiSTL1-3</c:v>
                </c:pt>
                <c:pt idx="3">
                  <c:v>E2F1</c:v>
                </c:pt>
                <c:pt idx="4">
                  <c:v>E2F2</c:v>
                </c:pt>
              </c:strCache>
            </c:strRef>
          </c:cat>
          <c:val>
            <c:numRef>
              <c:f>Sheet2!$K$93:$O$93</c:f>
              <c:numCache>
                <c:formatCode>0.00_);[Red]\(0.00\)</c:formatCode>
                <c:ptCount val="5"/>
                <c:pt idx="0">
                  <c:v>1.7733778978439165</c:v>
                </c:pt>
                <c:pt idx="1">
                  <c:v>0.68958485752701082</c:v>
                </c:pt>
                <c:pt idx="2">
                  <c:v>1.1451655613094013E-2</c:v>
                </c:pt>
                <c:pt idx="3" formatCode="0.00">
                  <c:v>0.43737217110011617</c:v>
                </c:pt>
                <c:pt idx="4" formatCode="0.00">
                  <c:v>0.50280533468646871</c:v>
                </c:pt>
              </c:numCache>
            </c:numRef>
          </c:val>
        </c:ser>
        <c:ser>
          <c:idx val="1"/>
          <c:order val="1"/>
          <c:tx>
            <c:strRef>
              <c:f>Sheet2!$J$94</c:f>
              <c:strCache>
                <c:ptCount val="1"/>
                <c:pt idx="0">
                  <c:v>sistl1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zh-CN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both"/>
            <c:errValType val="cust"/>
            <c:noEndCap val="0"/>
            <c:plus>
              <c:numRef>
                <c:f>Sheet2!$K$97:$O$97</c:f>
                <c:numCache>
                  <c:formatCode>General</c:formatCode>
                  <c:ptCount val="5"/>
                  <c:pt idx="0">
                    <c:v>2.5429558623145887E-2</c:v>
                  </c:pt>
                  <c:pt idx="1">
                    <c:v>1.0062840241916088E-2</c:v>
                  </c:pt>
                  <c:pt idx="2">
                    <c:v>1.6698612997410323E-3</c:v>
                  </c:pt>
                  <c:pt idx="3">
                    <c:v>2.2479149603704535E-2</c:v>
                  </c:pt>
                  <c:pt idx="4">
                    <c:v>1.0574462948409635E-2</c:v>
                  </c:pt>
                </c:numCache>
              </c:numRef>
            </c:plus>
            <c:minus>
              <c:numRef>
                <c:f>Sheet2!$K$97:$O$97</c:f>
                <c:numCache>
                  <c:formatCode>General</c:formatCode>
                  <c:ptCount val="5"/>
                  <c:pt idx="0">
                    <c:v>2.5429558623145887E-2</c:v>
                  </c:pt>
                  <c:pt idx="1">
                    <c:v>1.0062840241916088E-2</c:v>
                  </c:pt>
                  <c:pt idx="2">
                    <c:v>1.6698612997410323E-3</c:v>
                  </c:pt>
                  <c:pt idx="3">
                    <c:v>2.2479149603704535E-2</c:v>
                  </c:pt>
                  <c:pt idx="4">
                    <c:v>1.0574462948409635E-2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2!$K$92:$O$92</c:f>
              <c:strCache>
                <c:ptCount val="5"/>
                <c:pt idx="0">
                  <c:v>SiSTL1</c:v>
                </c:pt>
                <c:pt idx="1">
                  <c:v>SiSTL1-2</c:v>
                </c:pt>
                <c:pt idx="2">
                  <c:v>SiSTL1-3</c:v>
                </c:pt>
                <c:pt idx="3">
                  <c:v>E2F1</c:v>
                </c:pt>
                <c:pt idx="4">
                  <c:v>E2F2</c:v>
                </c:pt>
              </c:strCache>
            </c:strRef>
          </c:cat>
          <c:val>
            <c:numRef>
              <c:f>Sheet2!$K$94:$O$94</c:f>
              <c:numCache>
                <c:formatCode>0.00_);[Red]\(0.00\)</c:formatCode>
                <c:ptCount val="5"/>
                <c:pt idx="0">
                  <c:v>0.59628198960735379</c:v>
                </c:pt>
                <c:pt idx="1">
                  <c:v>0.2046882226384448</c:v>
                </c:pt>
                <c:pt idx="2">
                  <c:v>6.4977982552861732E-3</c:v>
                </c:pt>
                <c:pt idx="3" formatCode="0.00">
                  <c:v>0.23167913079373773</c:v>
                </c:pt>
                <c:pt idx="4" formatCode="0.00">
                  <c:v>0.1543795950640982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292234752"/>
        <c:axId val="292235312"/>
      </c:barChart>
      <c:catAx>
        <c:axId val="2922347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1" i="1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292235312"/>
        <c:crosses val="autoZero"/>
        <c:auto val="1"/>
        <c:lblAlgn val="ctr"/>
        <c:lblOffset val="100"/>
        <c:noMultiLvlLbl val="0"/>
      </c:catAx>
      <c:valAx>
        <c:axId val="292235312"/>
        <c:scaling>
          <c:orientation val="minMax"/>
        </c:scaling>
        <c:delete val="0"/>
        <c:axPos val="l"/>
        <c:numFmt formatCode="#,##0.0_);[Red]\(#,##0.0\)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292234752"/>
        <c:crosses val="autoZero"/>
        <c:crossBetween val="between"/>
        <c:majorUnit val="0.4"/>
      </c:valAx>
      <c:spPr>
        <a:noFill/>
        <a:ln>
          <a:noFill/>
        </a:ln>
        <a:effectLst/>
      </c:spPr>
    </c:plotArea>
    <c:legend>
      <c:legendPos val="t"/>
      <c:legendEntry>
        <c:idx val="1"/>
        <c:txPr>
          <a:bodyPr rot="0" spcFirstLastPara="1" vertOverflow="ellipsis" vert="horz" wrap="square" anchor="ctr" anchorCtr="1"/>
          <a:lstStyle/>
          <a:p>
            <a:pPr>
              <a:defRPr lang="zh-CN" altLang="en-US" sz="1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</c:legendEntry>
      <c:layout>
        <c:manualLayout>
          <c:xMode val="edge"/>
          <c:yMode val="edge"/>
          <c:x val="0.6734138519084627"/>
          <c:y val="0.323526247821115"/>
          <c:w val="0.20290055015861805"/>
          <c:h val="5.492013771521826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zh-CN" altLang="en-US" sz="18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lang="en-US" altLang="en-US" sz="2400" b="1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2400" b="1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OsCycA1:1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lang="en-US" altLang="en-US" sz="2400" b="1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0.11243934429714654"/>
          <c:y val="0.13353781158629302"/>
          <c:w val="0.79634637237922334"/>
          <c:h val="0.5934844943234366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5!$A$7</c:f>
              <c:strCache>
                <c:ptCount val="1"/>
                <c:pt idx="0">
                  <c:v>OsCycA1:1</c:v>
                </c:pt>
              </c:strCache>
            </c:strRef>
          </c:tx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5!$B$22:$J$22</c:f>
                <c:numCache>
                  <c:formatCode>General</c:formatCode>
                  <c:ptCount val="9"/>
                  <c:pt idx="0">
                    <c:v>0.70302202419138649</c:v>
                  </c:pt>
                  <c:pt idx="1">
                    <c:v>0.71345813445594874</c:v>
                  </c:pt>
                  <c:pt idx="2">
                    <c:v>0.84621615972776443</c:v>
                  </c:pt>
                  <c:pt idx="3">
                    <c:v>0.28080382379121227</c:v>
                  </c:pt>
                  <c:pt idx="4">
                    <c:v>0.80872523107902783</c:v>
                  </c:pt>
                  <c:pt idx="5">
                    <c:v>0.64316279119317965</c:v>
                  </c:pt>
                  <c:pt idx="6">
                    <c:v>0.37560721405623965</c:v>
                  </c:pt>
                  <c:pt idx="7">
                    <c:v>0.44318347183886275</c:v>
                  </c:pt>
                  <c:pt idx="8">
                    <c:v>0.69654672968838138</c:v>
                  </c:pt>
                </c:numCache>
              </c:numRef>
            </c:plus>
            <c:minus>
              <c:numRef>
                <c:f>Sheet5!$B$37:$J$37</c:f>
                <c:numCache>
                  <c:formatCode>General</c:formatCode>
                  <c:ptCount val="9"/>
                  <c:pt idx="0">
                    <c:v>0.77996483574376096</c:v>
                  </c:pt>
                  <c:pt idx="1">
                    <c:v>0.77393429622485232</c:v>
                  </c:pt>
                  <c:pt idx="2">
                    <c:v>1.1360197217021035</c:v>
                  </c:pt>
                  <c:pt idx="3">
                    <c:v>0.25923864428408749</c:v>
                  </c:pt>
                  <c:pt idx="4">
                    <c:v>0.7443919529624603</c:v>
                  </c:pt>
                  <c:pt idx="5">
                    <c:v>0.5897666744642247</c:v>
                  </c:pt>
                  <c:pt idx="6">
                    <c:v>0.28851848341991038</c:v>
                  </c:pt>
                  <c:pt idx="7">
                    <c:v>0.34390624222779054</c:v>
                  </c:pt>
                  <c:pt idx="8">
                    <c:v>0.67835834349076407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5!$B$2:$J$2</c:f>
              <c:strCache>
                <c:ptCount val="9"/>
                <c:pt idx="0">
                  <c:v>OsC1-4 T1-W</c:v>
                </c:pt>
                <c:pt idx="1">
                  <c:v>OsC2-12 T1-W</c:v>
                </c:pt>
                <c:pt idx="2">
                  <c:v>OsC1-8 T2-W</c:v>
                </c:pt>
                <c:pt idx="3">
                  <c:v>OsC1-4 T1-1</c:v>
                </c:pt>
                <c:pt idx="4">
                  <c:v>OsC1-4 T1-2</c:v>
                </c:pt>
                <c:pt idx="5">
                  <c:v>OsC2-12 T1-1</c:v>
                </c:pt>
                <c:pt idx="6">
                  <c:v>OsC2-12 T1-2</c:v>
                </c:pt>
                <c:pt idx="7">
                  <c:v>OsC1-8 T2-1</c:v>
                </c:pt>
                <c:pt idx="8">
                  <c:v>OsC1-8 T2-2</c:v>
                </c:pt>
              </c:strCache>
            </c:strRef>
          </c:cat>
          <c:val>
            <c:numRef>
              <c:f>Sheet5!$B$7:$J$7</c:f>
              <c:numCache>
                <c:formatCode>General</c:formatCode>
                <c:ptCount val="9"/>
                <c:pt idx="0">
                  <c:v>6.9344499189273279</c:v>
                </c:pt>
                <c:pt idx="1">
                  <c:v>7.7261970546027738</c:v>
                </c:pt>
                <c:pt idx="2">
                  <c:v>6.5253273357484431</c:v>
                </c:pt>
                <c:pt idx="3">
                  <c:v>1.377022136304884</c:v>
                </c:pt>
                <c:pt idx="4">
                  <c:v>2.7382925052542597</c:v>
                </c:pt>
                <c:pt idx="5">
                  <c:v>2.1416496947173687</c:v>
                </c:pt>
                <c:pt idx="6">
                  <c:v>1.1851105604504439</c:v>
                </c:pt>
                <c:pt idx="7">
                  <c:v>1.2923726780095361</c:v>
                </c:pt>
                <c:pt idx="8">
                  <c:v>2.382249830157798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77018704"/>
        <c:axId val="277019264"/>
      </c:barChart>
      <c:catAx>
        <c:axId val="2770187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altLang="en-US" sz="2000" b="1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277019264"/>
        <c:crosses val="autoZero"/>
        <c:auto val="1"/>
        <c:lblAlgn val="ctr"/>
        <c:lblOffset val="100"/>
        <c:noMultiLvlLbl val="0"/>
      </c:catAx>
      <c:valAx>
        <c:axId val="27701926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 rtl="0">
              <a:defRPr lang="zh-CN" altLang="en-US" sz="2400" b="1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2770187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 algn="ctr" rtl="0">
        <a:defRPr lang="zh-CN" altLang="en-US" sz="2400" b="1" i="1" u="none" strike="noStrike" kern="1200" spc="0" baseline="0">
          <a:solidFill>
            <a:schemeClr val="tx1"/>
          </a:solidFill>
          <a:latin typeface="Times New Roman" panose="02020603050405020304" pitchFamily="18" charset="0"/>
          <a:ea typeface="+mn-ea"/>
          <a:cs typeface="Times New Roman" panose="02020603050405020304" pitchFamily="18" charset="0"/>
        </a:defRPr>
      </a:pPr>
      <a:endParaRPr lang="zh-CN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92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2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sRNRL1</a:t>
            </a:r>
          </a:p>
        </c:rich>
      </c:tx>
      <c:layout>
        <c:manualLayout>
          <c:xMode val="edge"/>
          <c:yMode val="edge"/>
          <c:x val="0.40468132716049382"/>
          <c:y val="1.511904761904761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92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5!$A$4</c:f>
              <c:strCache>
                <c:ptCount val="1"/>
                <c:pt idx="0">
                  <c:v>OsRNRL1</c:v>
                </c:pt>
              </c:strCache>
            </c:strRef>
          </c:tx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5!$B$19:$J$19</c:f>
                <c:numCache>
                  <c:formatCode>General</c:formatCode>
                  <c:ptCount val="9"/>
                  <c:pt idx="0">
                    <c:v>0.33124348853741026</c:v>
                  </c:pt>
                  <c:pt idx="1">
                    <c:v>2.6712385777954317E-2</c:v>
                  </c:pt>
                  <c:pt idx="2">
                    <c:v>0.32044694147344321</c:v>
                  </c:pt>
                  <c:pt idx="3">
                    <c:v>0.18077323672960421</c:v>
                  </c:pt>
                  <c:pt idx="4">
                    <c:v>0.31009745389381238</c:v>
                  </c:pt>
                  <c:pt idx="5">
                    <c:v>0.62838154348852249</c:v>
                  </c:pt>
                  <c:pt idx="6">
                    <c:v>0.26599681229242972</c:v>
                  </c:pt>
                  <c:pt idx="7">
                    <c:v>0.16681771069277929</c:v>
                  </c:pt>
                  <c:pt idx="8">
                    <c:v>0.19764856242681417</c:v>
                  </c:pt>
                </c:numCache>
              </c:numRef>
            </c:plus>
            <c:minus>
              <c:numRef>
                <c:f>Sheet5!$B$34:$J$34</c:f>
                <c:numCache>
                  <c:formatCode>General</c:formatCode>
                  <c:ptCount val="9"/>
                  <c:pt idx="0">
                    <c:v>0.37334432016906494</c:v>
                  </c:pt>
                  <c:pt idx="1">
                    <c:v>6.3286338726156632E-2</c:v>
                  </c:pt>
                  <c:pt idx="2">
                    <c:v>0.48906558344692552</c:v>
                  </c:pt>
                  <c:pt idx="3">
                    <c:v>0.12748990672309141</c:v>
                  </c:pt>
                  <c:pt idx="4">
                    <c:v>0.23337581845904121</c:v>
                  </c:pt>
                  <c:pt idx="5">
                    <c:v>0.49373582560945728</c:v>
                  </c:pt>
                  <c:pt idx="6">
                    <c:v>0.18789364130975988</c:v>
                  </c:pt>
                  <c:pt idx="7">
                    <c:v>0.13883157327294715</c:v>
                  </c:pt>
                  <c:pt idx="8">
                    <c:v>0.2147680660941248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5!$B$2:$J$2</c:f>
              <c:strCache>
                <c:ptCount val="9"/>
                <c:pt idx="0">
                  <c:v>OsC1-4 T1-W</c:v>
                </c:pt>
                <c:pt idx="1">
                  <c:v>OsC2-12 T1-W</c:v>
                </c:pt>
                <c:pt idx="2">
                  <c:v>OsC1-8 T2-W</c:v>
                </c:pt>
                <c:pt idx="3">
                  <c:v>OsC1-4 T1-1</c:v>
                </c:pt>
                <c:pt idx="4">
                  <c:v>OsC1-4 T1-2</c:v>
                </c:pt>
                <c:pt idx="5">
                  <c:v>OsC2-12 T1-1</c:v>
                </c:pt>
                <c:pt idx="6">
                  <c:v>OsC2-12 T1-2</c:v>
                </c:pt>
                <c:pt idx="7">
                  <c:v>OsC1-8 T2-1</c:v>
                </c:pt>
                <c:pt idx="8">
                  <c:v>OsC1-8 T2-2</c:v>
                </c:pt>
              </c:strCache>
            </c:strRef>
          </c:cat>
          <c:val>
            <c:numRef>
              <c:f>Sheet5!$B$4:$J$4</c:f>
              <c:numCache>
                <c:formatCode>General</c:formatCode>
                <c:ptCount val="9"/>
                <c:pt idx="0">
                  <c:v>4.491521892975082</c:v>
                </c:pt>
                <c:pt idx="1">
                  <c:v>3.1961963502224862</c:v>
                </c:pt>
                <c:pt idx="2">
                  <c:v>3.6686903945910809</c:v>
                </c:pt>
                <c:pt idx="3">
                  <c:v>0.32224348440767925</c:v>
                </c:pt>
                <c:pt idx="4">
                  <c:v>0.65050952616243207</c:v>
                </c:pt>
                <c:pt idx="5">
                  <c:v>1.2781610773437933</c:v>
                </c:pt>
                <c:pt idx="6">
                  <c:v>0.4555384432888519</c:v>
                </c:pt>
                <c:pt idx="7">
                  <c:v>0.65021288059923588</c:v>
                </c:pt>
                <c:pt idx="8">
                  <c:v>0.8267487334476016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77020944"/>
        <c:axId val="277022064"/>
      </c:barChart>
      <c:catAx>
        <c:axId val="2770209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1" i="1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77022064"/>
        <c:crosses val="autoZero"/>
        <c:auto val="1"/>
        <c:lblAlgn val="ctr"/>
        <c:lblOffset val="100"/>
        <c:noMultiLvlLbl val="0"/>
      </c:catAx>
      <c:valAx>
        <c:axId val="277022064"/>
        <c:scaling>
          <c:orientation val="minMax"/>
          <c:max val="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 rtl="0">
              <a:defRPr sz="24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77020944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600"/>
      </a:pPr>
      <a:endParaRPr lang="zh-CN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lang="en-US" altLang="zh-CN" sz="2400" b="1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 sz="2400" b="1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OsCycB1:1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lang="en-US" altLang="zh-CN" sz="2400" b="1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0.11397521888985254"/>
          <c:y val="0.14110440148890818"/>
          <c:w val="0.86577418102123038"/>
          <c:h val="0.5441701877936260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5!$A$10</c:f>
              <c:strCache>
                <c:ptCount val="1"/>
                <c:pt idx="0">
                  <c:v>OsCycB1:1</c:v>
                </c:pt>
              </c:strCache>
            </c:strRef>
          </c:tx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5!$B$25:$J$25</c:f>
                <c:numCache>
                  <c:formatCode>General</c:formatCode>
                  <c:ptCount val="9"/>
                  <c:pt idx="0">
                    <c:v>4.0077106871296619E-2</c:v>
                  </c:pt>
                  <c:pt idx="1">
                    <c:v>6.7781425830853226E-2</c:v>
                  </c:pt>
                  <c:pt idx="2">
                    <c:v>9.7699080021331597E-2</c:v>
                  </c:pt>
                  <c:pt idx="3">
                    <c:v>6.8930066756107744E-2</c:v>
                  </c:pt>
                  <c:pt idx="4">
                    <c:v>5.5249237637164689E-2</c:v>
                  </c:pt>
                  <c:pt idx="5">
                    <c:v>6.9627928653993837E-2</c:v>
                  </c:pt>
                  <c:pt idx="6">
                    <c:v>6.7567302915633176E-3</c:v>
                  </c:pt>
                  <c:pt idx="7">
                    <c:v>4.2790057894209366E-2</c:v>
                  </c:pt>
                  <c:pt idx="8">
                    <c:v>6.6899842754082395E-2</c:v>
                  </c:pt>
                </c:numCache>
              </c:numRef>
            </c:plus>
            <c:minus>
              <c:numRef>
                <c:f>Sheet5!$B$40:$J$40</c:f>
                <c:numCache>
                  <c:formatCode>General</c:formatCode>
                  <c:ptCount val="9"/>
                  <c:pt idx="0">
                    <c:v>4.3065127877244369E-2</c:v>
                  </c:pt>
                  <c:pt idx="1">
                    <c:v>6.1596360725224231E-2</c:v>
                  </c:pt>
                  <c:pt idx="2">
                    <c:v>0.1201084528259751</c:v>
                  </c:pt>
                  <c:pt idx="3">
                    <c:v>5.4523182721306851E-2</c:v>
                  </c:pt>
                  <c:pt idx="4">
                    <c:v>5.3197561548066291E-2</c:v>
                  </c:pt>
                  <c:pt idx="5">
                    <c:v>5.8680638468519425E-2</c:v>
                  </c:pt>
                  <c:pt idx="6">
                    <c:v>5.3064515958152099E-3</c:v>
                  </c:pt>
                  <c:pt idx="7">
                    <c:v>3.4199892548246735E-2</c:v>
                  </c:pt>
                  <c:pt idx="8">
                    <c:v>6.660594773451331E-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5!$B$2:$J$2</c:f>
              <c:strCache>
                <c:ptCount val="9"/>
                <c:pt idx="0">
                  <c:v>OsC1-4 T1-W</c:v>
                </c:pt>
                <c:pt idx="1">
                  <c:v>OsC2-12 T1-W</c:v>
                </c:pt>
                <c:pt idx="2">
                  <c:v>OsC1-8 T2-W</c:v>
                </c:pt>
                <c:pt idx="3">
                  <c:v>OsC1-4 T1-1</c:v>
                </c:pt>
                <c:pt idx="4">
                  <c:v>OsC1-4 T1-2</c:v>
                </c:pt>
                <c:pt idx="5">
                  <c:v>OsC2-12 T1-1</c:v>
                </c:pt>
                <c:pt idx="6">
                  <c:v>OsC2-12 T1-2</c:v>
                </c:pt>
                <c:pt idx="7">
                  <c:v>OsC1-8 T2-1</c:v>
                </c:pt>
                <c:pt idx="8">
                  <c:v>OsC1-8 T2-2</c:v>
                </c:pt>
              </c:strCache>
            </c:strRef>
          </c:cat>
          <c:val>
            <c:numRef>
              <c:f>Sheet5!$B$10:$J$10</c:f>
              <c:numCache>
                <c:formatCode>General</c:formatCode>
                <c:ptCount val="9"/>
                <c:pt idx="0">
                  <c:v>0.63419139269949298</c:v>
                </c:pt>
                <c:pt idx="1">
                  <c:v>0.58927080839424828</c:v>
                </c:pt>
                <c:pt idx="2">
                  <c:v>0.44921318535592986</c:v>
                </c:pt>
                <c:pt idx="3">
                  <c:v>0.24919093417132987</c:v>
                </c:pt>
                <c:pt idx="4">
                  <c:v>0.19835449878095532</c:v>
                </c:pt>
                <c:pt idx="5">
                  <c:v>0.1891558456608057</c:v>
                </c:pt>
                <c:pt idx="6">
                  <c:v>2.1572193192733655E-2</c:v>
                </c:pt>
                <c:pt idx="7">
                  <c:v>0.14640386601324884</c:v>
                </c:pt>
                <c:pt idx="8">
                  <c:v>0.2683814361133222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77024304"/>
        <c:axId val="287213008"/>
      </c:barChart>
      <c:catAx>
        <c:axId val="2770243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 rtl="0">
              <a:defRPr lang="zh-CN" altLang="en-US" sz="2000" b="1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287213008"/>
        <c:crosses val="autoZero"/>
        <c:auto val="1"/>
        <c:lblAlgn val="ctr"/>
        <c:lblOffset val="100"/>
        <c:noMultiLvlLbl val="0"/>
      </c:catAx>
      <c:valAx>
        <c:axId val="287213008"/>
        <c:scaling>
          <c:orientation val="minMax"/>
          <c:max val="0.70000000000000007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 rtl="0">
              <a:defRPr lang="zh-CN" altLang="en-US" sz="2400" b="1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2770243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lang="en-US" altLang="zh-CN" sz="2400" b="1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 sz="2400" b="1" i="1" u="none" strike="noStrike" kern="1200" spc="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OsE2F1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lang="en-US" altLang="zh-CN" sz="2400" b="1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5!$A$13</c:f>
              <c:strCache>
                <c:ptCount val="1"/>
                <c:pt idx="0">
                  <c:v>OsE2F1</c:v>
                </c:pt>
              </c:strCache>
            </c:strRef>
          </c:tx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5!$B$28:$J$28</c:f>
                <c:numCache>
                  <c:formatCode>General</c:formatCode>
                  <c:ptCount val="9"/>
                  <c:pt idx="0">
                    <c:v>0.13386811658867326</c:v>
                  </c:pt>
                  <c:pt idx="1">
                    <c:v>0.16115925530604658</c:v>
                  </c:pt>
                  <c:pt idx="2">
                    <c:v>0.13454517479739514</c:v>
                  </c:pt>
                  <c:pt idx="3">
                    <c:v>0.12873447537481753</c:v>
                  </c:pt>
                  <c:pt idx="4">
                    <c:v>0.11936349706842853</c:v>
                  </c:pt>
                  <c:pt idx="5">
                    <c:v>8.161406992489259E-2</c:v>
                  </c:pt>
                  <c:pt idx="6">
                    <c:v>3.0891645701653134E-2</c:v>
                  </c:pt>
                  <c:pt idx="7">
                    <c:v>5.4889422831594703E-2</c:v>
                  </c:pt>
                  <c:pt idx="8">
                    <c:v>0.10368207000098617</c:v>
                  </c:pt>
                </c:numCache>
              </c:numRef>
            </c:plus>
            <c:minus>
              <c:numRef>
                <c:f>Sheet5!$B$43:$J$43</c:f>
                <c:numCache>
                  <c:formatCode>General</c:formatCode>
                  <c:ptCount val="9"/>
                  <c:pt idx="0">
                    <c:v>0.14370113253649786</c:v>
                  </c:pt>
                  <c:pt idx="1">
                    <c:v>0.16236839514985979</c:v>
                  </c:pt>
                  <c:pt idx="2">
                    <c:v>0.16177911146315394</c:v>
                  </c:pt>
                  <c:pt idx="3">
                    <c:v>0.13196985458216504</c:v>
                  </c:pt>
                  <c:pt idx="4">
                    <c:v>9.2652191822158753E-2</c:v>
                  </c:pt>
                  <c:pt idx="5">
                    <c:v>6.2358344206090932E-2</c:v>
                  </c:pt>
                  <c:pt idx="6">
                    <c:v>2.5004411105874425E-2</c:v>
                  </c:pt>
                  <c:pt idx="7">
                    <c:v>4.9668642539224706E-2</c:v>
                  </c:pt>
                  <c:pt idx="8">
                    <c:v>0.11183784261964086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5!$B$2:$J$2</c:f>
              <c:strCache>
                <c:ptCount val="9"/>
                <c:pt idx="0">
                  <c:v>OsC1-4 T1-W</c:v>
                </c:pt>
                <c:pt idx="1">
                  <c:v>OsC2-12 T1-W</c:v>
                </c:pt>
                <c:pt idx="2">
                  <c:v>OsC1-8 T2-W</c:v>
                </c:pt>
                <c:pt idx="3">
                  <c:v>OsC1-4 T1-1</c:v>
                </c:pt>
                <c:pt idx="4">
                  <c:v>OsC1-4 T1-2</c:v>
                </c:pt>
                <c:pt idx="5">
                  <c:v>OsC2-12 T1-1</c:v>
                </c:pt>
                <c:pt idx="6">
                  <c:v>OsC2-12 T1-2</c:v>
                </c:pt>
                <c:pt idx="7">
                  <c:v>OsC1-8 T2-1</c:v>
                </c:pt>
                <c:pt idx="8">
                  <c:v>OsC1-8 T2-2</c:v>
                </c:pt>
              </c:strCache>
            </c:strRef>
          </c:cat>
          <c:val>
            <c:numRef>
              <c:f>Sheet5!$B$13:$J$13</c:f>
              <c:numCache>
                <c:formatCode>General</c:formatCode>
                <c:ptCount val="9"/>
                <c:pt idx="0">
                  <c:v>1.2242889550292</c:v>
                </c:pt>
                <c:pt idx="1">
                  <c:v>1.7980313966671753</c:v>
                </c:pt>
                <c:pt idx="2">
                  <c:v>1.5639929612413417</c:v>
                </c:pt>
                <c:pt idx="3">
                  <c:v>0.44759738944208416</c:v>
                </c:pt>
                <c:pt idx="4">
                  <c:v>0.27255655144040108</c:v>
                </c:pt>
                <c:pt idx="5">
                  <c:v>0.23435183507408466</c:v>
                </c:pt>
                <c:pt idx="6">
                  <c:v>0.11875220026804902</c:v>
                </c:pt>
                <c:pt idx="7">
                  <c:v>0.32245530115539839</c:v>
                </c:pt>
                <c:pt idx="8">
                  <c:v>0.5503035371764863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87207968"/>
        <c:axId val="287214128"/>
      </c:barChart>
      <c:catAx>
        <c:axId val="2872079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1" i="1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287214128"/>
        <c:crosses val="autoZero"/>
        <c:auto val="1"/>
        <c:lblAlgn val="ctr"/>
        <c:lblOffset val="100"/>
        <c:noMultiLvlLbl val="0"/>
      </c:catAx>
      <c:valAx>
        <c:axId val="28721412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19050">
            <a:solidFill>
              <a:schemeClr val="tx1">
                <a:lumMod val="65000"/>
                <a:lumOff val="3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2872079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64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1064" b="0" i="0" u="none" strike="noStrike" kern="1200" baseline="0"/>
    <cs:bodyPr rot="-5400000" spcFirstLastPara="1" vertOverflow="clip" horzOverflow="clip" vert="horz" wrap="square" lIns="38100" tIns="19050" rIns="38100" bIns="19050" anchor="ctr" anchorCtr="1">
      <a:spAutoFit/>
    </cs:bodyPr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064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D6239AD-3B4D-44B0-A763-C2D7FD543CC6}" type="datetimeFigureOut">
              <a:rPr lang="zh-CN" altLang="en-US" smtClean="0"/>
              <a:t>2019/1/2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24075" y="1143000"/>
            <a:ext cx="26098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5B9C385-4AEF-4FE8-8489-D63B8EB7947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20688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5B9C385-4AEF-4FE8-8489-D63B8EB7947D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9370433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5B9C385-4AEF-4FE8-8489-D63B8EB7947D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766806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484948" y="3829544"/>
            <a:ext cx="16829405" cy="8146580"/>
          </a:xfrm>
        </p:spPr>
        <p:txBody>
          <a:bodyPr anchor="b"/>
          <a:lstStyle>
            <a:lvl1pPr algn="ctr">
              <a:defRPr sz="12992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474913" y="12290287"/>
            <a:ext cx="14849475" cy="5649521"/>
          </a:xfrm>
        </p:spPr>
        <p:txBody>
          <a:bodyPr/>
          <a:lstStyle>
            <a:lvl1pPr marL="0" indent="0" algn="ctr">
              <a:buNone/>
              <a:defRPr sz="5197"/>
            </a:lvl1pPr>
            <a:lvl2pPr marL="989975" indent="0" algn="ctr">
              <a:buNone/>
              <a:defRPr sz="4331"/>
            </a:lvl2pPr>
            <a:lvl3pPr marL="1979950" indent="0" algn="ctr">
              <a:buNone/>
              <a:defRPr sz="3898"/>
            </a:lvl3pPr>
            <a:lvl4pPr marL="2969925" indent="0" algn="ctr">
              <a:buNone/>
              <a:defRPr sz="3464"/>
            </a:lvl4pPr>
            <a:lvl5pPr marL="3959901" indent="0" algn="ctr">
              <a:buNone/>
              <a:defRPr sz="3464"/>
            </a:lvl5pPr>
            <a:lvl6pPr marL="4949876" indent="0" algn="ctr">
              <a:buNone/>
              <a:defRPr sz="3464"/>
            </a:lvl6pPr>
            <a:lvl7pPr marL="5939851" indent="0" algn="ctr">
              <a:buNone/>
              <a:defRPr sz="3464"/>
            </a:lvl7pPr>
            <a:lvl8pPr marL="6929826" indent="0" algn="ctr">
              <a:buNone/>
              <a:defRPr sz="3464"/>
            </a:lvl8pPr>
            <a:lvl9pPr marL="7919801" indent="0" algn="ctr">
              <a:buNone/>
              <a:defRPr sz="3464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E603C-DB6A-4CA3-ACBE-D9F9798362C9}" type="datetimeFigureOut">
              <a:rPr lang="zh-CN" altLang="en-US" smtClean="0"/>
              <a:t>2019/1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CD778A-0AEE-4165-A926-D638EA8554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10764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E603C-DB6A-4CA3-ACBE-D9F9798362C9}" type="datetimeFigureOut">
              <a:rPr lang="zh-CN" altLang="en-US" smtClean="0"/>
              <a:t>2019/1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CD778A-0AEE-4165-A926-D638EA8554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31980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4168875" y="1245820"/>
            <a:ext cx="4269224" cy="1983020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361203" y="1245820"/>
            <a:ext cx="12560181" cy="19830207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E603C-DB6A-4CA3-ACBE-D9F9798362C9}" type="datetimeFigureOut">
              <a:rPr lang="zh-CN" altLang="en-US" smtClean="0"/>
              <a:t>2019/1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CD778A-0AEE-4165-A926-D638EA8554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37108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E603C-DB6A-4CA3-ACBE-D9F9798362C9}" type="datetimeFigureOut">
              <a:rPr lang="zh-CN" altLang="en-US" smtClean="0"/>
              <a:t>2019/1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CD778A-0AEE-4165-A926-D638EA8554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414731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50891" y="5833695"/>
            <a:ext cx="17076896" cy="9733644"/>
          </a:xfrm>
        </p:spPr>
        <p:txBody>
          <a:bodyPr anchor="b"/>
          <a:lstStyle>
            <a:lvl1pPr>
              <a:defRPr sz="12992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50891" y="15659423"/>
            <a:ext cx="17076896" cy="5118694"/>
          </a:xfrm>
        </p:spPr>
        <p:txBody>
          <a:bodyPr/>
          <a:lstStyle>
            <a:lvl1pPr marL="0" indent="0">
              <a:buNone/>
              <a:defRPr sz="5197">
                <a:solidFill>
                  <a:schemeClr val="tx1"/>
                </a:solidFill>
              </a:defRPr>
            </a:lvl1pPr>
            <a:lvl2pPr marL="989975" indent="0">
              <a:buNone/>
              <a:defRPr sz="4331">
                <a:solidFill>
                  <a:schemeClr val="tx1">
                    <a:tint val="75000"/>
                  </a:schemeClr>
                </a:solidFill>
              </a:defRPr>
            </a:lvl2pPr>
            <a:lvl3pPr marL="1979950" indent="0">
              <a:buNone/>
              <a:defRPr sz="3898">
                <a:solidFill>
                  <a:schemeClr val="tx1">
                    <a:tint val="75000"/>
                  </a:schemeClr>
                </a:solidFill>
              </a:defRPr>
            </a:lvl3pPr>
            <a:lvl4pPr marL="2969925" indent="0">
              <a:buNone/>
              <a:defRPr sz="3464">
                <a:solidFill>
                  <a:schemeClr val="tx1">
                    <a:tint val="75000"/>
                  </a:schemeClr>
                </a:solidFill>
              </a:defRPr>
            </a:lvl4pPr>
            <a:lvl5pPr marL="3959901" indent="0">
              <a:buNone/>
              <a:defRPr sz="3464">
                <a:solidFill>
                  <a:schemeClr val="tx1">
                    <a:tint val="75000"/>
                  </a:schemeClr>
                </a:solidFill>
              </a:defRPr>
            </a:lvl5pPr>
            <a:lvl6pPr marL="4949876" indent="0">
              <a:buNone/>
              <a:defRPr sz="3464">
                <a:solidFill>
                  <a:schemeClr val="tx1">
                    <a:tint val="75000"/>
                  </a:schemeClr>
                </a:solidFill>
              </a:defRPr>
            </a:lvl6pPr>
            <a:lvl7pPr marL="5939851" indent="0">
              <a:buNone/>
              <a:defRPr sz="3464">
                <a:solidFill>
                  <a:schemeClr val="tx1">
                    <a:tint val="75000"/>
                  </a:schemeClr>
                </a:solidFill>
              </a:defRPr>
            </a:lvl7pPr>
            <a:lvl8pPr marL="6929826" indent="0">
              <a:buNone/>
              <a:defRPr sz="3464">
                <a:solidFill>
                  <a:schemeClr val="tx1">
                    <a:tint val="75000"/>
                  </a:schemeClr>
                </a:solidFill>
              </a:defRPr>
            </a:lvl8pPr>
            <a:lvl9pPr marL="7919801" indent="0">
              <a:buNone/>
              <a:defRPr sz="346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E603C-DB6A-4CA3-ACBE-D9F9798362C9}" type="datetimeFigureOut">
              <a:rPr lang="zh-CN" altLang="en-US" smtClean="0"/>
              <a:t>2019/1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CD778A-0AEE-4165-A926-D638EA8554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256193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361202" y="6229100"/>
            <a:ext cx="8414703" cy="1484692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023395" y="6229100"/>
            <a:ext cx="8414703" cy="1484692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E603C-DB6A-4CA3-ACBE-D9F9798362C9}" type="datetimeFigureOut">
              <a:rPr lang="zh-CN" altLang="en-US" smtClean="0"/>
              <a:t>2019/1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CD778A-0AEE-4165-A926-D638EA8554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33472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63781" y="1245825"/>
            <a:ext cx="17076896" cy="4522870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63783" y="5736191"/>
            <a:ext cx="8376031" cy="2811218"/>
          </a:xfrm>
        </p:spPr>
        <p:txBody>
          <a:bodyPr anchor="b"/>
          <a:lstStyle>
            <a:lvl1pPr marL="0" indent="0">
              <a:buNone/>
              <a:defRPr sz="5197" b="1"/>
            </a:lvl1pPr>
            <a:lvl2pPr marL="989975" indent="0">
              <a:buNone/>
              <a:defRPr sz="4331" b="1"/>
            </a:lvl2pPr>
            <a:lvl3pPr marL="1979950" indent="0">
              <a:buNone/>
              <a:defRPr sz="3898" b="1"/>
            </a:lvl3pPr>
            <a:lvl4pPr marL="2969925" indent="0">
              <a:buNone/>
              <a:defRPr sz="3464" b="1"/>
            </a:lvl4pPr>
            <a:lvl5pPr marL="3959901" indent="0">
              <a:buNone/>
              <a:defRPr sz="3464" b="1"/>
            </a:lvl5pPr>
            <a:lvl6pPr marL="4949876" indent="0">
              <a:buNone/>
              <a:defRPr sz="3464" b="1"/>
            </a:lvl6pPr>
            <a:lvl7pPr marL="5939851" indent="0">
              <a:buNone/>
              <a:defRPr sz="3464" b="1"/>
            </a:lvl7pPr>
            <a:lvl8pPr marL="6929826" indent="0">
              <a:buNone/>
              <a:defRPr sz="3464" b="1"/>
            </a:lvl8pPr>
            <a:lvl9pPr marL="7919801" indent="0">
              <a:buNone/>
              <a:defRPr sz="3464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63783" y="8547409"/>
            <a:ext cx="8376031" cy="12571951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0023397" y="5736191"/>
            <a:ext cx="8417281" cy="2811218"/>
          </a:xfrm>
        </p:spPr>
        <p:txBody>
          <a:bodyPr anchor="b"/>
          <a:lstStyle>
            <a:lvl1pPr marL="0" indent="0">
              <a:buNone/>
              <a:defRPr sz="5197" b="1"/>
            </a:lvl1pPr>
            <a:lvl2pPr marL="989975" indent="0">
              <a:buNone/>
              <a:defRPr sz="4331" b="1"/>
            </a:lvl2pPr>
            <a:lvl3pPr marL="1979950" indent="0">
              <a:buNone/>
              <a:defRPr sz="3898" b="1"/>
            </a:lvl3pPr>
            <a:lvl4pPr marL="2969925" indent="0">
              <a:buNone/>
              <a:defRPr sz="3464" b="1"/>
            </a:lvl4pPr>
            <a:lvl5pPr marL="3959901" indent="0">
              <a:buNone/>
              <a:defRPr sz="3464" b="1"/>
            </a:lvl5pPr>
            <a:lvl6pPr marL="4949876" indent="0">
              <a:buNone/>
              <a:defRPr sz="3464" b="1"/>
            </a:lvl6pPr>
            <a:lvl7pPr marL="5939851" indent="0">
              <a:buNone/>
              <a:defRPr sz="3464" b="1"/>
            </a:lvl7pPr>
            <a:lvl8pPr marL="6929826" indent="0">
              <a:buNone/>
              <a:defRPr sz="3464" b="1"/>
            </a:lvl8pPr>
            <a:lvl9pPr marL="7919801" indent="0">
              <a:buNone/>
              <a:defRPr sz="3464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0023397" y="8547409"/>
            <a:ext cx="8417281" cy="12571951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E603C-DB6A-4CA3-ACBE-D9F9798362C9}" type="datetimeFigureOut">
              <a:rPr lang="zh-CN" altLang="en-US" smtClean="0"/>
              <a:t>2019/1/2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CD778A-0AEE-4165-A926-D638EA8554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96096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E603C-DB6A-4CA3-ACBE-D9F9798362C9}" type="datetimeFigureOut">
              <a:rPr lang="zh-CN" altLang="en-US" smtClean="0"/>
              <a:t>2019/1/2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CD778A-0AEE-4165-A926-D638EA8554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82368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E603C-DB6A-4CA3-ACBE-D9F9798362C9}" type="datetimeFigureOut">
              <a:rPr lang="zh-CN" altLang="en-US" smtClean="0"/>
              <a:t>2019/1/2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CD778A-0AEE-4165-A926-D638EA8554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437547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63781" y="1559983"/>
            <a:ext cx="6385790" cy="5459942"/>
          </a:xfrm>
        </p:spPr>
        <p:txBody>
          <a:bodyPr anchor="b"/>
          <a:lstStyle>
            <a:lvl1pPr>
              <a:defRPr sz="6929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417281" y="3369136"/>
            <a:ext cx="10023396" cy="16628989"/>
          </a:xfrm>
        </p:spPr>
        <p:txBody>
          <a:bodyPr/>
          <a:lstStyle>
            <a:lvl1pPr>
              <a:defRPr sz="6929"/>
            </a:lvl1pPr>
            <a:lvl2pPr>
              <a:defRPr sz="6063"/>
            </a:lvl2pPr>
            <a:lvl3pPr>
              <a:defRPr sz="5197"/>
            </a:lvl3pPr>
            <a:lvl4pPr>
              <a:defRPr sz="4331"/>
            </a:lvl4pPr>
            <a:lvl5pPr>
              <a:defRPr sz="4331"/>
            </a:lvl5pPr>
            <a:lvl6pPr>
              <a:defRPr sz="4331"/>
            </a:lvl6pPr>
            <a:lvl7pPr>
              <a:defRPr sz="4331"/>
            </a:lvl7pPr>
            <a:lvl8pPr>
              <a:defRPr sz="4331"/>
            </a:lvl8pPr>
            <a:lvl9pPr>
              <a:defRPr sz="433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63781" y="7019925"/>
            <a:ext cx="6385790" cy="13005279"/>
          </a:xfrm>
        </p:spPr>
        <p:txBody>
          <a:bodyPr/>
          <a:lstStyle>
            <a:lvl1pPr marL="0" indent="0">
              <a:buNone/>
              <a:defRPr sz="3464"/>
            </a:lvl1pPr>
            <a:lvl2pPr marL="989975" indent="0">
              <a:buNone/>
              <a:defRPr sz="3031"/>
            </a:lvl2pPr>
            <a:lvl3pPr marL="1979950" indent="0">
              <a:buNone/>
              <a:defRPr sz="2598"/>
            </a:lvl3pPr>
            <a:lvl4pPr marL="2969925" indent="0">
              <a:buNone/>
              <a:defRPr sz="2165"/>
            </a:lvl4pPr>
            <a:lvl5pPr marL="3959901" indent="0">
              <a:buNone/>
              <a:defRPr sz="2165"/>
            </a:lvl5pPr>
            <a:lvl6pPr marL="4949876" indent="0">
              <a:buNone/>
              <a:defRPr sz="2165"/>
            </a:lvl6pPr>
            <a:lvl7pPr marL="5939851" indent="0">
              <a:buNone/>
              <a:defRPr sz="2165"/>
            </a:lvl7pPr>
            <a:lvl8pPr marL="6929826" indent="0">
              <a:buNone/>
              <a:defRPr sz="2165"/>
            </a:lvl8pPr>
            <a:lvl9pPr marL="7919801" indent="0">
              <a:buNone/>
              <a:defRPr sz="2165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E603C-DB6A-4CA3-ACBE-D9F9798362C9}" type="datetimeFigureOut">
              <a:rPr lang="zh-CN" altLang="en-US" smtClean="0"/>
              <a:t>2019/1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CD778A-0AEE-4165-A926-D638EA8554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91946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63781" y="1559983"/>
            <a:ext cx="6385790" cy="5459942"/>
          </a:xfrm>
        </p:spPr>
        <p:txBody>
          <a:bodyPr anchor="b"/>
          <a:lstStyle>
            <a:lvl1pPr>
              <a:defRPr sz="6929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8417281" y="3369136"/>
            <a:ext cx="10023396" cy="16628989"/>
          </a:xfrm>
        </p:spPr>
        <p:txBody>
          <a:bodyPr anchor="t"/>
          <a:lstStyle>
            <a:lvl1pPr marL="0" indent="0">
              <a:buNone/>
              <a:defRPr sz="6929"/>
            </a:lvl1pPr>
            <a:lvl2pPr marL="989975" indent="0">
              <a:buNone/>
              <a:defRPr sz="6063"/>
            </a:lvl2pPr>
            <a:lvl3pPr marL="1979950" indent="0">
              <a:buNone/>
              <a:defRPr sz="5197"/>
            </a:lvl3pPr>
            <a:lvl4pPr marL="2969925" indent="0">
              <a:buNone/>
              <a:defRPr sz="4331"/>
            </a:lvl4pPr>
            <a:lvl5pPr marL="3959901" indent="0">
              <a:buNone/>
              <a:defRPr sz="4331"/>
            </a:lvl5pPr>
            <a:lvl6pPr marL="4949876" indent="0">
              <a:buNone/>
              <a:defRPr sz="4331"/>
            </a:lvl6pPr>
            <a:lvl7pPr marL="5939851" indent="0">
              <a:buNone/>
              <a:defRPr sz="4331"/>
            </a:lvl7pPr>
            <a:lvl8pPr marL="6929826" indent="0">
              <a:buNone/>
              <a:defRPr sz="4331"/>
            </a:lvl8pPr>
            <a:lvl9pPr marL="7919801" indent="0">
              <a:buNone/>
              <a:defRPr sz="4331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63781" y="7019925"/>
            <a:ext cx="6385790" cy="13005279"/>
          </a:xfrm>
        </p:spPr>
        <p:txBody>
          <a:bodyPr/>
          <a:lstStyle>
            <a:lvl1pPr marL="0" indent="0">
              <a:buNone/>
              <a:defRPr sz="3464"/>
            </a:lvl1pPr>
            <a:lvl2pPr marL="989975" indent="0">
              <a:buNone/>
              <a:defRPr sz="3031"/>
            </a:lvl2pPr>
            <a:lvl3pPr marL="1979950" indent="0">
              <a:buNone/>
              <a:defRPr sz="2598"/>
            </a:lvl3pPr>
            <a:lvl4pPr marL="2969925" indent="0">
              <a:buNone/>
              <a:defRPr sz="2165"/>
            </a:lvl4pPr>
            <a:lvl5pPr marL="3959901" indent="0">
              <a:buNone/>
              <a:defRPr sz="2165"/>
            </a:lvl5pPr>
            <a:lvl6pPr marL="4949876" indent="0">
              <a:buNone/>
              <a:defRPr sz="2165"/>
            </a:lvl6pPr>
            <a:lvl7pPr marL="5939851" indent="0">
              <a:buNone/>
              <a:defRPr sz="2165"/>
            </a:lvl7pPr>
            <a:lvl8pPr marL="6929826" indent="0">
              <a:buNone/>
              <a:defRPr sz="2165"/>
            </a:lvl8pPr>
            <a:lvl9pPr marL="7919801" indent="0">
              <a:buNone/>
              <a:defRPr sz="2165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E603C-DB6A-4CA3-ACBE-D9F9798362C9}" type="datetimeFigureOut">
              <a:rPr lang="zh-CN" altLang="en-US" smtClean="0"/>
              <a:t>2019/1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CD778A-0AEE-4165-A926-D638EA8554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49297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361202" y="1245825"/>
            <a:ext cx="17076896" cy="452287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61202" y="6229100"/>
            <a:ext cx="17076896" cy="1484692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361202" y="21688107"/>
            <a:ext cx="4454843" cy="124582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5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5E603C-DB6A-4CA3-ACBE-D9F9798362C9}" type="datetimeFigureOut">
              <a:rPr lang="zh-CN" altLang="en-US" smtClean="0"/>
              <a:t>2019/1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558518" y="21688107"/>
            <a:ext cx="6682264" cy="124582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5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3983255" y="21688107"/>
            <a:ext cx="4454843" cy="124582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5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CD778A-0AEE-4165-A926-D638EA8554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31861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81" r:id="rId1"/>
    <p:sldLayoutId id="2147483782" r:id="rId2"/>
    <p:sldLayoutId id="2147483783" r:id="rId3"/>
    <p:sldLayoutId id="2147483784" r:id="rId4"/>
    <p:sldLayoutId id="2147483785" r:id="rId5"/>
    <p:sldLayoutId id="2147483786" r:id="rId6"/>
    <p:sldLayoutId id="2147483787" r:id="rId7"/>
    <p:sldLayoutId id="2147483788" r:id="rId8"/>
    <p:sldLayoutId id="2147483789" r:id="rId9"/>
    <p:sldLayoutId id="2147483790" r:id="rId10"/>
    <p:sldLayoutId id="2147483791" r:id="rId11"/>
  </p:sldLayoutIdLst>
  <p:txStyles>
    <p:titleStyle>
      <a:lvl1pPr algn="l" defTabSz="1979950" rtl="0" eaLnBrk="1" latinLnBrk="0" hangingPunct="1">
        <a:lnSpc>
          <a:spcPct val="90000"/>
        </a:lnSpc>
        <a:spcBef>
          <a:spcPct val="0"/>
        </a:spcBef>
        <a:buNone/>
        <a:defRPr sz="952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94988" indent="-494988" algn="l" defTabSz="1979950" rtl="0" eaLnBrk="1" latinLnBrk="0" hangingPunct="1">
        <a:lnSpc>
          <a:spcPct val="90000"/>
        </a:lnSpc>
        <a:spcBef>
          <a:spcPts val="2165"/>
        </a:spcBef>
        <a:buFont typeface="Arial" panose="020B0604020202020204" pitchFamily="34" charset="0"/>
        <a:buChar char="•"/>
        <a:defRPr sz="6063" kern="1200">
          <a:solidFill>
            <a:schemeClr val="tx1"/>
          </a:solidFill>
          <a:latin typeface="+mn-lt"/>
          <a:ea typeface="+mn-ea"/>
          <a:cs typeface="+mn-cs"/>
        </a:defRPr>
      </a:lvl1pPr>
      <a:lvl2pPr marL="1484963" indent="-494988" algn="l" defTabSz="1979950" rtl="0" eaLnBrk="1" latinLnBrk="0" hangingPunct="1">
        <a:lnSpc>
          <a:spcPct val="90000"/>
        </a:lnSpc>
        <a:spcBef>
          <a:spcPts val="1083"/>
        </a:spcBef>
        <a:buFont typeface="Arial" panose="020B0604020202020204" pitchFamily="34" charset="0"/>
        <a:buChar char="•"/>
        <a:defRPr sz="5197" kern="1200">
          <a:solidFill>
            <a:schemeClr val="tx1"/>
          </a:solidFill>
          <a:latin typeface="+mn-lt"/>
          <a:ea typeface="+mn-ea"/>
          <a:cs typeface="+mn-cs"/>
        </a:defRPr>
      </a:lvl2pPr>
      <a:lvl3pPr marL="2474938" indent="-494988" algn="l" defTabSz="1979950" rtl="0" eaLnBrk="1" latinLnBrk="0" hangingPunct="1">
        <a:lnSpc>
          <a:spcPct val="90000"/>
        </a:lnSpc>
        <a:spcBef>
          <a:spcPts val="1083"/>
        </a:spcBef>
        <a:buFont typeface="Arial" panose="020B0604020202020204" pitchFamily="34" charset="0"/>
        <a:buChar char="•"/>
        <a:defRPr sz="4331" kern="1200">
          <a:solidFill>
            <a:schemeClr val="tx1"/>
          </a:solidFill>
          <a:latin typeface="+mn-lt"/>
          <a:ea typeface="+mn-ea"/>
          <a:cs typeface="+mn-cs"/>
        </a:defRPr>
      </a:lvl3pPr>
      <a:lvl4pPr marL="3464913" indent="-494988" algn="l" defTabSz="1979950" rtl="0" eaLnBrk="1" latinLnBrk="0" hangingPunct="1">
        <a:lnSpc>
          <a:spcPct val="90000"/>
        </a:lnSpc>
        <a:spcBef>
          <a:spcPts val="1083"/>
        </a:spcBef>
        <a:buFont typeface="Arial" panose="020B0604020202020204" pitchFamily="34" charset="0"/>
        <a:buChar char="•"/>
        <a:defRPr sz="3898" kern="1200">
          <a:solidFill>
            <a:schemeClr val="tx1"/>
          </a:solidFill>
          <a:latin typeface="+mn-lt"/>
          <a:ea typeface="+mn-ea"/>
          <a:cs typeface="+mn-cs"/>
        </a:defRPr>
      </a:lvl4pPr>
      <a:lvl5pPr marL="4454888" indent="-494988" algn="l" defTabSz="1979950" rtl="0" eaLnBrk="1" latinLnBrk="0" hangingPunct="1">
        <a:lnSpc>
          <a:spcPct val="90000"/>
        </a:lnSpc>
        <a:spcBef>
          <a:spcPts val="1083"/>
        </a:spcBef>
        <a:buFont typeface="Arial" panose="020B0604020202020204" pitchFamily="34" charset="0"/>
        <a:buChar char="•"/>
        <a:defRPr sz="3898" kern="1200">
          <a:solidFill>
            <a:schemeClr val="tx1"/>
          </a:solidFill>
          <a:latin typeface="+mn-lt"/>
          <a:ea typeface="+mn-ea"/>
          <a:cs typeface="+mn-cs"/>
        </a:defRPr>
      </a:lvl5pPr>
      <a:lvl6pPr marL="5444863" indent="-494988" algn="l" defTabSz="1979950" rtl="0" eaLnBrk="1" latinLnBrk="0" hangingPunct="1">
        <a:lnSpc>
          <a:spcPct val="90000"/>
        </a:lnSpc>
        <a:spcBef>
          <a:spcPts val="1083"/>
        </a:spcBef>
        <a:buFont typeface="Arial" panose="020B0604020202020204" pitchFamily="34" charset="0"/>
        <a:buChar char="•"/>
        <a:defRPr sz="3898" kern="1200">
          <a:solidFill>
            <a:schemeClr val="tx1"/>
          </a:solidFill>
          <a:latin typeface="+mn-lt"/>
          <a:ea typeface="+mn-ea"/>
          <a:cs typeface="+mn-cs"/>
        </a:defRPr>
      </a:lvl6pPr>
      <a:lvl7pPr marL="6434839" indent="-494988" algn="l" defTabSz="1979950" rtl="0" eaLnBrk="1" latinLnBrk="0" hangingPunct="1">
        <a:lnSpc>
          <a:spcPct val="90000"/>
        </a:lnSpc>
        <a:spcBef>
          <a:spcPts val="1083"/>
        </a:spcBef>
        <a:buFont typeface="Arial" panose="020B0604020202020204" pitchFamily="34" charset="0"/>
        <a:buChar char="•"/>
        <a:defRPr sz="3898" kern="1200">
          <a:solidFill>
            <a:schemeClr val="tx1"/>
          </a:solidFill>
          <a:latin typeface="+mn-lt"/>
          <a:ea typeface="+mn-ea"/>
          <a:cs typeface="+mn-cs"/>
        </a:defRPr>
      </a:lvl7pPr>
      <a:lvl8pPr marL="7424814" indent="-494988" algn="l" defTabSz="1979950" rtl="0" eaLnBrk="1" latinLnBrk="0" hangingPunct="1">
        <a:lnSpc>
          <a:spcPct val="90000"/>
        </a:lnSpc>
        <a:spcBef>
          <a:spcPts val="1083"/>
        </a:spcBef>
        <a:buFont typeface="Arial" panose="020B0604020202020204" pitchFamily="34" charset="0"/>
        <a:buChar char="•"/>
        <a:defRPr sz="3898" kern="1200">
          <a:solidFill>
            <a:schemeClr val="tx1"/>
          </a:solidFill>
          <a:latin typeface="+mn-lt"/>
          <a:ea typeface="+mn-ea"/>
          <a:cs typeface="+mn-cs"/>
        </a:defRPr>
      </a:lvl8pPr>
      <a:lvl9pPr marL="8414789" indent="-494988" algn="l" defTabSz="1979950" rtl="0" eaLnBrk="1" latinLnBrk="0" hangingPunct="1">
        <a:lnSpc>
          <a:spcPct val="90000"/>
        </a:lnSpc>
        <a:spcBef>
          <a:spcPts val="1083"/>
        </a:spcBef>
        <a:buFont typeface="Arial" panose="020B0604020202020204" pitchFamily="34" charset="0"/>
        <a:buChar char="•"/>
        <a:defRPr sz="389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979950" rtl="0" eaLnBrk="1" latinLnBrk="0" hangingPunct="1">
        <a:defRPr sz="3898" kern="1200">
          <a:solidFill>
            <a:schemeClr val="tx1"/>
          </a:solidFill>
          <a:latin typeface="+mn-lt"/>
          <a:ea typeface="+mn-ea"/>
          <a:cs typeface="+mn-cs"/>
        </a:defRPr>
      </a:lvl1pPr>
      <a:lvl2pPr marL="989975" algn="l" defTabSz="1979950" rtl="0" eaLnBrk="1" latinLnBrk="0" hangingPunct="1">
        <a:defRPr sz="3898" kern="1200">
          <a:solidFill>
            <a:schemeClr val="tx1"/>
          </a:solidFill>
          <a:latin typeface="+mn-lt"/>
          <a:ea typeface="+mn-ea"/>
          <a:cs typeface="+mn-cs"/>
        </a:defRPr>
      </a:lvl2pPr>
      <a:lvl3pPr marL="1979950" algn="l" defTabSz="1979950" rtl="0" eaLnBrk="1" latinLnBrk="0" hangingPunct="1">
        <a:defRPr sz="3898" kern="1200">
          <a:solidFill>
            <a:schemeClr val="tx1"/>
          </a:solidFill>
          <a:latin typeface="+mn-lt"/>
          <a:ea typeface="+mn-ea"/>
          <a:cs typeface="+mn-cs"/>
        </a:defRPr>
      </a:lvl3pPr>
      <a:lvl4pPr marL="2969925" algn="l" defTabSz="1979950" rtl="0" eaLnBrk="1" latinLnBrk="0" hangingPunct="1">
        <a:defRPr sz="3898" kern="1200">
          <a:solidFill>
            <a:schemeClr val="tx1"/>
          </a:solidFill>
          <a:latin typeface="+mn-lt"/>
          <a:ea typeface="+mn-ea"/>
          <a:cs typeface="+mn-cs"/>
        </a:defRPr>
      </a:lvl4pPr>
      <a:lvl5pPr marL="3959901" algn="l" defTabSz="1979950" rtl="0" eaLnBrk="1" latinLnBrk="0" hangingPunct="1">
        <a:defRPr sz="3898" kern="1200">
          <a:solidFill>
            <a:schemeClr val="tx1"/>
          </a:solidFill>
          <a:latin typeface="+mn-lt"/>
          <a:ea typeface="+mn-ea"/>
          <a:cs typeface="+mn-cs"/>
        </a:defRPr>
      </a:lvl5pPr>
      <a:lvl6pPr marL="4949876" algn="l" defTabSz="1979950" rtl="0" eaLnBrk="1" latinLnBrk="0" hangingPunct="1">
        <a:defRPr sz="3898" kern="1200">
          <a:solidFill>
            <a:schemeClr val="tx1"/>
          </a:solidFill>
          <a:latin typeface="+mn-lt"/>
          <a:ea typeface="+mn-ea"/>
          <a:cs typeface="+mn-cs"/>
        </a:defRPr>
      </a:lvl6pPr>
      <a:lvl7pPr marL="5939851" algn="l" defTabSz="1979950" rtl="0" eaLnBrk="1" latinLnBrk="0" hangingPunct="1">
        <a:defRPr sz="3898" kern="1200">
          <a:solidFill>
            <a:schemeClr val="tx1"/>
          </a:solidFill>
          <a:latin typeface="+mn-lt"/>
          <a:ea typeface="+mn-ea"/>
          <a:cs typeface="+mn-cs"/>
        </a:defRPr>
      </a:lvl7pPr>
      <a:lvl8pPr marL="6929826" algn="l" defTabSz="1979950" rtl="0" eaLnBrk="1" latinLnBrk="0" hangingPunct="1">
        <a:defRPr sz="3898" kern="1200">
          <a:solidFill>
            <a:schemeClr val="tx1"/>
          </a:solidFill>
          <a:latin typeface="+mn-lt"/>
          <a:ea typeface="+mn-ea"/>
          <a:cs typeface="+mn-cs"/>
        </a:defRPr>
      </a:lvl8pPr>
      <a:lvl9pPr marL="7919801" algn="l" defTabSz="1979950" rtl="0" eaLnBrk="1" latinLnBrk="0" hangingPunct="1">
        <a:defRPr sz="389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"/><Relationship Id="rId3" Type="http://schemas.openxmlformats.org/officeDocument/2006/relationships/image" Target="../media/image2.tiff"/><Relationship Id="rId7" Type="http://schemas.openxmlformats.org/officeDocument/2006/relationships/image" Target="../media/image6.tif"/><Relationship Id="rId12" Type="http://schemas.openxmlformats.org/officeDocument/2006/relationships/image" Target="../media/image11.jpg"/><Relationship Id="rId17" Type="http://schemas.openxmlformats.org/officeDocument/2006/relationships/image" Target="../media/image16.tif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5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openxmlformats.org/officeDocument/2006/relationships/image" Target="../media/image10.tif"/><Relationship Id="rId5" Type="http://schemas.openxmlformats.org/officeDocument/2006/relationships/image" Target="../media/image4.tif"/><Relationship Id="rId15" Type="http://schemas.openxmlformats.org/officeDocument/2006/relationships/image" Target="../media/image14.tiff"/><Relationship Id="rId10" Type="http://schemas.openxmlformats.org/officeDocument/2006/relationships/image" Target="../media/image9.ti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png"/><Relationship Id="rId13" Type="http://schemas.openxmlformats.org/officeDocument/2006/relationships/image" Target="../media/image27.png"/><Relationship Id="rId3" Type="http://schemas.openxmlformats.org/officeDocument/2006/relationships/image" Target="../media/image17.png"/><Relationship Id="rId7" Type="http://schemas.openxmlformats.org/officeDocument/2006/relationships/image" Target="../media/image21.png"/><Relationship Id="rId12" Type="http://schemas.openxmlformats.org/officeDocument/2006/relationships/image" Target="../media/image26.pn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3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0.png"/><Relationship Id="rId11" Type="http://schemas.openxmlformats.org/officeDocument/2006/relationships/image" Target="../media/image25.png"/><Relationship Id="rId5" Type="http://schemas.openxmlformats.org/officeDocument/2006/relationships/image" Target="../media/image19.png"/><Relationship Id="rId15" Type="http://schemas.openxmlformats.org/officeDocument/2006/relationships/image" Target="../media/image29.png"/><Relationship Id="rId10" Type="http://schemas.openxmlformats.org/officeDocument/2006/relationships/image" Target="../media/image24.png"/><Relationship Id="rId4" Type="http://schemas.openxmlformats.org/officeDocument/2006/relationships/image" Target="../media/image18.png"/><Relationship Id="rId9" Type="http://schemas.openxmlformats.org/officeDocument/2006/relationships/image" Target="../media/image23.png"/><Relationship Id="rId14" Type="http://schemas.openxmlformats.org/officeDocument/2006/relationships/image" Target="../media/image28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t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32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3.tif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chart" Target="../charts/chart4.xml"/><Relationship Id="rId3" Type="http://schemas.openxmlformats.org/officeDocument/2006/relationships/image" Target="../media/image35.tif"/><Relationship Id="rId7" Type="http://schemas.openxmlformats.org/officeDocument/2006/relationships/image" Target="../media/image37.tif"/><Relationship Id="rId2" Type="http://schemas.openxmlformats.org/officeDocument/2006/relationships/image" Target="../media/image34.tif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3.xml"/><Relationship Id="rId5" Type="http://schemas.openxmlformats.org/officeDocument/2006/relationships/image" Target="../media/image36.tif"/><Relationship Id="rId10" Type="http://schemas.openxmlformats.org/officeDocument/2006/relationships/image" Target="../media/image38.jpg"/><Relationship Id="rId4" Type="http://schemas.openxmlformats.org/officeDocument/2006/relationships/chart" Target="../charts/chart2.xml"/><Relationship Id="rId9" Type="http://schemas.openxmlformats.org/officeDocument/2006/relationships/chart" Target="../charts/chart5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7.xml"/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0.xml"/><Relationship Id="rId5" Type="http://schemas.openxmlformats.org/officeDocument/2006/relationships/chart" Target="../charts/chart9.xml"/><Relationship Id="rId4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759538" y="1275603"/>
            <a:ext cx="19205298" cy="378565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4000" b="1" i="1" dirty="0">
                <a:latin typeface="Times New Roman" pitchFamily="18" charset="0"/>
                <a:cs typeface="Times New Roman" pitchFamily="18" charset="0"/>
              </a:rPr>
              <a:t>SiSTL1</a:t>
            </a:r>
            <a:r>
              <a:rPr lang="en-US" altLang="zh-CN" sz="4000" b="1" dirty="0">
                <a:latin typeface="Times New Roman" pitchFamily="18" charset="0"/>
                <a:cs typeface="Times New Roman" pitchFamily="18" charset="0"/>
              </a:rPr>
              <a:t> encoding a large subunit of RNR, is crucial for plant growth, chloroplast biogenesis, and cell cycle progression in </a:t>
            </a:r>
            <a:r>
              <a:rPr lang="en-US" altLang="zh-CN" sz="4000" b="1" i="1" dirty="0" err="1">
                <a:latin typeface="Times New Roman" pitchFamily="18" charset="0"/>
                <a:cs typeface="Times New Roman" pitchFamily="18" charset="0"/>
              </a:rPr>
              <a:t>Setaria</a:t>
            </a:r>
            <a:r>
              <a:rPr lang="en-US" altLang="zh-CN" sz="4000" b="1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4000" b="1" i="1" dirty="0" err="1">
                <a:latin typeface="Times New Roman" pitchFamily="18" charset="0"/>
                <a:cs typeface="Times New Roman" pitchFamily="18" charset="0"/>
              </a:rPr>
              <a:t>italica</a:t>
            </a:r>
            <a:r>
              <a:rPr lang="en-US" altLang="zh-CN" sz="4000" b="1" dirty="0">
                <a:latin typeface="Times New Roman" pitchFamily="18" charset="0"/>
                <a:cs typeface="Times New Roman" pitchFamily="18" charset="0"/>
              </a:rPr>
              <a:t>. </a:t>
            </a:r>
            <a:endParaRPr lang="zh-CN" altLang="zh-CN" sz="320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4000" kern="1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hanjuan</a:t>
            </a:r>
            <a:r>
              <a:rPr lang="en-US" altLang="zh-CN" sz="40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Tang, </a:t>
            </a:r>
            <a:r>
              <a:rPr lang="en-US" altLang="zh-CN" sz="4000" kern="1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ha</a:t>
            </a:r>
            <a:r>
              <a:rPr lang="en-US" altLang="zh-CN" sz="40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Tang, </a:t>
            </a:r>
            <a:r>
              <a:rPr lang="en-US" altLang="zh-CN" sz="4000" kern="1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huo</a:t>
            </a:r>
            <a:r>
              <a:rPr lang="en-US" altLang="zh-CN" sz="40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Zhang, </a:t>
            </a:r>
            <a:r>
              <a:rPr lang="en-US" altLang="zh-CN" sz="4000" kern="1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ingzhao</a:t>
            </a:r>
            <a:r>
              <a:rPr lang="en-US" altLang="zh-CN" sz="40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Luo, </a:t>
            </a:r>
            <a:r>
              <a:rPr lang="en-US" altLang="zh-CN" sz="4000" kern="1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uanqing</a:t>
            </a:r>
            <a:r>
              <a:rPr lang="en-US" altLang="zh-CN" sz="40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4000" kern="1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Jia</a:t>
            </a:r>
            <a:r>
              <a:rPr lang="en-US" altLang="zh-CN" sz="40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4000" kern="1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ui</a:t>
            </a:r>
            <a:r>
              <a:rPr lang="en-US" altLang="zh-CN" sz="40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4000" kern="1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Zhi</a:t>
            </a:r>
            <a:r>
              <a:rPr lang="en-US" altLang="zh-CN" sz="40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†</a:t>
            </a:r>
            <a:r>
              <a:rPr lang="en-US" altLang="zh-CN" sz="40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4000" kern="1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ianmin</a:t>
            </a:r>
            <a:r>
              <a:rPr lang="en-US" altLang="zh-CN" sz="40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4000" kern="1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iao</a:t>
            </a:r>
            <a:r>
              <a:rPr lang="en-US" altLang="zh-CN" sz="40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†</a:t>
            </a:r>
            <a:endParaRPr lang="zh-CN" altLang="zh-CN" sz="320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2326279" y="17306176"/>
            <a:ext cx="16197943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3200" b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. Density curves of </a:t>
            </a:r>
            <a:r>
              <a:rPr lang="en-US" altLang="zh-CN" sz="3200" b="1" kern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SCs/MCs </a:t>
            </a:r>
            <a:r>
              <a:rPr lang="en-US" altLang="zh-CN" sz="3200" b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aining zero to six chloroplasts in Yugu1 and </a:t>
            </a:r>
            <a:r>
              <a:rPr lang="en-US" altLang="zh-CN" sz="3200" b="1" i="1" kern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stl1</a:t>
            </a:r>
            <a:r>
              <a:rPr lang="en-US" altLang="zh-CN" sz="3200" b="1" kern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3200" kern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ta were obtained from resin-embedded sections of the fifth leaves of Yugu1 </a:t>
            </a:r>
            <a:r>
              <a:rPr lang="en-US" altLang="zh-CN" sz="32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zh-CN" sz="3200" i="1" kern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stl1</a:t>
            </a:r>
            <a:r>
              <a:rPr lang="en-US" altLang="zh-CN" sz="3200" kern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zh-CN" altLang="zh-CN" sz="320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7" name="组合 6"/>
          <p:cNvGrpSpPr/>
          <p:nvPr/>
        </p:nvGrpSpPr>
        <p:grpSpPr>
          <a:xfrm>
            <a:off x="3228503" y="8752114"/>
            <a:ext cx="14393494" cy="7433517"/>
            <a:chOff x="1442607" y="764704"/>
            <a:chExt cx="10067312" cy="5133927"/>
          </a:xfrm>
        </p:grpSpPr>
        <p:pic>
          <p:nvPicPr>
            <p:cNvPr id="8" name="图片 7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91544" y="764704"/>
              <a:ext cx="8229600" cy="4867275"/>
            </a:xfrm>
            <a:prstGeom prst="rect">
              <a:avLst/>
            </a:prstGeom>
          </p:spPr>
        </p:pic>
        <p:sp>
          <p:nvSpPr>
            <p:cNvPr id="9" name="文本框 8"/>
            <p:cNvSpPr txBox="1"/>
            <p:nvPr/>
          </p:nvSpPr>
          <p:spPr>
            <a:xfrm>
              <a:off x="2639616" y="5229200"/>
              <a:ext cx="46689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3719299" y="5229200"/>
              <a:ext cx="46689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4798982" y="5229200"/>
              <a:ext cx="46689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5872899" y="5229200"/>
              <a:ext cx="466890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</a:p>
            <a:p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6949548" y="5229200"/>
              <a:ext cx="46689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8026197" y="5229199"/>
              <a:ext cx="46689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文本框 14"/>
            <p:cNvSpPr txBox="1"/>
            <p:nvPr/>
          </p:nvSpPr>
          <p:spPr>
            <a:xfrm>
              <a:off x="9100114" y="5229199"/>
              <a:ext cx="46689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文本框 15"/>
            <p:cNvSpPr txBox="1"/>
            <p:nvPr/>
          </p:nvSpPr>
          <p:spPr>
            <a:xfrm>
              <a:off x="1991544" y="4869160"/>
              <a:ext cx="46689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文本框 16"/>
            <p:cNvSpPr txBox="1"/>
            <p:nvPr/>
          </p:nvSpPr>
          <p:spPr>
            <a:xfrm>
              <a:off x="1991544" y="3573016"/>
              <a:ext cx="46689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1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文本框 17"/>
            <p:cNvSpPr txBox="1"/>
            <p:nvPr/>
          </p:nvSpPr>
          <p:spPr>
            <a:xfrm>
              <a:off x="1991544" y="908720"/>
              <a:ext cx="46689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3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文本框 18"/>
            <p:cNvSpPr txBox="1"/>
            <p:nvPr/>
          </p:nvSpPr>
          <p:spPr>
            <a:xfrm>
              <a:off x="1991544" y="2240868"/>
              <a:ext cx="46689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文本框 19"/>
            <p:cNvSpPr txBox="1"/>
            <p:nvPr/>
          </p:nvSpPr>
          <p:spPr>
            <a:xfrm>
              <a:off x="9987698" y="2636912"/>
              <a:ext cx="1522221" cy="27633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ugu1-BSCs</a:t>
              </a:r>
              <a:endParaRPr lang="zh-CN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文本框 20"/>
            <p:cNvSpPr txBox="1"/>
            <p:nvPr/>
          </p:nvSpPr>
          <p:spPr>
            <a:xfrm>
              <a:off x="9987697" y="2859959"/>
              <a:ext cx="1522222" cy="27633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20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  <a:r>
                <a:rPr lang="en-US" altLang="zh-CN" sz="20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tl1 </a:t>
              </a:r>
              <a:r>
                <a:rPr lang="en-US" altLang="zh-CN" sz="2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 BSCs</a:t>
              </a:r>
              <a:endParaRPr lang="zh-CN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9987698" y="3071565"/>
              <a:ext cx="1522221" cy="27633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ugu1- MCs</a:t>
              </a:r>
              <a:endParaRPr lang="zh-CN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文本框 22"/>
            <p:cNvSpPr txBox="1"/>
            <p:nvPr/>
          </p:nvSpPr>
          <p:spPr>
            <a:xfrm>
              <a:off x="9987698" y="3312148"/>
              <a:ext cx="1316646" cy="27633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20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  <a:r>
                <a:rPr lang="en-US" altLang="zh-CN" sz="20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tl1 </a:t>
              </a:r>
              <a:r>
                <a:rPr lang="en-US" altLang="zh-CN" sz="2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  MCs</a:t>
              </a:r>
              <a:endParaRPr lang="zh-CN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矩形 23"/>
            <p:cNvSpPr/>
            <p:nvPr/>
          </p:nvSpPr>
          <p:spPr>
            <a:xfrm>
              <a:off x="9768408" y="2379367"/>
              <a:ext cx="219289" cy="25754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5" name="矩形 24"/>
            <p:cNvSpPr/>
            <p:nvPr/>
          </p:nvSpPr>
          <p:spPr>
            <a:xfrm>
              <a:off x="1991544" y="2731186"/>
              <a:ext cx="288031" cy="58096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6" name="文本框 25"/>
            <p:cNvSpPr txBox="1"/>
            <p:nvPr/>
          </p:nvSpPr>
          <p:spPr>
            <a:xfrm rot="16200000">
              <a:off x="1039578" y="2640359"/>
              <a:ext cx="1172015" cy="3659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ensity</a:t>
              </a:r>
              <a:endParaRPr lang="zh-CN" alt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文本框 26"/>
            <p:cNvSpPr txBox="1"/>
            <p:nvPr/>
          </p:nvSpPr>
          <p:spPr>
            <a:xfrm>
              <a:off x="3822615" y="5529299"/>
              <a:ext cx="420358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 of chloroplasts per BSC/ MC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8" name="直接连接符 27"/>
            <p:cNvCxnSpPr/>
            <p:nvPr/>
          </p:nvCxnSpPr>
          <p:spPr>
            <a:xfrm flipH="1">
              <a:off x="5159949" y="1537122"/>
              <a:ext cx="103038" cy="27699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文本框 28"/>
            <p:cNvSpPr txBox="1"/>
            <p:nvPr/>
          </p:nvSpPr>
          <p:spPr>
            <a:xfrm>
              <a:off x="4859675" y="1269769"/>
              <a:ext cx="806624" cy="18068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SCs in Yugu1</a:t>
              </a:r>
              <a:endParaRPr lang="zh-CN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文本框 29"/>
            <p:cNvSpPr txBox="1"/>
            <p:nvPr/>
          </p:nvSpPr>
          <p:spPr>
            <a:xfrm>
              <a:off x="3224896" y="1269769"/>
              <a:ext cx="692008" cy="18068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SCs in </a:t>
              </a:r>
              <a:r>
                <a:rPr lang="en-US" altLang="zh-CN" sz="11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  <a:r>
                <a:rPr lang="en-US" altLang="zh-CN" sz="11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tl1</a:t>
              </a:r>
              <a:endParaRPr lang="zh-CN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1" name="直接连接符 30"/>
            <p:cNvCxnSpPr/>
            <p:nvPr/>
          </p:nvCxnSpPr>
          <p:spPr>
            <a:xfrm flipH="1">
              <a:off x="3364264" y="1537123"/>
              <a:ext cx="103038" cy="27699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文本框 31"/>
            <p:cNvSpPr txBox="1"/>
            <p:nvPr/>
          </p:nvSpPr>
          <p:spPr>
            <a:xfrm>
              <a:off x="8118824" y="3294796"/>
              <a:ext cx="100484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Cs in </a:t>
              </a:r>
              <a:r>
                <a:rPr lang="en-US" altLang="zh-CN" sz="11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  <a:r>
                <a:rPr lang="en-US" altLang="zh-CN" sz="11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tl1</a:t>
              </a:r>
              <a:r>
                <a:rPr lang="en-US" altLang="zh-CN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3" name="直接连接符 32"/>
            <p:cNvCxnSpPr/>
            <p:nvPr/>
          </p:nvCxnSpPr>
          <p:spPr>
            <a:xfrm flipH="1">
              <a:off x="8157560" y="3579316"/>
              <a:ext cx="233445" cy="33193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文本框 33"/>
            <p:cNvSpPr txBox="1"/>
            <p:nvPr/>
          </p:nvSpPr>
          <p:spPr>
            <a:xfrm>
              <a:off x="7269438" y="1675621"/>
              <a:ext cx="122364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Cs in Yugu1</a:t>
              </a:r>
              <a:endParaRPr lang="zh-CN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5" name="直接连接符 34"/>
            <p:cNvCxnSpPr/>
            <p:nvPr/>
          </p:nvCxnSpPr>
          <p:spPr>
            <a:xfrm flipH="1">
              <a:off x="7416438" y="1960332"/>
              <a:ext cx="103038" cy="27699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4723480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2" name="组合 51"/>
          <p:cNvGrpSpPr/>
          <p:nvPr/>
        </p:nvGrpSpPr>
        <p:grpSpPr>
          <a:xfrm>
            <a:off x="931199" y="467447"/>
            <a:ext cx="18364744" cy="22784904"/>
            <a:chOff x="931199" y="467447"/>
            <a:chExt cx="18364744" cy="22784904"/>
          </a:xfrm>
        </p:grpSpPr>
        <p:sp>
          <p:nvSpPr>
            <p:cNvPr id="39" name="矩形 38"/>
            <p:cNvSpPr/>
            <p:nvPr/>
          </p:nvSpPr>
          <p:spPr>
            <a:xfrm>
              <a:off x="931199" y="18835757"/>
              <a:ext cx="18364744" cy="441659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>
                <a:lnSpc>
                  <a:spcPct val="150000"/>
                </a:lnSpc>
                <a:spcBef>
                  <a:spcPts val="600"/>
                </a:spcBef>
              </a:pPr>
              <a:r>
                <a:rPr lang="en-US" altLang="zh-CN" sz="3200" b="1" kern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l figure </a:t>
              </a:r>
              <a:r>
                <a:rPr lang="en-US" altLang="zh-CN" sz="3200" b="1" kern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altLang="zh-CN" sz="3200" b="1" kern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zh-CN" sz="3200" b="1" kern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hotographs showing four striped T</a:t>
              </a:r>
              <a:r>
                <a:rPr lang="en-US" altLang="zh-CN" sz="3200" b="1" kern="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r>
                <a:rPr lang="en-US" altLang="zh-CN" sz="3200" b="1" kern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lines, striped T</a:t>
              </a:r>
              <a:r>
                <a:rPr lang="en-US" altLang="zh-CN" sz="3200" b="1" kern="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lang="en-US" altLang="zh-CN" sz="3200" b="1" kern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lines of OsC1-4 and OsC2-12, and T2 lines of OsC1-8 </a:t>
              </a:r>
              <a:endParaRPr lang="en-US" altLang="zh-CN" sz="3200" b="1" kern="0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ct val="150000"/>
                </a:lnSpc>
                <a:spcBef>
                  <a:spcPts val="600"/>
                </a:spcBef>
              </a:pP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) Figure </a:t>
              </a:r>
              <a:r>
                <a:rPr lang="en-US" altLang="zh-CN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f the 4 striped T</a:t>
              </a:r>
              <a:r>
                <a:rPr lang="en-US" altLang="zh-CN" sz="24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r>
                <a:rPr lang="en-US" altLang="zh-CN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ines, </a:t>
              </a:r>
              <a:r>
                <a:rPr lang="en-US" altLang="zh-CN" sz="2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C1-2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</a:t>
              </a:r>
              <a:r>
                <a:rPr lang="en-US" altLang="zh-CN" sz="2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sC1-4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</a:t>
              </a:r>
              <a:r>
                <a:rPr lang="en-US" altLang="zh-CN" sz="2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sC1-8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and </a:t>
              </a:r>
              <a:r>
                <a:rPr lang="en-US" altLang="zh-CN" sz="2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C2-12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r>
                <a:rPr lang="en-US" altLang="zh-CN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) Figure </a:t>
              </a:r>
              <a:r>
                <a:rPr lang="en-US" altLang="zh-CN" sz="2400" kern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f the T</a:t>
              </a:r>
              <a:r>
                <a:rPr lang="en-US" altLang="zh-CN" sz="2400" kern="0" baseline="-25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lang="en-US" altLang="zh-CN" sz="2400" kern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escendants derived from </a:t>
              </a:r>
              <a:r>
                <a:rPr lang="en-US" altLang="zh-CN" sz="2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C1-4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r>
                <a:rPr lang="en-US" altLang="zh-CN" sz="2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C1-4 T1-W was a normal green individual; </a:t>
              </a:r>
              <a:r>
                <a:rPr lang="en-US" altLang="zh-CN" sz="2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C1-4 T1-1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</a:t>
              </a:r>
              <a:r>
                <a:rPr lang="en-US" altLang="zh-CN" sz="2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sC1-4 T1-2 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 </a:t>
              </a:r>
              <a:r>
                <a:rPr lang="en-US" altLang="zh-CN" sz="2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C1-4 T1-3 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ere</a:t>
              </a:r>
              <a:r>
                <a:rPr lang="en-US" altLang="zh-CN" sz="2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riped individuals. (</a:t>
              </a:r>
              <a:r>
                <a:rPr lang="en-US" altLang="zh-CN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)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2400" kern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of the </a:t>
              </a:r>
              <a:r>
                <a:rPr lang="en-US" altLang="zh-CN" sz="2400" kern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r>
                <a:rPr lang="en-US" altLang="zh-CN" sz="2400" kern="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lang="en-US" altLang="zh-CN" sz="2400" kern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escendants derived from </a:t>
              </a:r>
              <a:r>
                <a:rPr lang="en-US" altLang="zh-CN" sz="2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C2-12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r>
                <a:rPr lang="en-US" altLang="zh-CN" sz="2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C2-12 T1-W was a normal green individual; </a:t>
              </a:r>
              <a:r>
                <a:rPr lang="en-US" altLang="zh-CN" sz="2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C2-12 T1-1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</a:t>
              </a:r>
              <a:r>
                <a:rPr lang="en-US" altLang="zh-CN" sz="2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sC2-12 T1-2 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</a:t>
              </a:r>
              <a:r>
                <a:rPr lang="en-US" altLang="zh-CN" sz="2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sC2-12 T1-3 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ere</a:t>
              </a:r>
              <a:r>
                <a:rPr lang="en-US" altLang="zh-CN" sz="2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riped </a:t>
              </a:r>
              <a:r>
                <a:rPr lang="en-US" altLang="zh-CN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dividuals. (D) 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</a:t>
              </a:r>
              <a:r>
                <a:rPr lang="en-US" altLang="zh-CN" sz="2400" kern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f the </a:t>
              </a:r>
              <a:r>
                <a:rPr lang="en-US" altLang="zh-CN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escendants derived from </a:t>
              </a:r>
              <a:r>
                <a:rPr lang="en-US" altLang="zh-CN" sz="2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C1-8 T1-1</a:t>
              </a:r>
              <a:r>
                <a:rPr lang="en-US" altLang="zh-CN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r>
                <a:rPr lang="en-US" altLang="zh-CN" sz="2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C1-8 T2-W 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as </a:t>
              </a:r>
              <a:r>
                <a:rPr lang="en-US" altLang="zh-CN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 normal green individual; </a:t>
              </a:r>
              <a:r>
                <a:rPr lang="en-US" altLang="zh-CN" sz="2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C1-8 T2-1 </a:t>
              </a:r>
              <a:r>
                <a:rPr lang="en-US" altLang="zh-CN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</a:t>
              </a:r>
              <a:r>
                <a:rPr lang="en-US" altLang="zh-CN" sz="2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sC1-8 T2-2 </a:t>
              </a:r>
              <a:r>
                <a:rPr lang="en-US" altLang="zh-CN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ere</a:t>
              </a:r>
              <a:r>
                <a:rPr lang="en-US" altLang="zh-CN" sz="2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riped individuals. White 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ars at right bottom  = 1 cm; White bars beside the enlarged leaves = 0.2 cm. </a:t>
              </a:r>
              <a:endParaRPr lang="zh-CN" altLang="zh-CN" sz="2400" kern="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51" name="组合 50"/>
            <p:cNvGrpSpPr/>
            <p:nvPr/>
          </p:nvGrpSpPr>
          <p:grpSpPr>
            <a:xfrm>
              <a:off x="4044794" y="467447"/>
              <a:ext cx="12137554" cy="18368310"/>
              <a:chOff x="3225518" y="341152"/>
              <a:chExt cx="12137554" cy="18368310"/>
            </a:xfrm>
          </p:grpSpPr>
          <p:grpSp>
            <p:nvGrpSpPr>
              <p:cNvPr id="37" name="组合 36"/>
              <p:cNvGrpSpPr/>
              <p:nvPr/>
            </p:nvGrpSpPr>
            <p:grpSpPr>
              <a:xfrm>
                <a:off x="3235937" y="341152"/>
                <a:ext cx="12127135" cy="18368310"/>
                <a:chOff x="3268594" y="117050"/>
                <a:chExt cx="12127135" cy="18368310"/>
              </a:xfrm>
            </p:grpSpPr>
            <p:grpSp>
              <p:nvGrpSpPr>
                <p:cNvPr id="36" name="组合 35"/>
                <p:cNvGrpSpPr/>
                <p:nvPr/>
              </p:nvGrpSpPr>
              <p:grpSpPr>
                <a:xfrm>
                  <a:off x="3268594" y="117050"/>
                  <a:ext cx="12127135" cy="18368310"/>
                  <a:chOff x="1035970" y="-2149459"/>
                  <a:chExt cx="12127135" cy="18368310"/>
                </a:xfrm>
              </p:grpSpPr>
              <p:grpSp>
                <p:nvGrpSpPr>
                  <p:cNvPr id="2" name="组合 1"/>
                  <p:cNvGrpSpPr/>
                  <p:nvPr/>
                </p:nvGrpSpPr>
                <p:grpSpPr>
                  <a:xfrm>
                    <a:off x="1931161" y="11834104"/>
                    <a:ext cx="8719643" cy="4384747"/>
                    <a:chOff x="-87032" y="15412469"/>
                    <a:chExt cx="12207041" cy="6138409"/>
                  </a:xfrm>
                </p:grpSpPr>
                <p:grpSp>
                  <p:nvGrpSpPr>
                    <p:cNvPr id="3" name="组合 2"/>
                    <p:cNvGrpSpPr/>
                    <p:nvPr/>
                  </p:nvGrpSpPr>
                  <p:grpSpPr>
                    <a:xfrm>
                      <a:off x="-87032" y="15412469"/>
                      <a:ext cx="12207041" cy="5587882"/>
                      <a:chOff x="-989556" y="15934984"/>
                      <a:chExt cx="12207041" cy="5587882"/>
                    </a:xfrm>
                  </p:grpSpPr>
                  <p:pic>
                    <p:nvPicPr>
                      <p:cNvPr id="7" name="图片 6"/>
                      <p:cNvPicPr>
                        <a:picLocks noChangeAspect="1"/>
                      </p:cNvPicPr>
                      <p:nvPr/>
                    </p:nvPicPr>
                    <p:blipFill>
                      <a:blip r:embed="rId3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-989556" y="15939329"/>
                        <a:ext cx="3528587" cy="5543792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8" name="图片 7"/>
                      <p:cNvPicPr>
                        <a:picLocks noChangeAspect="1"/>
                      </p:cNvPicPr>
                      <p:nvPr/>
                    </p:nvPicPr>
                    <p:blipFill>
                      <a:blip r:embed="rId4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8456072" y="15934984"/>
                        <a:ext cx="2761413" cy="5543791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9" name="图片 8"/>
                      <p:cNvPicPr>
                        <a:picLocks noChangeAspect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4097711" y="15979075"/>
                        <a:ext cx="2959469" cy="5543791"/>
                      </a:xfrm>
                      <a:prstGeom prst="rect">
                        <a:avLst/>
                      </a:prstGeom>
                    </p:spPr>
                  </p:pic>
                </p:grpSp>
                <p:sp>
                  <p:nvSpPr>
                    <p:cNvPr id="4" name="矩形 3"/>
                    <p:cNvSpPr/>
                    <p:nvPr/>
                  </p:nvSpPr>
                  <p:spPr>
                    <a:xfrm>
                      <a:off x="320466" y="20902279"/>
                      <a:ext cx="2824719" cy="646306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altLang="zh-CN" sz="24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sC1-8 T2-W</a:t>
                      </a:r>
                      <a:endParaRPr lang="zh-CN" altLang="en-US" sz="2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5" name="矩形 4"/>
                    <p:cNvSpPr/>
                    <p:nvPr/>
                  </p:nvSpPr>
                  <p:spPr>
                    <a:xfrm>
                      <a:off x="5215404" y="20904572"/>
                      <a:ext cx="2545281" cy="646306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altLang="zh-CN" sz="2400" b="1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sC1-8 T2-1</a:t>
                      </a:r>
                      <a:endParaRPr lang="zh-CN" altLang="en-US" sz="2400" b="1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6" name="矩形 5"/>
                    <p:cNvSpPr/>
                    <p:nvPr/>
                  </p:nvSpPr>
                  <p:spPr>
                    <a:xfrm>
                      <a:off x="9457446" y="20900819"/>
                      <a:ext cx="2545281" cy="646306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altLang="zh-CN" sz="2400" b="1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sC1-8 T2-2</a:t>
                      </a:r>
                      <a:endParaRPr lang="zh-CN" altLang="en-US" sz="2400" b="1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grpSp>
                <p:nvGrpSpPr>
                  <p:cNvPr id="10" name="组合 9"/>
                  <p:cNvGrpSpPr/>
                  <p:nvPr/>
                </p:nvGrpSpPr>
                <p:grpSpPr>
                  <a:xfrm>
                    <a:off x="1936861" y="2375051"/>
                    <a:ext cx="10551735" cy="4425830"/>
                    <a:chOff x="-577812" y="-4085604"/>
                    <a:chExt cx="14771871" cy="6195928"/>
                  </a:xfrm>
                </p:grpSpPr>
                <p:grpSp>
                  <p:nvGrpSpPr>
                    <p:cNvPr id="11" name="组合 10"/>
                    <p:cNvGrpSpPr/>
                    <p:nvPr/>
                  </p:nvGrpSpPr>
                  <p:grpSpPr>
                    <a:xfrm>
                      <a:off x="-577812" y="-4085604"/>
                      <a:ext cx="14771871" cy="5560273"/>
                      <a:chOff x="-1266582" y="-3705595"/>
                      <a:chExt cx="14771871" cy="5560273"/>
                    </a:xfrm>
                  </p:grpSpPr>
                  <p:grpSp>
                    <p:nvGrpSpPr>
                      <p:cNvPr id="16" name="组合 15"/>
                      <p:cNvGrpSpPr/>
                      <p:nvPr/>
                    </p:nvGrpSpPr>
                    <p:grpSpPr>
                      <a:xfrm>
                        <a:off x="2450961" y="-3705595"/>
                        <a:ext cx="11054328" cy="5560273"/>
                        <a:chOff x="-209112" y="-3408712"/>
                        <a:chExt cx="11054328" cy="5560273"/>
                      </a:xfrm>
                    </p:grpSpPr>
                    <p:pic>
                      <p:nvPicPr>
                        <p:cNvPr id="18" name="图片 17"/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6" cstate="print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tretch>
                          <a:fillRect/>
                        </a:stretch>
                      </p:blipFill>
                      <p:spPr>
                        <a:xfrm>
                          <a:off x="7502704" y="-3408712"/>
                          <a:ext cx="3342512" cy="5543789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19" name="图片 18"/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7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tretch>
                          <a:fillRect/>
                        </a:stretch>
                      </p:blipFill>
                      <p:spPr>
                        <a:xfrm>
                          <a:off x="3050186" y="-3408712"/>
                          <a:ext cx="3304157" cy="5543789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20" name="图片 19"/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8" cstate="print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tretch>
                          <a:fillRect/>
                        </a:stretch>
                      </p:blipFill>
                      <p:spPr>
                        <a:xfrm>
                          <a:off x="-209112" y="-3392229"/>
                          <a:ext cx="2337088" cy="5543790"/>
                        </a:xfrm>
                        <a:prstGeom prst="rect">
                          <a:avLst/>
                        </a:prstGeom>
                      </p:spPr>
                    </p:pic>
                  </p:grpSp>
                  <p:pic>
                    <p:nvPicPr>
                      <p:cNvPr id="17" name="图片 16"/>
                      <p:cNvPicPr>
                        <a:picLocks noChangeAspect="1"/>
                      </p:cNvPicPr>
                      <p:nvPr/>
                    </p:nvPicPr>
                    <p:blipFill>
                      <a:blip r:embed="rId9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-1266582" y="-3699763"/>
                        <a:ext cx="2717120" cy="5543790"/>
                      </a:xfrm>
                      <a:prstGeom prst="rect">
                        <a:avLst/>
                      </a:prstGeom>
                    </p:spPr>
                  </p:pic>
                </p:grpSp>
                <p:sp>
                  <p:nvSpPr>
                    <p:cNvPr id="12" name="矩形 11"/>
                    <p:cNvSpPr/>
                    <p:nvPr/>
                  </p:nvSpPr>
                  <p:spPr>
                    <a:xfrm>
                      <a:off x="-571319" y="1431966"/>
                      <a:ext cx="2824718" cy="646307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altLang="zh-CN" sz="24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sC1-4 T1-W</a:t>
                      </a:r>
                      <a:endParaRPr lang="zh-CN" altLang="en-US" sz="2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3" name="矩形 12"/>
                    <p:cNvSpPr/>
                    <p:nvPr/>
                  </p:nvSpPr>
                  <p:spPr>
                    <a:xfrm>
                      <a:off x="3058831" y="1464017"/>
                      <a:ext cx="2926781" cy="646307"/>
                    </a:xfrm>
                    <a:prstGeom prst="rect">
                      <a:avLst/>
                    </a:prstGeom>
                  </p:spPr>
                  <p:txBody>
                    <a:bodyPr wrap="square">
                      <a:spAutoFit/>
                    </a:bodyPr>
                    <a:lstStyle/>
                    <a:p>
                      <a:r>
                        <a:rPr lang="en-US" altLang="zh-CN" sz="2400" b="1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sC1-4 T1-1</a:t>
                      </a:r>
                      <a:endParaRPr lang="zh-CN" altLang="en-US" sz="2400" b="1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4" name="矩形 13"/>
                    <p:cNvSpPr/>
                    <p:nvPr/>
                  </p:nvSpPr>
                  <p:spPr>
                    <a:xfrm>
                      <a:off x="6778468" y="1417057"/>
                      <a:ext cx="2545280" cy="646307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altLang="zh-CN" sz="2400" b="1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sC1-4 T1-2</a:t>
                      </a:r>
                      <a:endParaRPr lang="zh-CN" altLang="en-US" sz="2400" b="1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5" name="矩形 14"/>
                    <p:cNvSpPr/>
                    <p:nvPr/>
                  </p:nvSpPr>
                  <p:spPr>
                    <a:xfrm>
                      <a:off x="11250162" y="1417056"/>
                      <a:ext cx="2545280" cy="646307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altLang="zh-CN" sz="2400" b="1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sC1-4 T1-3</a:t>
                      </a:r>
                      <a:endParaRPr lang="zh-CN" altLang="en-US" sz="2400" b="1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grpSp>
                <p:nvGrpSpPr>
                  <p:cNvPr id="21" name="组合 20"/>
                  <p:cNvGrpSpPr/>
                  <p:nvPr/>
                </p:nvGrpSpPr>
                <p:grpSpPr>
                  <a:xfrm>
                    <a:off x="1931161" y="7098932"/>
                    <a:ext cx="11231944" cy="4428861"/>
                    <a:chOff x="-768980" y="-3826597"/>
                    <a:chExt cx="15724127" cy="6200169"/>
                  </a:xfrm>
                </p:grpSpPr>
                <p:grpSp>
                  <p:nvGrpSpPr>
                    <p:cNvPr id="22" name="组合 21"/>
                    <p:cNvGrpSpPr/>
                    <p:nvPr/>
                  </p:nvGrpSpPr>
                  <p:grpSpPr>
                    <a:xfrm>
                      <a:off x="-768980" y="-3826597"/>
                      <a:ext cx="15724127" cy="5553863"/>
                      <a:chOff x="-1065862" y="-3137225"/>
                      <a:chExt cx="15724127" cy="5553863"/>
                    </a:xfrm>
                  </p:grpSpPr>
                  <p:grpSp>
                    <p:nvGrpSpPr>
                      <p:cNvPr id="27" name="组合 26"/>
                      <p:cNvGrpSpPr/>
                      <p:nvPr/>
                    </p:nvGrpSpPr>
                    <p:grpSpPr>
                      <a:xfrm>
                        <a:off x="2922486" y="-3137222"/>
                        <a:ext cx="11735779" cy="5553860"/>
                        <a:chOff x="179287" y="-3339102"/>
                        <a:chExt cx="11735779" cy="5553860"/>
                      </a:xfrm>
                    </p:grpSpPr>
                    <p:grpSp>
                      <p:nvGrpSpPr>
                        <p:cNvPr id="29" name="组合 28"/>
                        <p:cNvGrpSpPr/>
                        <p:nvPr/>
                      </p:nvGrpSpPr>
                      <p:grpSpPr>
                        <a:xfrm>
                          <a:off x="179287" y="-3339102"/>
                          <a:ext cx="7559203" cy="5553860"/>
                          <a:chOff x="543731" y="-3410353"/>
                          <a:chExt cx="7559203" cy="5553860"/>
                        </a:xfrm>
                      </p:grpSpPr>
                      <p:pic>
                        <p:nvPicPr>
                          <p:cNvPr id="31" name="图片 30"/>
                          <p:cNvPicPr>
                            <a:picLocks noChangeAspect="1"/>
                          </p:cNvPicPr>
                          <p:nvPr/>
                        </p:nvPicPr>
                        <p:blipFill>
                          <a:blip r:embed="rId10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tretch>
                            <a:fillRect/>
                          </a:stretch>
                        </p:blipFill>
                        <p:spPr>
                          <a:xfrm>
                            <a:off x="5334515" y="-3400280"/>
                            <a:ext cx="2768419" cy="5543787"/>
                          </a:xfrm>
                          <a:prstGeom prst="rect">
                            <a:avLst/>
                          </a:prstGeom>
                        </p:spPr>
                      </p:pic>
                      <p:pic>
                        <p:nvPicPr>
                          <p:cNvPr id="32" name="图片 31"/>
                          <p:cNvPicPr>
                            <a:picLocks noChangeAspect="1"/>
                          </p:cNvPicPr>
                          <p:nvPr/>
                        </p:nvPicPr>
                        <p:blipFill>
                          <a:blip r:embed="rId11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tretch>
                            <a:fillRect/>
                          </a:stretch>
                        </p:blipFill>
                        <p:spPr>
                          <a:xfrm>
                            <a:off x="543731" y="-3410353"/>
                            <a:ext cx="4206593" cy="5543788"/>
                          </a:xfrm>
                          <a:prstGeom prst="rect">
                            <a:avLst/>
                          </a:prstGeom>
                        </p:spPr>
                      </p:pic>
                    </p:grpSp>
                    <p:pic>
                      <p:nvPicPr>
                        <p:cNvPr id="30" name="图片 29"/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12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tretch>
                          <a:fillRect/>
                        </a:stretch>
                      </p:blipFill>
                      <p:spPr>
                        <a:xfrm>
                          <a:off x="8286277" y="-3329029"/>
                          <a:ext cx="3628789" cy="5543787"/>
                        </a:xfrm>
                        <a:prstGeom prst="rect">
                          <a:avLst/>
                        </a:prstGeom>
                      </p:spPr>
                    </p:pic>
                  </p:grpSp>
                  <p:pic>
                    <p:nvPicPr>
                      <p:cNvPr id="28" name="图片 27"/>
                      <p:cNvPicPr>
                        <a:picLocks noChangeAspect="1"/>
                      </p:cNvPicPr>
                      <p:nvPr/>
                    </p:nvPicPr>
                    <p:blipFill>
                      <a:blip r:embed="rId1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-1065862" y="-3137225"/>
                        <a:ext cx="3236186" cy="5543790"/>
                      </a:xfrm>
                      <a:prstGeom prst="rect">
                        <a:avLst/>
                      </a:prstGeom>
                    </p:spPr>
                  </p:pic>
                </p:grpSp>
                <p:sp>
                  <p:nvSpPr>
                    <p:cNvPr id="23" name="矩形 22"/>
                    <p:cNvSpPr/>
                    <p:nvPr/>
                  </p:nvSpPr>
                  <p:spPr>
                    <a:xfrm>
                      <a:off x="-615400" y="1675797"/>
                      <a:ext cx="3040153" cy="646306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altLang="zh-CN" sz="24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sC2-12 T1-W</a:t>
                      </a:r>
                      <a:endParaRPr lang="zh-CN" altLang="en-US" sz="2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24" name="矩形 23"/>
                    <p:cNvSpPr/>
                    <p:nvPr/>
                  </p:nvSpPr>
                  <p:spPr>
                    <a:xfrm>
                      <a:off x="3873813" y="1717195"/>
                      <a:ext cx="2760717" cy="646306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altLang="zh-CN" sz="2400" b="1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sC2-12 T1-1</a:t>
                      </a:r>
                      <a:endParaRPr lang="zh-CN" altLang="en-US" sz="2400" b="1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25" name="矩形 24"/>
                    <p:cNvSpPr/>
                    <p:nvPr/>
                  </p:nvSpPr>
                  <p:spPr>
                    <a:xfrm>
                      <a:off x="8048753" y="1686140"/>
                      <a:ext cx="2760717" cy="646306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altLang="zh-CN" sz="2400" b="1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sC2-12 T1-2</a:t>
                      </a:r>
                      <a:endParaRPr lang="zh-CN" altLang="en-US" sz="2400" b="1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26" name="矩形 25"/>
                    <p:cNvSpPr/>
                    <p:nvPr/>
                  </p:nvSpPr>
                  <p:spPr>
                    <a:xfrm>
                      <a:off x="11740401" y="1727266"/>
                      <a:ext cx="2760717" cy="646306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altLang="zh-CN" sz="2400" b="1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sC2-12 T1-3</a:t>
                      </a:r>
                      <a:endParaRPr lang="zh-CN" altLang="en-US" sz="2400" b="1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sp>
                <p:nvSpPr>
                  <p:cNvPr id="33" name="矩形 32"/>
                  <p:cNvSpPr/>
                  <p:nvPr/>
                </p:nvSpPr>
                <p:spPr>
                  <a:xfrm>
                    <a:off x="1035970" y="-2149459"/>
                    <a:ext cx="444352" cy="52322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2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  <a:endParaRPr lang="zh-CN" altLang="en-US" sz="2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4" name="矩形 33"/>
                  <p:cNvSpPr/>
                  <p:nvPr/>
                </p:nvSpPr>
                <p:spPr>
                  <a:xfrm>
                    <a:off x="1035970" y="2309909"/>
                    <a:ext cx="423514" cy="52322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2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  <a:endParaRPr lang="zh-CN" altLang="en-US" sz="2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5" name="矩形 34"/>
                  <p:cNvSpPr/>
                  <p:nvPr/>
                </p:nvSpPr>
                <p:spPr>
                  <a:xfrm>
                    <a:off x="1035970" y="7014676"/>
                    <a:ext cx="444352" cy="52322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2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</a:t>
                    </a:r>
                    <a:endParaRPr lang="zh-CN" altLang="en-US" sz="2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38" name="组合 37"/>
                <p:cNvGrpSpPr/>
                <p:nvPr/>
              </p:nvGrpSpPr>
              <p:grpSpPr>
                <a:xfrm>
                  <a:off x="4135748" y="117050"/>
                  <a:ext cx="8952052" cy="4426024"/>
                  <a:chOff x="623407" y="264843"/>
                  <a:chExt cx="8952052" cy="4426024"/>
                </a:xfrm>
              </p:grpSpPr>
              <p:grpSp>
                <p:nvGrpSpPr>
                  <p:cNvPr id="40" name="组合 39"/>
                  <p:cNvGrpSpPr/>
                  <p:nvPr/>
                </p:nvGrpSpPr>
                <p:grpSpPr>
                  <a:xfrm>
                    <a:off x="623407" y="264843"/>
                    <a:ext cx="8952052" cy="3960000"/>
                    <a:chOff x="503092" y="445317"/>
                    <a:chExt cx="8952052" cy="3960000"/>
                  </a:xfrm>
                </p:grpSpPr>
                <p:grpSp>
                  <p:nvGrpSpPr>
                    <p:cNvPr id="45" name="组合 44"/>
                    <p:cNvGrpSpPr/>
                    <p:nvPr/>
                  </p:nvGrpSpPr>
                  <p:grpSpPr>
                    <a:xfrm>
                      <a:off x="503092" y="445317"/>
                      <a:ext cx="6886320" cy="3960000"/>
                      <a:chOff x="387709" y="709854"/>
                      <a:chExt cx="6886320" cy="3960000"/>
                    </a:xfrm>
                  </p:grpSpPr>
                  <p:pic>
                    <p:nvPicPr>
                      <p:cNvPr id="47" name="图片 46"/>
                      <p:cNvPicPr>
                        <a:picLocks noChangeAspect="1"/>
                      </p:cNvPicPr>
                      <p:nvPr/>
                    </p:nvPicPr>
                    <p:blipFill>
                      <a:blip r:embed="rId14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5279817" y="709854"/>
                        <a:ext cx="1994212" cy="3960000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48" name="图片 47"/>
                      <p:cNvPicPr>
                        <a:picLocks noChangeAspect="1"/>
                      </p:cNvPicPr>
                      <p:nvPr/>
                    </p:nvPicPr>
                    <p:blipFill>
                      <a:blip r:embed="rId15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3066369" y="709854"/>
                        <a:ext cx="1675948" cy="3960000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49" name="图片 48"/>
                      <p:cNvPicPr>
                        <a:picLocks noChangeAspect="1"/>
                      </p:cNvPicPr>
                      <p:nvPr/>
                    </p:nvPicPr>
                    <p:blipFill>
                      <a:blip r:embed="rId16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387709" y="709854"/>
                        <a:ext cx="2146360" cy="3960000"/>
                      </a:xfrm>
                      <a:prstGeom prst="rect">
                        <a:avLst/>
                      </a:prstGeom>
                    </p:spPr>
                  </p:pic>
                </p:grpSp>
                <p:pic>
                  <p:nvPicPr>
                    <p:cNvPr id="46" name="图片 45"/>
                    <p:cNvPicPr>
                      <a:picLocks noChangeAspect="1"/>
                    </p:cNvPicPr>
                    <p:nvPr/>
                  </p:nvPicPr>
                  <p:blipFill>
                    <a:blip r:embed="rId17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7979713" y="445317"/>
                      <a:ext cx="1475431" cy="3960000"/>
                    </a:xfrm>
                    <a:prstGeom prst="rect">
                      <a:avLst/>
                    </a:prstGeom>
                  </p:spPr>
                </p:pic>
              </p:grpSp>
              <p:sp>
                <p:nvSpPr>
                  <p:cNvPr id="41" name="矩形 40"/>
                  <p:cNvSpPr/>
                  <p:nvPr/>
                </p:nvSpPr>
                <p:spPr>
                  <a:xfrm>
                    <a:off x="1221066" y="4229202"/>
                    <a:ext cx="1220206" cy="461665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2400" b="1" i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OsC1-2 </a:t>
                    </a:r>
                    <a:endParaRPr lang="zh-CN" altLang="en-US" sz="2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2" name="矩形 41"/>
                  <p:cNvSpPr/>
                  <p:nvPr/>
                </p:nvSpPr>
                <p:spPr>
                  <a:xfrm>
                    <a:off x="3538924" y="4229201"/>
                    <a:ext cx="1220206" cy="461665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2400" b="1" i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OsC1-4 </a:t>
                    </a:r>
                    <a:endParaRPr lang="zh-CN" altLang="en-US" sz="2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3" name="矩形 42"/>
                  <p:cNvSpPr/>
                  <p:nvPr/>
                </p:nvSpPr>
                <p:spPr>
                  <a:xfrm>
                    <a:off x="5949328" y="4227193"/>
                    <a:ext cx="1220206" cy="461665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2400" b="1" i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OsC1-8 </a:t>
                    </a:r>
                    <a:endParaRPr lang="zh-CN" altLang="en-US" sz="2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4" name="矩形 43"/>
                  <p:cNvSpPr/>
                  <p:nvPr/>
                </p:nvSpPr>
                <p:spPr>
                  <a:xfrm>
                    <a:off x="8184923" y="4227192"/>
                    <a:ext cx="1374094" cy="461665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2400" b="1" i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OsC2-12 </a:t>
                    </a:r>
                    <a:endParaRPr lang="zh-CN" altLang="en-US" sz="2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</p:grpSp>
          <p:sp>
            <p:nvSpPr>
              <p:cNvPr id="50" name="矩形 49"/>
              <p:cNvSpPr/>
              <p:nvPr/>
            </p:nvSpPr>
            <p:spPr>
              <a:xfrm>
                <a:off x="3225518" y="14102330"/>
                <a:ext cx="444352" cy="52322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2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  <a:endParaRPr lang="zh-CN" altLang="en-US" sz="2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524585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1202022" y="482245"/>
            <a:ext cx="18103252" cy="22854221"/>
            <a:chOff x="1006078" y="536955"/>
            <a:chExt cx="18103252" cy="22854221"/>
          </a:xfrm>
        </p:grpSpPr>
        <p:sp>
          <p:nvSpPr>
            <p:cNvPr id="98" name="文本框 97"/>
            <p:cNvSpPr txBox="1"/>
            <p:nvPr/>
          </p:nvSpPr>
          <p:spPr>
            <a:xfrm>
              <a:off x="1006079" y="10412901"/>
              <a:ext cx="41643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800" b="1" dirty="0" smtClean="0">
                  <a:latin typeface="Times New Roman" panose="02020603050405020304" pitchFamily="18" charset="0"/>
                </a:rPr>
                <a:t>C</a:t>
              </a:r>
              <a:endParaRPr lang="zh-CN" altLang="en-US" sz="2800" b="1" dirty="0">
                <a:latin typeface="Times New Roman" panose="02020603050405020304" pitchFamily="18" charset="0"/>
              </a:endParaRPr>
            </a:p>
          </p:txBody>
        </p:sp>
        <p:sp>
          <p:nvSpPr>
            <p:cNvPr id="99" name="文本框 98"/>
            <p:cNvSpPr txBox="1"/>
            <p:nvPr/>
          </p:nvSpPr>
          <p:spPr>
            <a:xfrm>
              <a:off x="1006078" y="14053009"/>
              <a:ext cx="41643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800" b="1" dirty="0" smtClean="0">
                  <a:latin typeface="Times New Roman" panose="02020603050405020304" pitchFamily="18" charset="0"/>
                </a:rPr>
                <a:t>D</a:t>
              </a:r>
              <a:endParaRPr lang="zh-CN" altLang="en-US" sz="2800" b="1" dirty="0">
                <a:latin typeface="Times New Roman" panose="02020603050405020304" pitchFamily="18" charset="0"/>
              </a:endParaRPr>
            </a:p>
          </p:txBody>
        </p:sp>
        <p:grpSp>
          <p:nvGrpSpPr>
            <p:cNvPr id="100" name="组合 99"/>
            <p:cNvGrpSpPr/>
            <p:nvPr/>
          </p:nvGrpSpPr>
          <p:grpSpPr>
            <a:xfrm>
              <a:off x="1637922" y="10412901"/>
              <a:ext cx="16931387" cy="2930533"/>
              <a:chOff x="2956938" y="7446994"/>
              <a:chExt cx="16931387" cy="2930533"/>
            </a:xfrm>
          </p:grpSpPr>
          <p:grpSp>
            <p:nvGrpSpPr>
              <p:cNvPr id="142" name="组合 141"/>
              <p:cNvGrpSpPr/>
              <p:nvPr/>
            </p:nvGrpSpPr>
            <p:grpSpPr>
              <a:xfrm>
                <a:off x="2956938" y="7446994"/>
                <a:ext cx="16931387" cy="2930533"/>
                <a:chOff x="-122947" y="425636"/>
                <a:chExt cx="16931387" cy="2930533"/>
              </a:xfrm>
            </p:grpSpPr>
            <p:grpSp>
              <p:nvGrpSpPr>
                <p:cNvPr id="144" name="组合 143"/>
                <p:cNvGrpSpPr/>
                <p:nvPr/>
              </p:nvGrpSpPr>
              <p:grpSpPr>
                <a:xfrm>
                  <a:off x="-122947" y="425636"/>
                  <a:ext cx="16931387" cy="2930533"/>
                  <a:chOff x="-122947" y="425636"/>
                  <a:chExt cx="16931387" cy="2930533"/>
                </a:xfrm>
              </p:grpSpPr>
              <p:grpSp>
                <p:nvGrpSpPr>
                  <p:cNvPr id="147" name="组合 146"/>
                  <p:cNvGrpSpPr/>
                  <p:nvPr/>
                </p:nvGrpSpPr>
                <p:grpSpPr>
                  <a:xfrm>
                    <a:off x="-122947" y="425636"/>
                    <a:ext cx="16931387" cy="2473788"/>
                    <a:chOff x="-39820" y="556264"/>
                    <a:chExt cx="16931387" cy="2473788"/>
                  </a:xfrm>
                </p:grpSpPr>
                <p:pic>
                  <p:nvPicPr>
                    <p:cNvPr id="150" name="图片 149"/>
                    <p:cNvPicPr>
                      <a:picLocks noChangeAspect="1"/>
                    </p:cNvPicPr>
                    <p:nvPr/>
                  </p:nvPicPr>
                  <p:blipFill>
                    <a:blip r:embed="rId3"/>
                    <a:stretch>
                      <a:fillRect/>
                    </a:stretch>
                  </p:blipFill>
                  <p:spPr>
                    <a:xfrm>
                      <a:off x="6051781" y="863384"/>
                      <a:ext cx="5028571" cy="2161905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51" name="图片 150"/>
                    <p:cNvPicPr>
                      <a:picLocks noChangeAspect="1"/>
                    </p:cNvPicPr>
                    <p:nvPr/>
                  </p:nvPicPr>
                  <p:blipFill>
                    <a:blip r:embed="rId4"/>
                    <a:stretch>
                      <a:fillRect/>
                    </a:stretch>
                  </p:blipFill>
                  <p:spPr>
                    <a:xfrm>
                      <a:off x="409858" y="858623"/>
                      <a:ext cx="5304762" cy="2171429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152" name="文本框 151"/>
                    <p:cNvSpPr txBox="1"/>
                    <p:nvPr/>
                  </p:nvSpPr>
                  <p:spPr>
                    <a:xfrm>
                      <a:off x="1113603" y="556264"/>
                      <a:ext cx="4760217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6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 G C  C  C   A  A G  A  T  T C  C  A  A  A  C  A T  T</a:t>
                      </a:r>
                      <a:endParaRPr lang="zh-CN" altLang="en-US" sz="1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53" name="矩形 152"/>
                    <p:cNvSpPr/>
                    <p:nvPr/>
                  </p:nvSpPr>
                  <p:spPr>
                    <a:xfrm>
                      <a:off x="443609" y="837234"/>
                      <a:ext cx="703746" cy="2160000"/>
                    </a:xfrm>
                    <a:prstGeom prst="rect">
                      <a:avLst/>
                    </a:prstGeom>
                    <a:solidFill>
                      <a:srgbClr val="ED7D31">
                        <a:alpha val="18824"/>
                      </a:srgb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/>
                    </a:p>
                  </p:txBody>
                </p:sp>
                <p:cxnSp>
                  <p:nvCxnSpPr>
                    <p:cNvPr id="154" name="直接连接符 153"/>
                    <p:cNvCxnSpPr/>
                    <p:nvPr/>
                  </p:nvCxnSpPr>
                  <p:spPr>
                    <a:xfrm>
                      <a:off x="1181106" y="1102073"/>
                      <a:ext cx="4533515" cy="0"/>
                    </a:xfrm>
                    <a:prstGeom prst="line">
                      <a:avLst/>
                    </a:prstGeom>
                    <a:ln w="285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55" name="矩形 154"/>
                    <p:cNvSpPr/>
                    <p:nvPr/>
                  </p:nvSpPr>
                  <p:spPr>
                    <a:xfrm>
                      <a:off x="-25451" y="865361"/>
                      <a:ext cx="646331" cy="307777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zh-CN" altLang="en-US" sz="14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lang="en-US" altLang="zh-CN" sz="14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zh-CN" altLang="en-US" sz="14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）</a:t>
                      </a:r>
                    </a:p>
                  </p:txBody>
                </p:sp>
                <p:sp>
                  <p:nvSpPr>
                    <p:cNvPr id="156" name="矩形 155"/>
                    <p:cNvSpPr/>
                    <p:nvPr/>
                  </p:nvSpPr>
                  <p:spPr>
                    <a:xfrm>
                      <a:off x="-39820" y="584993"/>
                      <a:ext cx="603050" cy="307777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algn="ctr"/>
                      <a:r>
                        <a:rPr lang="zh-CN" altLang="en-US" sz="14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lang="en-US" altLang="zh-CN" sz="14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zh-CN" altLang="en-US" sz="14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）</a:t>
                      </a:r>
                    </a:p>
                  </p:txBody>
                </p:sp>
                <p:sp>
                  <p:nvSpPr>
                    <p:cNvPr id="157" name="文本框 156"/>
                    <p:cNvSpPr txBox="1"/>
                    <p:nvPr/>
                  </p:nvSpPr>
                  <p:spPr>
                    <a:xfrm>
                      <a:off x="442098" y="1238882"/>
                      <a:ext cx="957707" cy="4001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2000" b="1" dirty="0">
                          <a:latin typeface="Times New Roman" panose="02020603050405020304" pitchFamily="18" charset="0"/>
                        </a:rPr>
                        <a:t>PAM</a:t>
                      </a:r>
                      <a:endParaRPr lang="zh-CN" altLang="en-US" sz="2000" b="1" dirty="0">
                        <a:latin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58" name="文本框 157"/>
                    <p:cNvSpPr txBox="1"/>
                    <p:nvPr/>
                  </p:nvSpPr>
                  <p:spPr>
                    <a:xfrm>
                      <a:off x="7975240" y="1238882"/>
                      <a:ext cx="1998945" cy="46166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2400" b="1" dirty="0">
                          <a:latin typeface="Times New Roman" panose="02020603050405020304" pitchFamily="18" charset="0"/>
                        </a:rPr>
                        <a:t>G deletion</a:t>
                      </a:r>
                      <a:endParaRPr lang="zh-CN" altLang="en-US" sz="2400" b="1" dirty="0">
                        <a:latin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59" name="矩形 158"/>
                    <p:cNvSpPr/>
                    <p:nvPr/>
                  </p:nvSpPr>
                  <p:spPr>
                    <a:xfrm>
                      <a:off x="7208323" y="839290"/>
                      <a:ext cx="83126" cy="2157944"/>
                    </a:xfrm>
                    <a:prstGeom prst="rect">
                      <a:avLst/>
                    </a:prstGeom>
                    <a:solidFill>
                      <a:srgbClr val="FFFF00">
                        <a:alpha val="30980"/>
                      </a:srgb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/>
                    </a:p>
                  </p:txBody>
                </p:sp>
                <p:pic>
                  <p:nvPicPr>
                    <p:cNvPr id="160" name="图片 159"/>
                    <p:cNvPicPr>
                      <a:picLocks noChangeAspect="1"/>
                    </p:cNvPicPr>
                    <p:nvPr/>
                  </p:nvPicPr>
                  <p:blipFill>
                    <a:blip r:embed="rId5"/>
                    <a:stretch>
                      <a:fillRect/>
                    </a:stretch>
                  </p:blipFill>
                  <p:spPr>
                    <a:xfrm>
                      <a:off x="11358234" y="865361"/>
                      <a:ext cx="5533333" cy="2161905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161" name="矩形 160"/>
                    <p:cNvSpPr/>
                    <p:nvPr/>
                  </p:nvSpPr>
                  <p:spPr>
                    <a:xfrm>
                      <a:off x="12808532" y="784814"/>
                      <a:ext cx="233938" cy="2240318"/>
                    </a:xfrm>
                    <a:prstGeom prst="rect">
                      <a:avLst/>
                    </a:prstGeom>
                    <a:solidFill>
                      <a:srgbClr val="FF0000">
                        <a:alpha val="18824"/>
                      </a:srgb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/>
                    </a:p>
                  </p:txBody>
                </p:sp>
                <p:sp>
                  <p:nvSpPr>
                    <p:cNvPr id="162" name="文本框 161"/>
                    <p:cNvSpPr txBox="1"/>
                    <p:nvPr/>
                  </p:nvSpPr>
                  <p:spPr>
                    <a:xfrm>
                      <a:off x="13591948" y="1158794"/>
                      <a:ext cx="3064611" cy="46166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2400" b="1" dirty="0" smtClean="0">
                          <a:latin typeface="Times New Roman" panose="02020603050405020304" pitchFamily="18" charset="0"/>
                        </a:rPr>
                        <a:t>A / T </a:t>
                      </a:r>
                      <a:r>
                        <a:rPr lang="en-US" altLang="zh-CN" sz="2400" b="1" dirty="0">
                          <a:latin typeface="Times New Roman" panose="02020603050405020304" pitchFamily="18" charset="0"/>
                        </a:rPr>
                        <a:t>insertion</a:t>
                      </a:r>
                      <a:endParaRPr lang="zh-CN" altLang="en-US" sz="2400" b="1" dirty="0">
                        <a:latin typeface="Times New Roman" panose="02020603050405020304" pitchFamily="18" charset="0"/>
                      </a:endParaRPr>
                    </a:p>
                  </p:txBody>
                </p:sp>
              </p:grpSp>
              <p:sp>
                <p:nvSpPr>
                  <p:cNvPr id="148" name="文本框 147"/>
                  <p:cNvSpPr txBox="1"/>
                  <p:nvPr/>
                </p:nvSpPr>
                <p:spPr>
                  <a:xfrm>
                    <a:off x="7905499" y="2881199"/>
                    <a:ext cx="1838765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2400" b="1" i="1" dirty="0">
                        <a:latin typeface="Times New Roman" panose="02020603050405020304" pitchFamily="18" charset="0"/>
                      </a:rPr>
                      <a:t>OsC1-4</a:t>
                    </a:r>
                    <a:endParaRPr lang="zh-CN" altLang="en-US" sz="2400" b="1" i="1" dirty="0">
                      <a:latin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49" name="文本框 148"/>
                  <p:cNvSpPr txBox="1"/>
                  <p:nvPr/>
                </p:nvSpPr>
                <p:spPr>
                  <a:xfrm>
                    <a:off x="13016511" y="2894504"/>
                    <a:ext cx="2540305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2400" b="1" i="1" dirty="0">
                        <a:latin typeface="Times New Roman" panose="02020603050405020304" pitchFamily="18" charset="0"/>
                      </a:rPr>
                      <a:t>OsC1-4 </a:t>
                    </a:r>
                    <a:r>
                      <a:rPr lang="en-US" altLang="zh-CN" sz="2400" b="1" i="1" dirty="0" smtClean="0">
                        <a:latin typeface="Times New Roman" panose="02020603050405020304" pitchFamily="18" charset="0"/>
                      </a:rPr>
                      <a:t>T1-1, 2, 3</a:t>
                    </a:r>
                    <a:endParaRPr lang="zh-CN" altLang="en-US" sz="2400" b="1" i="1" dirty="0">
                      <a:latin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145" name="矩形 144"/>
                <p:cNvSpPr/>
                <p:nvPr/>
              </p:nvSpPr>
              <p:spPr>
                <a:xfrm>
                  <a:off x="5556713" y="729201"/>
                  <a:ext cx="646331" cy="30777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zh-CN" altLang="en-US" sz="1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（</a:t>
                  </a:r>
                  <a:r>
                    <a:rPr lang="en-US" altLang="zh-CN" sz="1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</a:t>
                  </a:r>
                  <a:r>
                    <a:rPr lang="zh-CN" altLang="en-US" sz="1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）</a:t>
                  </a:r>
                </a:p>
              </p:txBody>
            </p:sp>
            <p:sp>
              <p:nvSpPr>
                <p:cNvPr id="146" name="矩形 145"/>
                <p:cNvSpPr/>
                <p:nvPr/>
              </p:nvSpPr>
              <p:spPr>
                <a:xfrm>
                  <a:off x="10856262" y="732837"/>
                  <a:ext cx="646331" cy="30777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zh-CN" altLang="en-US" sz="1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（</a:t>
                  </a:r>
                  <a:r>
                    <a:rPr lang="en-US" altLang="zh-CN" sz="1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</a:t>
                  </a:r>
                  <a:r>
                    <a:rPr lang="zh-CN" altLang="en-US" sz="1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）</a:t>
                  </a:r>
                </a:p>
              </p:txBody>
            </p:sp>
          </p:grpSp>
          <p:sp>
            <p:nvSpPr>
              <p:cNvPr id="143" name="矩形 142"/>
              <p:cNvSpPr/>
              <p:nvPr/>
            </p:nvSpPr>
            <p:spPr>
              <a:xfrm>
                <a:off x="5251657" y="9913471"/>
                <a:ext cx="2017732" cy="46166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2400" b="1" dirty="0">
                    <a:latin typeface="Times New Roman" panose="02020603050405020304" pitchFamily="18" charset="0"/>
                  </a:rPr>
                  <a:t>OsC1-4 T1-W</a:t>
                </a:r>
                <a:endParaRPr lang="zh-CN" altLang="en-US" sz="2400" b="1" dirty="0">
                  <a:latin typeface="Times New Roman" panose="02020603050405020304" pitchFamily="18" charset="0"/>
                </a:endParaRPr>
              </a:p>
            </p:txBody>
          </p:sp>
        </p:grpSp>
        <p:grpSp>
          <p:nvGrpSpPr>
            <p:cNvPr id="87" name="组合 86"/>
            <p:cNvGrpSpPr/>
            <p:nvPr/>
          </p:nvGrpSpPr>
          <p:grpSpPr>
            <a:xfrm>
              <a:off x="2874782" y="536955"/>
              <a:ext cx="14025943" cy="5861251"/>
              <a:chOff x="2874782" y="536955"/>
              <a:chExt cx="14025943" cy="5861251"/>
            </a:xfrm>
          </p:grpSpPr>
          <p:sp>
            <p:nvSpPr>
              <p:cNvPr id="97" name="文本框 96"/>
              <p:cNvSpPr txBox="1"/>
              <p:nvPr/>
            </p:nvSpPr>
            <p:spPr>
              <a:xfrm>
                <a:off x="2874782" y="557366"/>
                <a:ext cx="416439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800" b="1" dirty="0">
                    <a:latin typeface="Times New Roman" panose="02020603050405020304" pitchFamily="18" charset="0"/>
                  </a:rPr>
                  <a:t>A</a:t>
                </a:r>
                <a:endParaRPr lang="zh-CN" altLang="en-US" sz="2800" b="1" dirty="0">
                  <a:latin typeface="Times New Roman" panose="02020603050405020304" pitchFamily="18" charset="0"/>
                </a:endParaRPr>
              </a:p>
            </p:txBody>
          </p:sp>
          <p:grpSp>
            <p:nvGrpSpPr>
              <p:cNvPr id="101" name="组合 100"/>
              <p:cNvGrpSpPr/>
              <p:nvPr/>
            </p:nvGrpSpPr>
            <p:grpSpPr>
              <a:xfrm>
                <a:off x="3635287" y="536955"/>
                <a:ext cx="13265438" cy="5861251"/>
                <a:chOff x="3939871" y="282592"/>
                <a:chExt cx="13265438" cy="5861251"/>
              </a:xfrm>
            </p:grpSpPr>
            <p:grpSp>
              <p:nvGrpSpPr>
                <p:cNvPr id="115" name="组合 114"/>
                <p:cNvGrpSpPr/>
                <p:nvPr/>
              </p:nvGrpSpPr>
              <p:grpSpPr>
                <a:xfrm>
                  <a:off x="3939871" y="282592"/>
                  <a:ext cx="13265438" cy="5861251"/>
                  <a:chOff x="-101881" y="292181"/>
                  <a:chExt cx="13265438" cy="5861251"/>
                </a:xfrm>
              </p:grpSpPr>
              <p:grpSp>
                <p:nvGrpSpPr>
                  <p:cNvPr id="117" name="组合 116"/>
                  <p:cNvGrpSpPr/>
                  <p:nvPr/>
                </p:nvGrpSpPr>
                <p:grpSpPr>
                  <a:xfrm>
                    <a:off x="-101881" y="292181"/>
                    <a:ext cx="13265438" cy="5861251"/>
                    <a:chOff x="-78130" y="529688"/>
                    <a:chExt cx="13265438" cy="5861251"/>
                  </a:xfrm>
                </p:grpSpPr>
                <p:grpSp>
                  <p:nvGrpSpPr>
                    <p:cNvPr id="121" name="组合 120"/>
                    <p:cNvGrpSpPr/>
                    <p:nvPr/>
                  </p:nvGrpSpPr>
                  <p:grpSpPr>
                    <a:xfrm>
                      <a:off x="-78130" y="529688"/>
                      <a:ext cx="13265438" cy="5398025"/>
                      <a:chOff x="-244384" y="802820"/>
                      <a:chExt cx="13265438" cy="5398025"/>
                    </a:xfrm>
                  </p:grpSpPr>
                  <p:grpSp>
                    <p:nvGrpSpPr>
                      <p:cNvPr id="125" name="组合 124"/>
                      <p:cNvGrpSpPr/>
                      <p:nvPr/>
                    </p:nvGrpSpPr>
                    <p:grpSpPr>
                      <a:xfrm>
                        <a:off x="-244384" y="802820"/>
                        <a:ext cx="11856636" cy="5398025"/>
                        <a:chOff x="-90004" y="-669721"/>
                        <a:chExt cx="11856636" cy="5398025"/>
                      </a:xfrm>
                    </p:grpSpPr>
                    <p:pic>
                      <p:nvPicPr>
                        <p:cNvPr id="129" name="图片 128"/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421735" y="-299221"/>
                          <a:ext cx="5304762" cy="2171429"/>
                        </a:xfrm>
                        <a:prstGeom prst="rect">
                          <a:avLst/>
                        </a:prstGeom>
                      </p:spPr>
                    </p:pic>
                    <p:sp>
                      <p:nvSpPr>
                        <p:cNvPr id="130" name="矩形 129"/>
                        <p:cNvSpPr/>
                        <p:nvPr/>
                      </p:nvSpPr>
                      <p:spPr>
                        <a:xfrm>
                          <a:off x="422829" y="-385924"/>
                          <a:ext cx="703746" cy="2232000"/>
                        </a:xfrm>
                        <a:prstGeom prst="rect">
                          <a:avLst/>
                        </a:prstGeom>
                        <a:solidFill>
                          <a:srgbClr val="ED7D31">
                            <a:alpha val="18824"/>
                          </a:srgbClr>
                        </a:solidFill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zh-CN" altLang="en-US"/>
                        </a:p>
                      </p:txBody>
                    </p:sp>
                    <p:pic>
                      <p:nvPicPr>
                        <p:cNvPr id="131" name="图片 130"/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6223775" y="2546902"/>
                          <a:ext cx="5542857" cy="2171429"/>
                        </a:xfrm>
                        <a:prstGeom prst="rect">
                          <a:avLst/>
                        </a:prstGeom>
                      </p:spPr>
                    </p:pic>
                    <p:sp>
                      <p:nvSpPr>
                        <p:cNvPr id="132" name="矩形 131"/>
                        <p:cNvSpPr/>
                        <p:nvPr/>
                      </p:nvSpPr>
                      <p:spPr>
                        <a:xfrm>
                          <a:off x="7669846" y="2478909"/>
                          <a:ext cx="233938" cy="2240318"/>
                        </a:xfrm>
                        <a:prstGeom prst="rect">
                          <a:avLst/>
                        </a:prstGeom>
                        <a:solidFill>
                          <a:srgbClr val="FF0000">
                            <a:alpha val="18824"/>
                          </a:srgbClr>
                        </a:solidFill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zh-CN" altLang="en-US"/>
                        </a:p>
                      </p:txBody>
                    </p:sp>
                    <p:sp>
                      <p:nvSpPr>
                        <p:cNvPr id="133" name="文本框 132"/>
                        <p:cNvSpPr txBox="1"/>
                        <p:nvPr/>
                      </p:nvSpPr>
                      <p:spPr>
                        <a:xfrm>
                          <a:off x="8355037" y="2840119"/>
                          <a:ext cx="3181534" cy="461665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altLang="zh-CN" sz="2400" b="1" dirty="0" smtClean="0">
                              <a:latin typeface="Times New Roman" panose="02020603050405020304" pitchFamily="18" charset="0"/>
                            </a:rPr>
                            <a:t>C / T </a:t>
                          </a:r>
                          <a:r>
                            <a:rPr lang="en-US" altLang="zh-CN" sz="2400" b="1" dirty="0">
                              <a:latin typeface="Times New Roman" panose="02020603050405020304" pitchFamily="18" charset="0"/>
                            </a:rPr>
                            <a:t>insertion</a:t>
                          </a:r>
                          <a:endParaRPr lang="zh-CN" altLang="en-US" sz="2400" b="1" dirty="0">
                            <a:latin typeface="Times New Roman" panose="02020603050405020304" pitchFamily="18" charset="0"/>
                          </a:endParaRPr>
                        </a:p>
                      </p:txBody>
                    </p:sp>
                    <p:pic>
                      <p:nvPicPr>
                        <p:cNvPr id="134" name="图片 133"/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421735" y="2546902"/>
                          <a:ext cx="5523809" cy="2171429"/>
                        </a:xfrm>
                        <a:prstGeom prst="rect">
                          <a:avLst/>
                        </a:prstGeom>
                      </p:spPr>
                    </p:pic>
                    <p:sp>
                      <p:nvSpPr>
                        <p:cNvPr id="135" name="矩形 134"/>
                        <p:cNvSpPr/>
                        <p:nvPr/>
                      </p:nvSpPr>
                      <p:spPr>
                        <a:xfrm>
                          <a:off x="1844881" y="2487986"/>
                          <a:ext cx="233938" cy="2240318"/>
                        </a:xfrm>
                        <a:prstGeom prst="rect">
                          <a:avLst/>
                        </a:prstGeom>
                        <a:solidFill>
                          <a:srgbClr val="FF0000">
                            <a:alpha val="18824"/>
                          </a:srgbClr>
                        </a:solidFill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zh-CN" altLang="en-US"/>
                        </a:p>
                      </p:txBody>
                    </p:sp>
                    <p:sp>
                      <p:nvSpPr>
                        <p:cNvPr id="136" name="文本框 135"/>
                        <p:cNvSpPr txBox="1"/>
                        <p:nvPr/>
                      </p:nvSpPr>
                      <p:spPr>
                        <a:xfrm>
                          <a:off x="2519774" y="2840119"/>
                          <a:ext cx="2860665" cy="461665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altLang="zh-CN" sz="2400" b="1" dirty="0" smtClean="0">
                              <a:latin typeface="Times New Roman" panose="02020603050405020304" pitchFamily="18" charset="0"/>
                            </a:rPr>
                            <a:t>A / T </a:t>
                          </a:r>
                          <a:r>
                            <a:rPr lang="en-US" altLang="zh-CN" sz="2400" b="1" dirty="0">
                              <a:latin typeface="Times New Roman" panose="02020603050405020304" pitchFamily="18" charset="0"/>
                            </a:rPr>
                            <a:t>insertion</a:t>
                          </a:r>
                          <a:endParaRPr lang="zh-CN" altLang="en-US" sz="2400" b="1" dirty="0">
                            <a:latin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137" name="文本框 136"/>
                        <p:cNvSpPr txBox="1"/>
                        <p:nvPr/>
                      </p:nvSpPr>
                      <p:spPr>
                        <a:xfrm>
                          <a:off x="422979" y="-49064"/>
                          <a:ext cx="935261" cy="40011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altLang="zh-CN" sz="2000" b="1" dirty="0">
                              <a:latin typeface="Times New Roman" panose="02020603050405020304" pitchFamily="18" charset="0"/>
                            </a:rPr>
                            <a:t>PAM</a:t>
                          </a:r>
                          <a:endParaRPr lang="zh-CN" altLang="en-US" sz="2000" b="1" dirty="0">
                            <a:latin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138" name="文本框 137"/>
                        <p:cNvSpPr txBox="1"/>
                        <p:nvPr/>
                      </p:nvSpPr>
                      <p:spPr>
                        <a:xfrm>
                          <a:off x="1122823" y="-667443"/>
                          <a:ext cx="4760217" cy="33855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altLang="zh-CN" sz="1600" b="1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C G C  C  C   A  A G  A  T  T C  C  A  A  A  C  A T  T</a:t>
                          </a:r>
                          <a:endParaRPr lang="zh-CN" altLang="en-US" sz="16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p:txBody>
                    </p:sp>
                    <p:cxnSp>
                      <p:nvCxnSpPr>
                        <p:cNvPr id="139" name="直接连接符 138"/>
                        <p:cNvCxnSpPr/>
                        <p:nvPr/>
                      </p:nvCxnSpPr>
                      <p:spPr>
                        <a:xfrm>
                          <a:off x="1192983" y="140171"/>
                          <a:ext cx="4533515" cy="0"/>
                        </a:xfrm>
                        <a:prstGeom prst="line">
                          <a:avLst/>
                        </a:prstGeom>
                        <a:ln w="28575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140" name="矩形 139"/>
                        <p:cNvSpPr/>
                        <p:nvPr/>
                      </p:nvSpPr>
                      <p:spPr>
                        <a:xfrm>
                          <a:off x="-60349" y="-366398"/>
                          <a:ext cx="646331" cy="307777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r>
                            <a:rPr lang="zh-CN" altLang="en-US" sz="1400" b="1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（</a:t>
                          </a:r>
                          <a:r>
                            <a:rPr lang="en-US" altLang="zh-CN" sz="1400" b="1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+</a:t>
                          </a:r>
                          <a:r>
                            <a:rPr lang="zh-CN" altLang="en-US" sz="1400" b="1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）</a:t>
                          </a:r>
                        </a:p>
                      </p:txBody>
                    </p:sp>
                    <p:sp>
                      <p:nvSpPr>
                        <p:cNvPr id="141" name="矩形 140"/>
                        <p:cNvSpPr/>
                        <p:nvPr/>
                      </p:nvSpPr>
                      <p:spPr>
                        <a:xfrm>
                          <a:off x="-90004" y="-669721"/>
                          <a:ext cx="603050" cy="307777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algn="ctr"/>
                          <a:r>
                            <a:rPr lang="zh-CN" altLang="en-US" sz="1400" b="1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（</a:t>
                          </a:r>
                          <a:r>
                            <a:rPr lang="en-US" altLang="zh-CN" sz="1400" b="1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</a:t>
                          </a:r>
                          <a:r>
                            <a:rPr lang="zh-CN" altLang="en-US" sz="1400" b="1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）</a:t>
                          </a:r>
                        </a:p>
                      </p:txBody>
                    </p:sp>
                  </p:grpSp>
                  <p:pic>
                    <p:nvPicPr>
                      <p:cNvPr id="126" name="图片 125"/>
                      <p:cNvPicPr>
                        <a:picLocks noChangeAspect="1"/>
                      </p:cNvPicPr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885820" y="1176858"/>
                        <a:ext cx="3885714" cy="2142857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127" name="文本框 126"/>
                      <p:cNvSpPr txBox="1"/>
                      <p:nvPr/>
                    </p:nvSpPr>
                    <p:spPr>
                      <a:xfrm>
                        <a:off x="9436794" y="1431875"/>
                        <a:ext cx="3584260" cy="46166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altLang="zh-CN" sz="2400" b="1" dirty="0">
                            <a:latin typeface="Times New Roman" panose="02020603050405020304" pitchFamily="18" charset="0"/>
                          </a:rPr>
                          <a:t>GGGTTC deletion</a:t>
                        </a:r>
                        <a:endParaRPr lang="zh-CN" altLang="en-US" sz="2400" b="1" dirty="0">
                          <a:latin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128" name="矩形 127"/>
                      <p:cNvSpPr/>
                      <p:nvPr/>
                    </p:nvSpPr>
                    <p:spPr>
                      <a:xfrm>
                        <a:off x="8048497" y="1127731"/>
                        <a:ext cx="71253" cy="2240318"/>
                      </a:xfrm>
                      <a:prstGeom prst="rect">
                        <a:avLst/>
                      </a:prstGeom>
                      <a:solidFill>
                        <a:srgbClr val="FFFF00">
                          <a:alpha val="30980"/>
                        </a:srgbClr>
                      </a:solidFill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zh-CN" altLang="en-US"/>
                      </a:p>
                    </p:txBody>
                  </p:sp>
                </p:grpSp>
                <p:sp>
                  <p:nvSpPr>
                    <p:cNvPr id="122" name="文本框 121"/>
                    <p:cNvSpPr txBox="1"/>
                    <p:nvPr/>
                  </p:nvSpPr>
                  <p:spPr>
                    <a:xfrm>
                      <a:off x="8105026" y="3091951"/>
                      <a:ext cx="1608580" cy="46166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2400" b="1" i="1" dirty="0">
                          <a:latin typeface="Times New Roman" panose="02020603050405020304" pitchFamily="18" charset="0"/>
                        </a:rPr>
                        <a:t>OsC1-8</a:t>
                      </a:r>
                      <a:endParaRPr lang="zh-CN" altLang="en-US" sz="2400" b="1" i="1" dirty="0">
                        <a:latin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23" name="文本框 122"/>
                    <p:cNvSpPr txBox="1"/>
                    <p:nvPr/>
                  </p:nvSpPr>
                  <p:spPr>
                    <a:xfrm>
                      <a:off x="2271055" y="5929274"/>
                      <a:ext cx="2404671" cy="46166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2400" b="1" i="1" dirty="0">
                          <a:latin typeface="Times New Roman" panose="02020603050405020304" pitchFamily="18" charset="0"/>
                        </a:rPr>
                        <a:t>OsC1-8</a:t>
                      </a:r>
                      <a:r>
                        <a:rPr lang="en-US" altLang="zh-CN" sz="1400" b="1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zh-CN" sz="2400" b="1" i="1" dirty="0">
                          <a:latin typeface="Times New Roman" panose="02020603050405020304" pitchFamily="18" charset="0"/>
                        </a:rPr>
                        <a:t>T2-1</a:t>
                      </a:r>
                      <a:endParaRPr lang="zh-CN" altLang="en-US" sz="2400" b="1" i="1" dirty="0">
                        <a:latin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24" name="文本框 123"/>
                    <p:cNvSpPr txBox="1"/>
                    <p:nvPr/>
                  </p:nvSpPr>
                  <p:spPr>
                    <a:xfrm>
                      <a:off x="8366911" y="5904056"/>
                      <a:ext cx="2594295" cy="46166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2400" b="1" i="1" dirty="0">
                          <a:latin typeface="Times New Roman" panose="02020603050405020304" pitchFamily="18" charset="0"/>
                        </a:rPr>
                        <a:t>OsC1-8</a:t>
                      </a:r>
                      <a:r>
                        <a:rPr lang="en-US" altLang="zh-CN" sz="1400" b="1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zh-CN" sz="2400" b="1" i="1" dirty="0">
                          <a:latin typeface="Times New Roman" panose="02020603050405020304" pitchFamily="18" charset="0"/>
                        </a:rPr>
                        <a:t>T2-2</a:t>
                      </a:r>
                      <a:endParaRPr lang="zh-CN" altLang="en-US" sz="2400" b="1" i="1" dirty="0">
                        <a:latin typeface="Times New Roman" panose="02020603050405020304" pitchFamily="18" charset="0"/>
                      </a:endParaRPr>
                    </a:p>
                  </p:txBody>
                </p:sp>
              </p:grpSp>
              <p:sp>
                <p:nvSpPr>
                  <p:cNvPr id="118" name="矩形 117"/>
                  <p:cNvSpPr/>
                  <p:nvPr/>
                </p:nvSpPr>
                <p:spPr>
                  <a:xfrm>
                    <a:off x="6505441" y="665323"/>
                    <a:ext cx="646331" cy="307777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zh-CN" altLang="en-US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（</a:t>
                    </a:r>
                    <a:r>
                      <a:rPr lang="en-US" altLang="zh-CN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+</a:t>
                    </a:r>
                    <a:r>
                      <a:rPr lang="zh-CN" altLang="en-US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）</a:t>
                    </a:r>
                  </a:p>
                </p:txBody>
              </p:sp>
              <p:sp>
                <p:nvSpPr>
                  <p:cNvPr id="119" name="矩形 118"/>
                  <p:cNvSpPr/>
                  <p:nvPr/>
                </p:nvSpPr>
                <p:spPr>
                  <a:xfrm>
                    <a:off x="-68957" y="3492365"/>
                    <a:ext cx="646331" cy="307777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zh-CN" altLang="en-US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（</a:t>
                    </a:r>
                    <a:r>
                      <a:rPr lang="en-US" altLang="zh-CN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+</a:t>
                    </a:r>
                    <a:r>
                      <a:rPr lang="zh-CN" altLang="en-US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）</a:t>
                    </a:r>
                  </a:p>
                </p:txBody>
              </p:sp>
              <p:sp>
                <p:nvSpPr>
                  <p:cNvPr id="120" name="矩形 119"/>
                  <p:cNvSpPr/>
                  <p:nvPr/>
                </p:nvSpPr>
                <p:spPr>
                  <a:xfrm>
                    <a:off x="5787159" y="3527935"/>
                    <a:ext cx="646331" cy="307777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zh-CN" altLang="en-US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（</a:t>
                    </a:r>
                    <a:r>
                      <a:rPr lang="en-US" altLang="zh-CN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+</a:t>
                    </a:r>
                    <a:r>
                      <a:rPr lang="zh-CN" altLang="en-US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）</a:t>
                    </a:r>
                  </a:p>
                </p:txBody>
              </p:sp>
            </p:grpSp>
            <p:sp>
              <p:nvSpPr>
                <p:cNvPr id="116" name="矩形 115"/>
                <p:cNvSpPr/>
                <p:nvPr/>
              </p:nvSpPr>
              <p:spPr>
                <a:xfrm>
                  <a:off x="6542180" y="2759517"/>
                  <a:ext cx="1991251" cy="461665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2400" b="1" dirty="0" smtClean="0">
                      <a:latin typeface="Times New Roman" panose="02020603050405020304" pitchFamily="18" charset="0"/>
                    </a:rPr>
                    <a:t>OsC1-8</a:t>
                  </a:r>
                  <a:r>
                    <a:rPr lang="en-US" altLang="zh-CN" sz="14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lang="en-US" altLang="zh-CN" sz="2400" b="1" dirty="0" smtClean="0">
                      <a:latin typeface="Times New Roman" panose="02020603050405020304" pitchFamily="18" charset="0"/>
                    </a:rPr>
                    <a:t>T2-W</a:t>
                  </a:r>
                  <a:endParaRPr lang="zh-CN" altLang="en-US" sz="2400" b="1" dirty="0">
                    <a:latin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102" name="组合 101"/>
            <p:cNvGrpSpPr/>
            <p:nvPr/>
          </p:nvGrpSpPr>
          <p:grpSpPr>
            <a:xfrm>
              <a:off x="1714339" y="6914313"/>
              <a:ext cx="16469454" cy="2763731"/>
              <a:chOff x="480446" y="4242443"/>
              <a:chExt cx="16469454" cy="2763731"/>
            </a:xfrm>
          </p:grpSpPr>
          <p:pic>
            <p:nvPicPr>
              <p:cNvPr id="104" name="图片 103"/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930835" y="4306571"/>
                <a:ext cx="5266667" cy="2180952"/>
              </a:xfrm>
              <a:prstGeom prst="rect">
                <a:avLst/>
              </a:prstGeom>
            </p:spPr>
          </p:pic>
          <p:pic>
            <p:nvPicPr>
              <p:cNvPr id="105" name="图片 104"/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7210444" y="4306571"/>
                <a:ext cx="3876190" cy="2180952"/>
              </a:xfrm>
              <a:prstGeom prst="rect">
                <a:avLst/>
              </a:prstGeom>
            </p:spPr>
          </p:pic>
          <p:pic>
            <p:nvPicPr>
              <p:cNvPr id="106" name="图片 105"/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11968948" y="4311332"/>
                <a:ext cx="4980952" cy="2171429"/>
              </a:xfrm>
              <a:prstGeom prst="rect">
                <a:avLst/>
              </a:prstGeom>
            </p:spPr>
          </p:pic>
          <p:sp>
            <p:nvSpPr>
              <p:cNvPr id="107" name="矩形 106"/>
              <p:cNvSpPr/>
              <p:nvPr/>
            </p:nvSpPr>
            <p:spPr>
              <a:xfrm>
                <a:off x="480446" y="4306571"/>
                <a:ext cx="646331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zh-CN" alt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（</a:t>
                </a:r>
                <a:r>
                  <a:rPr lang="en-US" altLang="zh-CN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r>
                  <a:rPr lang="zh-CN" alt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）</a:t>
                </a:r>
              </a:p>
            </p:txBody>
          </p:sp>
          <p:sp>
            <p:nvSpPr>
              <p:cNvPr id="108" name="矩形 107"/>
              <p:cNvSpPr/>
              <p:nvPr/>
            </p:nvSpPr>
            <p:spPr>
              <a:xfrm>
                <a:off x="6731933" y="4306570"/>
                <a:ext cx="646331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zh-CN" alt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（</a:t>
                </a:r>
                <a:r>
                  <a:rPr lang="en-US" altLang="zh-CN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r>
                  <a:rPr lang="zh-CN" alt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）</a:t>
                </a:r>
              </a:p>
            </p:txBody>
          </p:sp>
          <p:sp>
            <p:nvSpPr>
              <p:cNvPr id="109" name="矩形 108"/>
              <p:cNvSpPr/>
              <p:nvPr/>
            </p:nvSpPr>
            <p:spPr>
              <a:xfrm>
                <a:off x="11535892" y="4306569"/>
                <a:ext cx="646331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zh-CN" alt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（</a:t>
                </a:r>
                <a:r>
                  <a:rPr lang="en-US" altLang="zh-CN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r>
                  <a:rPr lang="zh-CN" alt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）</a:t>
                </a:r>
              </a:p>
            </p:txBody>
          </p:sp>
          <p:sp>
            <p:nvSpPr>
              <p:cNvPr id="110" name="文本框 109"/>
              <p:cNvSpPr txBox="1"/>
              <p:nvPr/>
            </p:nvSpPr>
            <p:spPr>
              <a:xfrm>
                <a:off x="7701081" y="6546889"/>
                <a:ext cx="2894916" cy="4592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400" b="1" dirty="0">
                    <a:latin typeface="Times New Roman" panose="02020603050405020304" pitchFamily="18" charset="0"/>
                  </a:rPr>
                  <a:t>GGGTTC deletion</a:t>
                </a:r>
                <a:endParaRPr lang="zh-CN" altLang="en-US" sz="2400" b="1" dirty="0">
                  <a:latin typeface="Times New Roman" panose="02020603050405020304" pitchFamily="18" charset="0"/>
                </a:endParaRPr>
              </a:p>
            </p:txBody>
          </p:sp>
          <p:sp>
            <p:nvSpPr>
              <p:cNvPr id="111" name="矩形 110"/>
              <p:cNvSpPr/>
              <p:nvPr/>
            </p:nvSpPr>
            <p:spPr>
              <a:xfrm>
                <a:off x="8347063" y="4242443"/>
                <a:ext cx="71253" cy="2240318"/>
              </a:xfrm>
              <a:prstGeom prst="rect">
                <a:avLst/>
              </a:prstGeom>
              <a:solidFill>
                <a:srgbClr val="FFFF00">
                  <a:alpha val="30980"/>
                </a:srgb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12" name="矩形 111"/>
              <p:cNvSpPr/>
              <p:nvPr/>
            </p:nvSpPr>
            <p:spPr>
              <a:xfrm>
                <a:off x="13166738" y="4281057"/>
                <a:ext cx="71253" cy="2240318"/>
              </a:xfrm>
              <a:prstGeom prst="rect">
                <a:avLst/>
              </a:prstGeom>
              <a:solidFill>
                <a:srgbClr val="FFFF00">
                  <a:alpha val="30980"/>
                </a:srgb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13" name="文本框 112"/>
              <p:cNvSpPr txBox="1"/>
              <p:nvPr/>
            </p:nvSpPr>
            <p:spPr>
              <a:xfrm>
                <a:off x="13892861" y="6544509"/>
                <a:ext cx="1615113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400" b="1" dirty="0" smtClean="0">
                    <a:latin typeface="Times New Roman" panose="02020603050405020304" pitchFamily="18" charset="0"/>
                  </a:rPr>
                  <a:t>G </a:t>
                </a:r>
                <a:r>
                  <a:rPr lang="en-US" altLang="zh-CN" sz="2400" b="1" dirty="0">
                    <a:latin typeface="Times New Roman" panose="02020603050405020304" pitchFamily="18" charset="0"/>
                  </a:rPr>
                  <a:t>deletion</a:t>
                </a:r>
                <a:endParaRPr lang="zh-CN" altLang="en-US" sz="2400" b="1" dirty="0">
                  <a:latin typeface="Times New Roman" panose="02020603050405020304" pitchFamily="18" charset="0"/>
                </a:endParaRPr>
              </a:p>
            </p:txBody>
          </p:sp>
          <p:sp>
            <p:nvSpPr>
              <p:cNvPr id="114" name="文本框 113"/>
              <p:cNvSpPr txBox="1"/>
              <p:nvPr/>
            </p:nvSpPr>
            <p:spPr>
              <a:xfrm>
                <a:off x="2756611" y="6544509"/>
                <a:ext cx="1615113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400" b="1" dirty="0" smtClean="0">
                    <a:latin typeface="Times New Roman" panose="02020603050405020304" pitchFamily="18" charset="0"/>
                  </a:rPr>
                  <a:t>Wild type</a:t>
                </a:r>
                <a:endParaRPr lang="zh-CN" altLang="en-US" sz="2400" b="1" dirty="0">
                  <a:latin typeface="Times New Roman" panose="02020603050405020304" pitchFamily="18" charset="0"/>
                </a:endParaRPr>
              </a:p>
            </p:txBody>
          </p:sp>
        </p:grpSp>
        <p:sp>
          <p:nvSpPr>
            <p:cNvPr id="103" name="文本框 102"/>
            <p:cNvSpPr txBox="1"/>
            <p:nvPr/>
          </p:nvSpPr>
          <p:spPr>
            <a:xfrm>
              <a:off x="1010330" y="6914313"/>
              <a:ext cx="41643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800" b="1" dirty="0" smtClean="0">
                  <a:latin typeface="Times New Roman" panose="02020603050405020304" pitchFamily="18" charset="0"/>
                </a:rPr>
                <a:t>B</a:t>
              </a:r>
              <a:endParaRPr lang="zh-CN" altLang="en-US" sz="2800" b="1" dirty="0">
                <a:latin typeface="Times New Roman" panose="02020603050405020304" pitchFamily="18" charset="0"/>
              </a:endParaRPr>
            </a:p>
          </p:txBody>
        </p:sp>
        <p:sp>
          <p:nvSpPr>
            <p:cNvPr id="195" name="矩形 194"/>
            <p:cNvSpPr/>
            <p:nvPr/>
          </p:nvSpPr>
          <p:spPr>
            <a:xfrm>
              <a:off x="1015851" y="19790190"/>
              <a:ext cx="18093479" cy="360098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altLang="zh-CN" sz="3200" b="1" kern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l figure </a:t>
              </a:r>
              <a:r>
                <a:rPr lang="en-US" altLang="zh-CN" sz="3200" b="1" kern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. </a:t>
              </a:r>
              <a:r>
                <a:rPr lang="en-US" altLang="zh-CN" sz="3200" b="1" kern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uencing analysis of </a:t>
              </a:r>
              <a:r>
                <a:rPr lang="en-US" altLang="zh-CN" sz="32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C1-8</a:t>
              </a:r>
              <a:r>
                <a:rPr lang="en-US" altLang="zh-CN" sz="3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</a:t>
              </a:r>
              <a:r>
                <a:rPr lang="en-US" altLang="zh-CN" sz="32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C1-4, OsC2-12 </a:t>
              </a:r>
              <a:r>
                <a:rPr lang="en-US" altLang="zh-CN" sz="3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 </a:t>
              </a:r>
              <a:r>
                <a:rPr lang="en-US" altLang="zh-CN" sz="3200" b="1" kern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ir descendants.</a:t>
              </a:r>
            </a:p>
            <a:p>
              <a:pPr>
                <a:lnSpc>
                  <a:spcPct val="150000"/>
                </a:lnSpc>
              </a:pPr>
              <a:r>
                <a:rPr lang="en-US" altLang="zh-CN" sz="2400" kern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) Sequencing analysis of </a:t>
              </a:r>
              <a:r>
                <a:rPr lang="en-US" altLang="zh-CN" sz="2400" i="1" kern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C1-8</a:t>
              </a:r>
              <a:r>
                <a:rPr lang="en-US" altLang="zh-CN" sz="2400" kern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nd its T</a:t>
              </a:r>
              <a:r>
                <a:rPr lang="en-US" altLang="zh-CN" sz="2400" kern="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altLang="zh-CN" sz="2400" kern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descendants. OsC1-8 T2-W was </a:t>
              </a:r>
              <a:r>
                <a:rPr lang="en-US" altLang="zh-CN" sz="2400" kern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 </a:t>
              </a:r>
              <a:r>
                <a:rPr lang="en-US" altLang="zh-CN" sz="2400" kern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rmal 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reen </a:t>
              </a:r>
              <a:r>
                <a:rPr lang="en-US" altLang="zh-CN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dividual; </a:t>
              </a:r>
              <a:r>
                <a:rPr lang="en-US" altLang="zh-CN" sz="2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C1-8 T2-1 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</a:t>
              </a:r>
              <a:r>
                <a:rPr lang="en-US" altLang="zh-CN" sz="2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sC1-8 T2-2 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ere</a:t>
              </a:r>
              <a:r>
                <a:rPr lang="en-US" altLang="zh-CN" sz="2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riped individuals. (B) Three types of gene sequences </a:t>
              </a:r>
              <a:r>
                <a:rPr lang="en-US" altLang="zh-CN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ained 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 </a:t>
              </a:r>
              <a:r>
                <a:rPr lang="en-US" altLang="zh-CN" sz="2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C1-8 T1-1. 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C)</a:t>
              </a:r>
              <a:r>
                <a:rPr lang="en-US" altLang="zh-CN" sz="2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2400" kern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uencing analysis of </a:t>
              </a:r>
              <a:r>
                <a:rPr lang="en-US" altLang="zh-CN" sz="2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C1-4 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 its T</a:t>
              </a:r>
              <a:r>
                <a:rPr lang="en-US" altLang="zh-CN" sz="2400" baseline="-25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descendants. </a:t>
              </a:r>
              <a:r>
                <a:rPr lang="en-US" altLang="zh-CN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C1-4 T1-W was 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 </a:t>
              </a:r>
              <a:r>
                <a:rPr lang="en-US" altLang="zh-CN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rmal green 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dividual; </a:t>
              </a:r>
              <a:r>
                <a:rPr lang="en-US" altLang="zh-CN" sz="2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C1-4 T1-1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</a:t>
              </a:r>
              <a:r>
                <a:rPr lang="en-US" altLang="zh-CN" sz="2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sC1-4 T1-2 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 </a:t>
              </a:r>
              <a:r>
                <a:rPr lang="en-US" altLang="zh-CN" sz="2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C1-4 T1-3 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ere</a:t>
              </a:r>
              <a:r>
                <a:rPr lang="en-US" altLang="zh-CN" sz="2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riped individuals. (D) </a:t>
              </a:r>
              <a:r>
                <a:rPr lang="en-US" altLang="zh-CN" sz="2400" kern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uencing analysis of </a:t>
              </a:r>
              <a:r>
                <a:rPr lang="en-US" altLang="zh-CN" sz="2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C2-12 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 its T</a:t>
              </a:r>
              <a:r>
                <a:rPr lang="en-US" altLang="zh-CN" sz="2400" baseline="-25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descendants.</a:t>
              </a:r>
              <a:r>
                <a:rPr lang="en-US" altLang="zh-CN" sz="2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C2-12 T1-W was a normal green </a:t>
              </a:r>
              <a:r>
                <a:rPr lang="en-US" altLang="zh-CN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dividual;</a:t>
              </a:r>
              <a:r>
                <a:rPr lang="en-US" altLang="zh-CN" sz="2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sC2-12 T1-1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</a:t>
              </a:r>
              <a:r>
                <a:rPr lang="en-US" altLang="zh-CN" sz="2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sC2-12 T1-2 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</a:t>
              </a:r>
              <a:r>
                <a:rPr lang="en-US" altLang="zh-CN" sz="2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sC2-12 T1-3 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ere</a:t>
              </a:r>
              <a:r>
                <a:rPr lang="en-US" altLang="zh-CN" sz="2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riped individuals.  </a:t>
              </a:r>
              <a:endParaRPr lang="zh-CN" altLang="zh-CN" sz="2000" kern="100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88" name="组合 87"/>
            <p:cNvGrpSpPr/>
            <p:nvPr/>
          </p:nvGrpSpPr>
          <p:grpSpPr>
            <a:xfrm>
              <a:off x="1637922" y="13911489"/>
              <a:ext cx="17471408" cy="5820062"/>
              <a:chOff x="1637922" y="13911489"/>
              <a:chExt cx="17471408" cy="5820062"/>
            </a:xfrm>
          </p:grpSpPr>
          <p:grpSp>
            <p:nvGrpSpPr>
              <p:cNvPr id="96" name="组合 95"/>
              <p:cNvGrpSpPr/>
              <p:nvPr/>
            </p:nvGrpSpPr>
            <p:grpSpPr>
              <a:xfrm>
                <a:off x="1637922" y="13911489"/>
                <a:ext cx="17471408" cy="5820062"/>
                <a:chOff x="-180397" y="711087"/>
                <a:chExt cx="17471408" cy="5820062"/>
              </a:xfrm>
            </p:grpSpPr>
            <p:grpSp>
              <p:nvGrpSpPr>
                <p:cNvPr id="163" name="组合 162"/>
                <p:cNvGrpSpPr/>
                <p:nvPr/>
              </p:nvGrpSpPr>
              <p:grpSpPr>
                <a:xfrm>
                  <a:off x="-180397" y="711087"/>
                  <a:ext cx="17471408" cy="5314169"/>
                  <a:chOff x="163988" y="912967"/>
                  <a:chExt cx="17471408" cy="5314169"/>
                </a:xfrm>
              </p:grpSpPr>
              <p:grpSp>
                <p:nvGrpSpPr>
                  <p:cNvPr id="167" name="组合 166"/>
                  <p:cNvGrpSpPr/>
                  <p:nvPr/>
                </p:nvGrpSpPr>
                <p:grpSpPr>
                  <a:xfrm>
                    <a:off x="3146336" y="912967"/>
                    <a:ext cx="14489060" cy="5314169"/>
                    <a:chOff x="2939630" y="579708"/>
                    <a:chExt cx="14489060" cy="5314169"/>
                  </a:xfrm>
                </p:grpSpPr>
                <p:grpSp>
                  <p:nvGrpSpPr>
                    <p:cNvPr id="180" name="组合 179"/>
                    <p:cNvGrpSpPr/>
                    <p:nvPr/>
                  </p:nvGrpSpPr>
                  <p:grpSpPr>
                    <a:xfrm>
                      <a:off x="3482328" y="828463"/>
                      <a:ext cx="13946362" cy="5065414"/>
                      <a:chOff x="3482328" y="828463"/>
                      <a:chExt cx="13946362" cy="5065414"/>
                    </a:xfrm>
                  </p:grpSpPr>
                  <p:grpSp>
                    <p:nvGrpSpPr>
                      <p:cNvPr id="184" name="组合 183"/>
                      <p:cNvGrpSpPr/>
                      <p:nvPr/>
                    </p:nvGrpSpPr>
                    <p:grpSpPr>
                      <a:xfrm>
                        <a:off x="3482328" y="908781"/>
                        <a:ext cx="13946362" cy="4985096"/>
                        <a:chOff x="3707960" y="315015"/>
                        <a:chExt cx="13946362" cy="4985096"/>
                      </a:xfrm>
                    </p:grpSpPr>
                    <p:pic>
                      <p:nvPicPr>
                        <p:cNvPr id="192" name="图片 191"/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3707960" y="315015"/>
                          <a:ext cx="5308801" cy="2160000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193" name="图片 192"/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6456899" y="3138206"/>
                          <a:ext cx="5569505" cy="2160000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194" name="图片 193"/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12397179" y="3138206"/>
                          <a:ext cx="5257143" cy="2161905"/>
                        </a:xfrm>
                        <a:prstGeom prst="rect">
                          <a:avLst/>
                        </a:prstGeom>
                      </p:spPr>
                    </p:pic>
                  </p:grpSp>
                  <p:cxnSp>
                    <p:nvCxnSpPr>
                      <p:cNvPr id="185" name="直接连接符 184"/>
                      <p:cNvCxnSpPr/>
                      <p:nvPr/>
                    </p:nvCxnSpPr>
                    <p:spPr>
                      <a:xfrm>
                        <a:off x="3482328" y="1235034"/>
                        <a:ext cx="4533515" cy="0"/>
                      </a:xfrm>
                      <a:prstGeom prst="line">
                        <a:avLst/>
                      </a:prstGeom>
                      <a:ln w="285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86" name="矩形 185"/>
                      <p:cNvSpPr/>
                      <p:nvPr/>
                    </p:nvSpPr>
                    <p:spPr>
                      <a:xfrm>
                        <a:off x="8087383" y="828463"/>
                        <a:ext cx="703746" cy="2240318"/>
                      </a:xfrm>
                      <a:prstGeom prst="rect">
                        <a:avLst/>
                      </a:prstGeom>
                      <a:solidFill>
                        <a:srgbClr val="ED7D31">
                          <a:alpha val="18824"/>
                        </a:srgbClr>
                      </a:solidFill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zh-CN" altLang="en-US"/>
                      </a:p>
                    </p:txBody>
                  </p:sp>
                  <p:sp>
                    <p:nvSpPr>
                      <p:cNvPr id="187" name="文本框 186"/>
                      <p:cNvSpPr txBox="1"/>
                      <p:nvPr/>
                    </p:nvSpPr>
                    <p:spPr>
                      <a:xfrm>
                        <a:off x="8054849" y="1297032"/>
                        <a:ext cx="906149" cy="4001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altLang="zh-CN" sz="2000" b="1" dirty="0">
                            <a:latin typeface="Times New Roman" panose="02020603050405020304" pitchFamily="18" charset="0"/>
                          </a:rPr>
                          <a:t>PAM</a:t>
                        </a:r>
                        <a:endParaRPr lang="zh-CN" altLang="en-US" sz="2000" b="1" dirty="0">
                          <a:latin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188" name="矩形 187"/>
                      <p:cNvSpPr/>
                      <p:nvPr/>
                    </p:nvSpPr>
                    <p:spPr>
                      <a:xfrm>
                        <a:off x="10097784" y="3651654"/>
                        <a:ext cx="233938" cy="2240318"/>
                      </a:xfrm>
                      <a:prstGeom prst="rect">
                        <a:avLst/>
                      </a:prstGeom>
                      <a:solidFill>
                        <a:srgbClr val="FF0000">
                          <a:alpha val="18824"/>
                        </a:srgbClr>
                      </a:solidFill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zh-CN" altLang="en-US"/>
                      </a:p>
                    </p:txBody>
                  </p:sp>
                  <p:sp>
                    <p:nvSpPr>
                      <p:cNvPr id="189" name="文本框 188"/>
                      <p:cNvSpPr txBox="1"/>
                      <p:nvPr/>
                    </p:nvSpPr>
                    <p:spPr>
                      <a:xfrm>
                        <a:off x="7749717" y="4088485"/>
                        <a:ext cx="2376302" cy="46166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altLang="zh-CN" sz="2400" b="1" dirty="0">
                            <a:latin typeface="Times New Roman" panose="02020603050405020304" pitchFamily="18" charset="0"/>
                          </a:rPr>
                          <a:t>G insertion</a:t>
                        </a:r>
                        <a:endParaRPr lang="zh-CN" altLang="en-US" sz="2400" b="1" dirty="0">
                          <a:latin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190" name="文本框 189"/>
                      <p:cNvSpPr txBox="1"/>
                      <p:nvPr/>
                    </p:nvSpPr>
                    <p:spPr>
                      <a:xfrm>
                        <a:off x="13634596" y="4043254"/>
                        <a:ext cx="2474667" cy="52322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altLang="zh-CN" sz="2400" b="1" dirty="0">
                            <a:latin typeface="Times New Roman" panose="02020603050405020304" pitchFamily="18" charset="0"/>
                          </a:rPr>
                          <a:t>T</a:t>
                        </a:r>
                        <a:r>
                          <a:rPr lang="en-US" altLang="zh-CN" sz="2800" b="1" dirty="0">
                            <a:latin typeface="Times New Roman" panose="02020603050405020304" pitchFamily="18" charset="0"/>
                          </a:rPr>
                          <a:t> </a:t>
                        </a:r>
                        <a:r>
                          <a:rPr lang="en-US" altLang="zh-CN" sz="2400" b="1" dirty="0">
                            <a:latin typeface="Times New Roman" panose="02020603050405020304" pitchFamily="18" charset="0"/>
                          </a:rPr>
                          <a:t>deletion</a:t>
                        </a:r>
                        <a:endParaRPr lang="zh-CN" altLang="en-US" sz="2400" b="1" dirty="0">
                          <a:latin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191" name="矩形 190"/>
                      <p:cNvSpPr/>
                      <p:nvPr/>
                    </p:nvSpPr>
                    <p:spPr>
                      <a:xfrm>
                        <a:off x="16227343" y="3651654"/>
                        <a:ext cx="71252" cy="2240318"/>
                      </a:xfrm>
                      <a:prstGeom prst="rect">
                        <a:avLst/>
                      </a:prstGeom>
                      <a:solidFill>
                        <a:srgbClr val="FFFF00">
                          <a:alpha val="30980"/>
                        </a:srgbClr>
                      </a:solidFill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zh-CN" altLang="en-US"/>
                      </a:p>
                    </p:txBody>
                  </p:sp>
                </p:grpSp>
                <p:sp>
                  <p:nvSpPr>
                    <p:cNvPr id="181" name="文本框 180"/>
                    <p:cNvSpPr txBox="1"/>
                    <p:nvPr/>
                  </p:nvSpPr>
                  <p:spPr>
                    <a:xfrm>
                      <a:off x="3422953" y="579708"/>
                      <a:ext cx="4771020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6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  A  A  A T  A  G  A G  G G T  T  T G  G C   A  A  G</a:t>
                      </a:r>
                      <a:endParaRPr lang="zh-CN" altLang="en-US" sz="1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82" name="矩形 181"/>
                    <p:cNvSpPr/>
                    <p:nvPr/>
                  </p:nvSpPr>
                  <p:spPr>
                    <a:xfrm>
                      <a:off x="2965159" y="630704"/>
                      <a:ext cx="646331" cy="307777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zh-CN" altLang="en-US" sz="14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lang="en-US" altLang="zh-CN" sz="14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zh-CN" altLang="en-US" sz="14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）</a:t>
                      </a:r>
                    </a:p>
                  </p:txBody>
                </p:sp>
                <p:sp>
                  <p:nvSpPr>
                    <p:cNvPr id="183" name="矩形 182"/>
                    <p:cNvSpPr/>
                    <p:nvPr/>
                  </p:nvSpPr>
                  <p:spPr>
                    <a:xfrm>
                      <a:off x="2939630" y="938148"/>
                      <a:ext cx="603050" cy="307777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algn="ctr"/>
                      <a:r>
                        <a:rPr lang="zh-CN" altLang="en-US" sz="14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lang="en-US" altLang="zh-CN" sz="14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zh-CN" altLang="en-US" sz="14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）</a:t>
                      </a:r>
                    </a:p>
                  </p:txBody>
                </p:sp>
              </p:grpSp>
              <p:sp>
                <p:nvSpPr>
                  <p:cNvPr id="168" name="矩形 167"/>
                  <p:cNvSpPr/>
                  <p:nvPr/>
                </p:nvSpPr>
                <p:spPr>
                  <a:xfrm>
                    <a:off x="11729678" y="3434761"/>
                    <a:ext cx="1297150" cy="461665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2400" b="1" i="1" dirty="0">
                        <a:latin typeface="Times New Roman" panose="02020603050405020304" pitchFamily="18" charset="0"/>
                      </a:rPr>
                      <a:t>OsC2-12</a:t>
                    </a:r>
                    <a:endParaRPr lang="zh-CN" altLang="en-US" sz="2400" b="1" i="1" dirty="0">
                      <a:latin typeface="Times New Roman" panose="02020603050405020304" pitchFamily="18" charset="0"/>
                    </a:endParaRPr>
                  </a:p>
                </p:txBody>
              </p:sp>
              <p:pic>
                <p:nvPicPr>
                  <p:cNvPr id="169" name="图片 168"/>
                  <p:cNvPicPr>
                    <a:picLocks noChangeAspect="1"/>
                  </p:cNvPicPr>
                  <p:nvPr/>
                </p:nvPicPr>
                <p:blipFill>
                  <a:blip r:embed="rId15"/>
                  <a:stretch>
                    <a:fillRect/>
                  </a:stretch>
                </p:blipFill>
                <p:spPr>
                  <a:xfrm>
                    <a:off x="9509942" y="1219156"/>
                    <a:ext cx="5514286" cy="2171429"/>
                  </a:xfrm>
                  <a:prstGeom prst="rect">
                    <a:avLst/>
                  </a:prstGeom>
                </p:spPr>
              </p:pic>
              <p:grpSp>
                <p:nvGrpSpPr>
                  <p:cNvPr id="170" name="组合 169"/>
                  <p:cNvGrpSpPr/>
                  <p:nvPr/>
                </p:nvGrpSpPr>
                <p:grpSpPr>
                  <a:xfrm>
                    <a:off x="626201" y="3976695"/>
                    <a:ext cx="5490396" cy="2240318"/>
                    <a:chOff x="11860893" y="4223205"/>
                    <a:chExt cx="5490396" cy="2240318"/>
                  </a:xfrm>
                </p:grpSpPr>
                <p:pic>
                  <p:nvPicPr>
                    <p:cNvPr id="177" name="图片 176"/>
                    <p:cNvPicPr>
                      <a:picLocks noChangeAspect="1"/>
                    </p:cNvPicPr>
                    <p:nvPr/>
                  </p:nvPicPr>
                  <p:blipFill>
                    <a:blip r:embed="rId16"/>
                    <a:stretch>
                      <a:fillRect/>
                    </a:stretch>
                  </p:blipFill>
                  <p:spPr>
                    <a:xfrm>
                      <a:off x="11860893" y="4303523"/>
                      <a:ext cx="5490396" cy="2160000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178" name="矩形 177"/>
                    <p:cNvSpPr/>
                    <p:nvPr/>
                  </p:nvSpPr>
                  <p:spPr>
                    <a:xfrm>
                      <a:off x="16142408" y="4223205"/>
                      <a:ext cx="233938" cy="2240318"/>
                    </a:xfrm>
                    <a:prstGeom prst="rect">
                      <a:avLst/>
                    </a:prstGeom>
                    <a:solidFill>
                      <a:srgbClr val="FF0000">
                        <a:alpha val="18824"/>
                      </a:srgb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/>
                    </a:p>
                  </p:txBody>
                </p:sp>
                <p:sp>
                  <p:nvSpPr>
                    <p:cNvPr id="179" name="文本框 178"/>
                    <p:cNvSpPr txBox="1"/>
                    <p:nvPr/>
                  </p:nvSpPr>
                  <p:spPr>
                    <a:xfrm>
                      <a:off x="13582112" y="4668254"/>
                      <a:ext cx="2145046" cy="46166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2400" b="1" dirty="0">
                          <a:latin typeface="Times New Roman" panose="02020603050405020304" pitchFamily="18" charset="0"/>
                        </a:rPr>
                        <a:t>T insertion</a:t>
                      </a:r>
                      <a:endParaRPr lang="zh-CN" altLang="en-US" sz="2400" b="1" dirty="0">
                        <a:latin typeface="Times New Roman" panose="02020603050405020304" pitchFamily="18" charset="0"/>
                      </a:endParaRPr>
                    </a:p>
                  </p:txBody>
                </p:sp>
              </p:grpSp>
              <p:sp>
                <p:nvSpPr>
                  <p:cNvPr id="171" name="矩形 170"/>
                  <p:cNvSpPr/>
                  <p:nvPr/>
                </p:nvSpPr>
                <p:spPr>
                  <a:xfrm>
                    <a:off x="9087102" y="1206959"/>
                    <a:ext cx="646331" cy="307777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zh-CN" altLang="en-US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（</a:t>
                    </a:r>
                    <a:r>
                      <a:rPr lang="en-US" altLang="zh-CN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+</a:t>
                    </a:r>
                    <a:r>
                      <a:rPr lang="zh-CN" altLang="en-US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）</a:t>
                    </a:r>
                  </a:p>
                </p:txBody>
              </p:sp>
              <p:sp>
                <p:nvSpPr>
                  <p:cNvPr id="172" name="矩形 171"/>
                  <p:cNvSpPr/>
                  <p:nvPr/>
                </p:nvSpPr>
                <p:spPr>
                  <a:xfrm>
                    <a:off x="10421355" y="1150267"/>
                    <a:ext cx="233938" cy="2240318"/>
                  </a:xfrm>
                  <a:prstGeom prst="rect">
                    <a:avLst/>
                  </a:prstGeom>
                  <a:solidFill>
                    <a:srgbClr val="FF0000">
                      <a:alpha val="18824"/>
                    </a:srgbClr>
                  </a:solidFill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173" name="文本框 172"/>
                  <p:cNvSpPr txBox="1"/>
                  <p:nvPr/>
                </p:nvSpPr>
                <p:spPr>
                  <a:xfrm>
                    <a:off x="11167400" y="1568293"/>
                    <a:ext cx="2165860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2400" b="1" dirty="0">
                        <a:latin typeface="Times New Roman" panose="02020603050405020304" pitchFamily="18" charset="0"/>
                      </a:rPr>
                      <a:t>A insertion</a:t>
                    </a:r>
                    <a:endParaRPr lang="zh-CN" altLang="en-US" sz="2400" b="1" dirty="0">
                      <a:latin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74" name="矩形 173"/>
                  <p:cNvSpPr/>
                  <p:nvPr/>
                </p:nvSpPr>
                <p:spPr>
                  <a:xfrm>
                    <a:off x="163988" y="4065231"/>
                    <a:ext cx="603050" cy="307777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ctr"/>
                    <a:r>
                      <a:rPr lang="zh-CN" altLang="en-US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（</a:t>
                    </a:r>
                    <a:r>
                      <a:rPr lang="en-US" altLang="zh-CN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-</a:t>
                    </a:r>
                    <a:r>
                      <a:rPr lang="zh-CN" altLang="en-US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）</a:t>
                    </a:r>
                  </a:p>
                </p:txBody>
              </p:sp>
              <p:sp>
                <p:nvSpPr>
                  <p:cNvPr id="175" name="矩形 174"/>
                  <p:cNvSpPr/>
                  <p:nvPr/>
                </p:nvSpPr>
                <p:spPr>
                  <a:xfrm>
                    <a:off x="6005857" y="4067460"/>
                    <a:ext cx="603050" cy="307777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ctr"/>
                    <a:r>
                      <a:rPr lang="zh-CN" altLang="en-US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（</a:t>
                    </a:r>
                    <a:r>
                      <a:rPr lang="en-US" altLang="zh-CN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-</a:t>
                    </a:r>
                    <a:r>
                      <a:rPr lang="zh-CN" altLang="en-US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）</a:t>
                    </a:r>
                  </a:p>
                </p:txBody>
              </p:sp>
              <p:sp>
                <p:nvSpPr>
                  <p:cNvPr id="176" name="矩形 175"/>
                  <p:cNvSpPr/>
                  <p:nvPr/>
                </p:nvSpPr>
                <p:spPr>
                  <a:xfrm>
                    <a:off x="11936984" y="4057013"/>
                    <a:ext cx="603050" cy="307777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ctr"/>
                    <a:r>
                      <a:rPr lang="zh-CN" altLang="en-US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（</a:t>
                    </a:r>
                    <a:r>
                      <a:rPr lang="en-US" altLang="zh-CN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-</a:t>
                    </a:r>
                    <a:r>
                      <a:rPr lang="zh-CN" altLang="en-US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）</a:t>
                    </a:r>
                  </a:p>
                </p:txBody>
              </p:sp>
            </p:grpSp>
            <p:sp>
              <p:nvSpPr>
                <p:cNvPr id="164" name="矩形 163"/>
                <p:cNvSpPr/>
                <p:nvPr/>
              </p:nvSpPr>
              <p:spPr>
                <a:xfrm>
                  <a:off x="1982697" y="5987443"/>
                  <a:ext cx="1972015" cy="461665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2400" b="1" i="1" dirty="0">
                      <a:latin typeface="Times New Roman" panose="02020603050405020304" pitchFamily="18" charset="0"/>
                    </a:rPr>
                    <a:t>OsC2-12 T1-1</a:t>
                  </a:r>
                  <a:endParaRPr lang="zh-CN" altLang="en-US" sz="2400" b="1" i="1" dirty="0">
                    <a:latin typeface="Times New Roman" panose="02020603050405020304" pitchFamily="18" charset="0"/>
                  </a:endParaRPr>
                </a:p>
              </p:txBody>
            </p:sp>
            <p:sp>
              <p:nvSpPr>
                <p:cNvPr id="165" name="矩形 164"/>
                <p:cNvSpPr/>
                <p:nvPr/>
              </p:nvSpPr>
              <p:spPr>
                <a:xfrm>
                  <a:off x="7917170" y="6065229"/>
                  <a:ext cx="1972015" cy="461665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2400" b="1" i="1" dirty="0">
                      <a:latin typeface="Times New Roman" panose="02020603050405020304" pitchFamily="18" charset="0"/>
                    </a:rPr>
                    <a:t>OsC2-12 T1-2</a:t>
                  </a:r>
                  <a:endParaRPr lang="zh-CN" altLang="en-US" sz="2400" b="1" i="1" dirty="0">
                    <a:latin typeface="Times New Roman" panose="02020603050405020304" pitchFamily="18" charset="0"/>
                  </a:endParaRPr>
                </a:p>
              </p:txBody>
            </p:sp>
            <p:sp>
              <p:nvSpPr>
                <p:cNvPr id="166" name="矩形 165"/>
                <p:cNvSpPr/>
                <p:nvPr/>
              </p:nvSpPr>
              <p:spPr>
                <a:xfrm>
                  <a:off x="13527352" y="6069484"/>
                  <a:ext cx="1972015" cy="461665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defTabSz="1413835"/>
                  <a:r>
                    <a:rPr lang="en-US" altLang="zh-CN" sz="2400" b="1" i="1" dirty="0">
                      <a:latin typeface="Times New Roman" panose="02020603050405020304" pitchFamily="18" charset="0"/>
                    </a:rPr>
                    <a:t>OsC2-12 T1-3</a:t>
                  </a:r>
                  <a:endParaRPr lang="zh-CN" altLang="en-US" sz="2400" b="1" i="1" dirty="0">
                    <a:latin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96" name="矩形 195"/>
              <p:cNvSpPr/>
              <p:nvPr/>
            </p:nvSpPr>
            <p:spPr>
              <a:xfrm>
                <a:off x="6643713" y="16430160"/>
                <a:ext cx="2171620" cy="46166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2400" b="1" dirty="0" smtClean="0">
                    <a:latin typeface="Times New Roman" panose="02020603050405020304" pitchFamily="18" charset="0"/>
                  </a:rPr>
                  <a:t>OsC2-12 </a:t>
                </a:r>
                <a:r>
                  <a:rPr lang="en-US" altLang="zh-CN" sz="2400" b="1" dirty="0">
                    <a:latin typeface="Times New Roman" panose="02020603050405020304" pitchFamily="18" charset="0"/>
                  </a:rPr>
                  <a:t>T1-W</a:t>
                </a:r>
                <a:endParaRPr lang="zh-CN" altLang="en-US" sz="2400" b="1" dirty="0">
                  <a:latin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2227221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组合 12"/>
          <p:cNvGrpSpPr/>
          <p:nvPr/>
        </p:nvGrpSpPr>
        <p:grpSpPr>
          <a:xfrm>
            <a:off x="2828743" y="6327140"/>
            <a:ext cx="14499787" cy="8610013"/>
            <a:chOff x="2828743" y="6327140"/>
            <a:chExt cx="14499787" cy="8610013"/>
          </a:xfrm>
        </p:grpSpPr>
        <p:grpSp>
          <p:nvGrpSpPr>
            <p:cNvPr id="10" name="组合 9"/>
            <p:cNvGrpSpPr/>
            <p:nvPr/>
          </p:nvGrpSpPr>
          <p:grpSpPr>
            <a:xfrm>
              <a:off x="2828743" y="6327140"/>
              <a:ext cx="14499787" cy="4680000"/>
              <a:chOff x="3449230" y="7894683"/>
              <a:chExt cx="14499787" cy="4680000"/>
            </a:xfrm>
          </p:grpSpPr>
          <p:pic>
            <p:nvPicPr>
              <p:cNvPr id="9" name="图片 8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94338" y="7894683"/>
                <a:ext cx="14454679" cy="4680000"/>
              </a:xfrm>
              <a:prstGeom prst="rect">
                <a:avLst/>
              </a:prstGeom>
            </p:spPr>
          </p:pic>
          <p:sp>
            <p:nvSpPr>
              <p:cNvPr id="101" name="文本框 100"/>
              <p:cNvSpPr txBox="1"/>
              <p:nvPr/>
            </p:nvSpPr>
            <p:spPr>
              <a:xfrm>
                <a:off x="3704414" y="8406963"/>
                <a:ext cx="284226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400" b="1" dirty="0" smtClean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00 </a:t>
                </a:r>
                <a:r>
                  <a:rPr lang="en-US" altLang="zh-CN" sz="2400" b="1" dirty="0" err="1" smtClean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p</a:t>
                </a:r>
                <a:r>
                  <a:rPr lang="en-US" altLang="zh-CN" sz="2400" b="1" dirty="0" smtClean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marker</a:t>
                </a:r>
                <a:endParaRPr lang="zh-CN" altLang="en-US" sz="2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2" name="文本框 101"/>
              <p:cNvSpPr txBox="1"/>
              <p:nvPr/>
            </p:nvSpPr>
            <p:spPr>
              <a:xfrm>
                <a:off x="3449230" y="10585340"/>
                <a:ext cx="118744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400" b="1" dirty="0" smtClean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50 </a:t>
                </a:r>
                <a:r>
                  <a:rPr lang="en-US" altLang="zh-CN" sz="2400" b="1" dirty="0" err="1" smtClean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p</a:t>
                </a:r>
                <a:endParaRPr lang="zh-CN" altLang="en-US" sz="2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03" name="组合 102"/>
              <p:cNvGrpSpPr/>
              <p:nvPr/>
            </p:nvGrpSpPr>
            <p:grpSpPr>
              <a:xfrm>
                <a:off x="5554869" y="8053027"/>
                <a:ext cx="12293450" cy="4276498"/>
                <a:chOff x="7635783" y="9351160"/>
                <a:chExt cx="12293450" cy="4276498"/>
              </a:xfrm>
            </p:grpSpPr>
            <p:grpSp>
              <p:nvGrpSpPr>
                <p:cNvPr id="104" name="组合 103"/>
                <p:cNvGrpSpPr/>
                <p:nvPr/>
              </p:nvGrpSpPr>
              <p:grpSpPr>
                <a:xfrm>
                  <a:off x="7635783" y="9415658"/>
                  <a:ext cx="12293450" cy="4212000"/>
                  <a:chOff x="6008862" y="3908418"/>
                  <a:chExt cx="12293450" cy="4212000"/>
                </a:xfrm>
              </p:grpSpPr>
              <p:cxnSp>
                <p:nvCxnSpPr>
                  <p:cNvPr id="106" name="直接连接符 105"/>
                  <p:cNvCxnSpPr/>
                  <p:nvPr/>
                </p:nvCxnSpPr>
                <p:spPr>
                  <a:xfrm>
                    <a:off x="9608087" y="3908418"/>
                    <a:ext cx="0" cy="4212000"/>
                  </a:xfrm>
                  <a:prstGeom prst="line">
                    <a:avLst/>
                  </a:prstGeom>
                  <a:ln>
                    <a:solidFill>
                      <a:srgbClr val="92D050"/>
                    </a:solidFill>
                    <a:prstDash val="lg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07" name="文本框 106"/>
                  <p:cNvSpPr txBox="1"/>
                  <p:nvPr/>
                </p:nvSpPr>
                <p:spPr>
                  <a:xfrm>
                    <a:off x="15277584" y="7463647"/>
                    <a:ext cx="1177386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2400" b="1" i="1" dirty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OsC1-8</a:t>
                    </a:r>
                    <a:endParaRPr lang="zh-CN" altLang="en-US" sz="2400" b="1" i="1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08" name="矩形 107"/>
                  <p:cNvSpPr/>
                  <p:nvPr/>
                </p:nvSpPr>
                <p:spPr>
                  <a:xfrm>
                    <a:off x="15548140" y="6976300"/>
                    <a:ext cx="782587" cy="461665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2400" b="1" i="1" dirty="0" smtClean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2-1</a:t>
                    </a:r>
                    <a:endParaRPr lang="zh-CN" altLang="en-US" sz="2400" b="1" i="1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09" name="矩形 108"/>
                  <p:cNvSpPr/>
                  <p:nvPr/>
                </p:nvSpPr>
                <p:spPr>
                  <a:xfrm>
                    <a:off x="16518786" y="6968175"/>
                    <a:ext cx="782587" cy="461665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2400" b="1" i="1" dirty="0" smtClean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2-2</a:t>
                    </a:r>
                    <a:endParaRPr lang="zh-CN" altLang="en-US" sz="2400" b="1" i="1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10" name="矩形 109"/>
                  <p:cNvSpPr/>
                  <p:nvPr/>
                </p:nvSpPr>
                <p:spPr>
                  <a:xfrm>
                    <a:off x="17399501" y="6968176"/>
                    <a:ext cx="902811" cy="461665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2400" b="1" i="1" dirty="0" smtClean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2-W</a:t>
                    </a:r>
                    <a:endParaRPr lang="zh-CN" altLang="en-US" sz="2400" b="1" i="1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11" name="文本框 110"/>
                  <p:cNvSpPr txBox="1"/>
                  <p:nvPr/>
                </p:nvSpPr>
                <p:spPr>
                  <a:xfrm>
                    <a:off x="11026493" y="7463647"/>
                    <a:ext cx="1928652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2400" b="1" i="1" dirty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OsC2-12</a:t>
                    </a:r>
                    <a:endParaRPr lang="zh-CN" altLang="en-US" sz="2400" b="1" i="1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12" name="文本框 111"/>
                  <p:cNvSpPr txBox="1"/>
                  <p:nvPr/>
                </p:nvSpPr>
                <p:spPr>
                  <a:xfrm>
                    <a:off x="7093317" y="7463647"/>
                    <a:ext cx="1496734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2400" b="1" i="1" dirty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OsC1-4</a:t>
                    </a:r>
                    <a:endParaRPr lang="zh-CN" altLang="en-US" sz="2400" b="1" i="1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13" name="矩形 112"/>
                  <p:cNvSpPr/>
                  <p:nvPr/>
                </p:nvSpPr>
                <p:spPr>
                  <a:xfrm>
                    <a:off x="9801872" y="6982521"/>
                    <a:ext cx="782587" cy="461665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2400" b="1" i="1" dirty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1-1</a:t>
                    </a:r>
                    <a:endParaRPr lang="zh-CN" altLang="en-US" sz="2400" b="1" i="1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14" name="矩形 113"/>
                  <p:cNvSpPr/>
                  <p:nvPr/>
                </p:nvSpPr>
                <p:spPr>
                  <a:xfrm>
                    <a:off x="10851586" y="6968178"/>
                    <a:ext cx="782587" cy="461665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2400" b="1" i="1" dirty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1-2</a:t>
                    </a:r>
                    <a:endParaRPr lang="zh-CN" altLang="en-US" sz="2400" b="1" i="1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15" name="矩形 114"/>
                  <p:cNvSpPr/>
                  <p:nvPr/>
                </p:nvSpPr>
                <p:spPr>
                  <a:xfrm>
                    <a:off x="11775016" y="6984842"/>
                    <a:ext cx="782587" cy="461665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2400" b="1" i="1" dirty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1-3</a:t>
                    </a:r>
                    <a:endParaRPr lang="zh-CN" altLang="en-US" sz="2400" b="1" i="1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16" name="矩形 115"/>
                  <p:cNvSpPr/>
                  <p:nvPr/>
                </p:nvSpPr>
                <p:spPr>
                  <a:xfrm>
                    <a:off x="6008862" y="6976300"/>
                    <a:ext cx="782587" cy="461665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2400" b="1" i="1" dirty="0" smtClean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1-1</a:t>
                    </a:r>
                    <a:endParaRPr lang="zh-CN" altLang="en-US" sz="2400" b="1" i="1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17" name="矩形 116"/>
                  <p:cNvSpPr/>
                  <p:nvPr/>
                </p:nvSpPr>
                <p:spPr>
                  <a:xfrm>
                    <a:off x="6903335" y="6970640"/>
                    <a:ext cx="782587" cy="461665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2400" b="1" i="1" dirty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1-2</a:t>
                    </a:r>
                    <a:endParaRPr lang="zh-CN" altLang="en-US" sz="2400" b="1" i="1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18" name="矩形 117"/>
                  <p:cNvSpPr/>
                  <p:nvPr/>
                </p:nvSpPr>
                <p:spPr>
                  <a:xfrm>
                    <a:off x="7886129" y="6968844"/>
                    <a:ext cx="859531" cy="461665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2400" b="1" i="1" dirty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1-3 </a:t>
                    </a:r>
                    <a:endParaRPr lang="zh-CN" altLang="en-US" sz="2400" b="1" i="1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23" name="矩形 122"/>
                  <p:cNvSpPr/>
                  <p:nvPr/>
                </p:nvSpPr>
                <p:spPr>
                  <a:xfrm>
                    <a:off x="12606533" y="6984842"/>
                    <a:ext cx="902811" cy="461665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2400" b="1" i="1" dirty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1-W</a:t>
                    </a:r>
                    <a:endParaRPr lang="zh-CN" altLang="en-US" sz="2400" b="1" i="1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24" name="矩形 123"/>
                  <p:cNvSpPr/>
                  <p:nvPr/>
                </p:nvSpPr>
                <p:spPr>
                  <a:xfrm>
                    <a:off x="8640951" y="6976300"/>
                    <a:ext cx="902811" cy="461665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2400" b="1" i="1" dirty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1-W</a:t>
                    </a:r>
                    <a:endParaRPr lang="zh-CN" altLang="en-US" sz="2400" b="1" i="1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cxnSp>
              <p:nvCxnSpPr>
                <p:cNvPr id="105" name="直接连接符 104"/>
                <p:cNvCxnSpPr/>
                <p:nvPr/>
              </p:nvCxnSpPr>
              <p:spPr>
                <a:xfrm>
                  <a:off x="15122512" y="9351160"/>
                  <a:ext cx="0" cy="4212000"/>
                </a:xfrm>
                <a:prstGeom prst="line">
                  <a:avLst/>
                </a:prstGeom>
                <a:ln>
                  <a:solidFill>
                    <a:srgbClr val="92D050"/>
                  </a:solidFill>
                  <a:prstDash val="lg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25" name="矩形 124"/>
              <p:cNvSpPr/>
              <p:nvPr/>
            </p:nvSpPr>
            <p:spPr>
              <a:xfrm>
                <a:off x="13226267" y="11177284"/>
                <a:ext cx="782587" cy="46166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2400" b="1" i="1" dirty="0" smtClean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1-1</a:t>
                </a:r>
                <a:endParaRPr lang="zh-CN" altLang="en-US" sz="2400" b="1" i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6" name="矩形 125"/>
              <p:cNvSpPr/>
              <p:nvPr/>
            </p:nvSpPr>
            <p:spPr>
              <a:xfrm>
                <a:off x="14053962" y="11193949"/>
                <a:ext cx="902811" cy="46166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2400" b="1" i="1" dirty="0" smtClean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1-W</a:t>
                </a:r>
                <a:endParaRPr lang="zh-CN" altLang="en-US" sz="2400" b="1" i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27" name="矩形 126"/>
            <p:cNvSpPr/>
            <p:nvPr/>
          </p:nvSpPr>
          <p:spPr>
            <a:xfrm>
              <a:off x="2829711" y="11520833"/>
              <a:ext cx="14244603" cy="341632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altLang="zh-CN" sz="3200" b="1" kern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l figure </a:t>
              </a:r>
              <a:r>
                <a:rPr lang="en-US" altLang="zh-CN" sz="3200" b="1" kern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. </a:t>
              </a:r>
              <a:r>
                <a:rPr lang="en-US" altLang="zh-CN" sz="3200" b="1" kern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garose gel electrophoresis for the PCR products amplified with </a:t>
              </a:r>
              <a:r>
                <a:rPr lang="en-US" altLang="zh-CN" sz="3200" b="1" i="1" kern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9</a:t>
              </a:r>
              <a:r>
                <a:rPr lang="en-US" altLang="zh-CN" sz="3200" b="1" kern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gene-specific primers of </a:t>
              </a:r>
              <a:r>
                <a:rPr lang="en-US" altLang="zh-CN" sz="3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r>
                <a:rPr lang="en-US" altLang="zh-CN" sz="3200" b="1" baseline="-25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lang="en-US" altLang="zh-CN" sz="3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nd T</a:t>
              </a:r>
              <a:r>
                <a:rPr lang="en-US" altLang="zh-CN" sz="3200" b="1" baseline="-25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altLang="zh-CN" sz="3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descendants of </a:t>
              </a:r>
              <a:r>
                <a:rPr lang="en-US" altLang="zh-CN" sz="32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C1-4</a:t>
              </a:r>
              <a:r>
                <a:rPr lang="en-US" altLang="zh-CN" sz="3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</a:t>
              </a:r>
              <a:r>
                <a:rPr lang="en-US" altLang="zh-CN" sz="32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C2-12, </a:t>
              </a:r>
              <a:r>
                <a:rPr lang="en-US" altLang="zh-CN" sz="3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 </a:t>
              </a:r>
              <a:r>
                <a:rPr lang="en-US" altLang="zh-CN" sz="32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C1-8</a:t>
              </a:r>
              <a:r>
                <a:rPr lang="en-US" altLang="zh-CN" sz="3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C1-4 T1-W, OsC2-12 T1-W, OsC1-8 </a:t>
              </a:r>
              <a:r>
                <a:rPr lang="en-US" altLang="zh-CN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1-W 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 T2-W were the normal green descendants</a:t>
              </a:r>
              <a:r>
                <a:rPr lang="en-US" altLang="zh-CN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OsC1-4 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1-1</a:t>
              </a:r>
              <a:r>
                <a:rPr lang="en-US" altLang="zh-CN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OsC1-4 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1-2, </a:t>
              </a:r>
              <a:r>
                <a:rPr lang="en-US" altLang="zh-CN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C1-4 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1-3, OsC2-12 T1-1, </a:t>
              </a:r>
              <a:r>
                <a:rPr lang="en-US" altLang="zh-CN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C2-12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T1-2, </a:t>
              </a:r>
              <a:r>
                <a:rPr lang="en-US" altLang="zh-CN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C2-12 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1-3, </a:t>
              </a:r>
              <a:r>
                <a:rPr lang="en-US" altLang="zh-CN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C1-8 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1-1, </a:t>
              </a:r>
              <a:r>
                <a:rPr lang="en-US" altLang="zh-CN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C1-8 </a:t>
              </a: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2-1 and OsC1-8 T2-2 were the striped descendants. </a:t>
              </a:r>
              <a:endParaRPr lang="zh-CN" altLang="zh-CN" sz="2400" kern="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3306373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组合 12"/>
          <p:cNvGrpSpPr/>
          <p:nvPr/>
        </p:nvGrpSpPr>
        <p:grpSpPr>
          <a:xfrm>
            <a:off x="2155372" y="1743626"/>
            <a:ext cx="16132628" cy="19872661"/>
            <a:chOff x="2220687" y="1939569"/>
            <a:chExt cx="16132628" cy="19872661"/>
          </a:xfrm>
        </p:grpSpPr>
        <p:sp>
          <p:nvSpPr>
            <p:cNvPr id="6" name="矩形 5"/>
            <p:cNvSpPr/>
            <p:nvPr/>
          </p:nvSpPr>
          <p:spPr>
            <a:xfrm>
              <a:off x="2220687" y="18118911"/>
              <a:ext cx="16132628" cy="369331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altLang="zh-CN" sz="3200" b="1" kern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l figure </a:t>
              </a:r>
              <a:r>
                <a:rPr lang="en-US" altLang="zh-CN" sz="3200" b="1" kern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r>
                <a:rPr lang="en-US" altLang="zh-CN" sz="3200" b="1" kern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zh-CN" sz="3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O term enrichment analysis </a:t>
              </a:r>
              <a:r>
                <a:rPr lang="en-US" altLang="zh-CN" sz="3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r </a:t>
              </a:r>
              <a:r>
                <a:rPr lang="en-US" altLang="zh-CN" sz="3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 </a:t>
              </a:r>
              <a:r>
                <a:rPr lang="en-US" altLang="zh-CN" sz="3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82 </a:t>
              </a:r>
              <a:r>
                <a:rPr lang="en-US" altLang="zh-CN" sz="3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 cycle regulated genes described by </a:t>
              </a:r>
              <a:r>
                <a:rPr lang="en-US" altLang="zh-CN" sz="3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enges</a:t>
              </a:r>
              <a:r>
                <a:rPr lang="en-US" altLang="zh-CN" sz="3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32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t </a:t>
              </a:r>
              <a:r>
                <a:rPr lang="en-US" altLang="zh-CN" sz="32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l</a:t>
              </a:r>
              <a:r>
                <a:rPr lang="en-US" altLang="zh-CN" sz="3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zh-CN" sz="3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2003) in </a:t>
              </a:r>
              <a:r>
                <a:rPr lang="en-US" altLang="zh-CN" sz="32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rabidopsis</a:t>
              </a:r>
              <a:r>
                <a:rPr lang="en-US" altLang="zh-CN" sz="3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nd 214 </a:t>
              </a:r>
              <a:r>
                <a:rPr lang="en-US" altLang="zh-CN" sz="3200" b="1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etaria</a:t>
              </a:r>
              <a:r>
                <a:rPr lang="en-US" altLang="zh-CN" sz="3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3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omologues differentially </a:t>
              </a:r>
              <a:r>
                <a:rPr lang="en-US" altLang="zh-CN" sz="3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pressed between Yugu1 and </a:t>
              </a:r>
              <a:r>
                <a:rPr lang="en-US" altLang="zh-CN" sz="32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stl1. </a:t>
              </a:r>
              <a:r>
                <a:rPr lang="en-US" altLang="zh-CN" sz="3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  <a:p>
              <a:pPr>
                <a:lnSpc>
                  <a:spcPct val="150000"/>
                </a:lnSpc>
              </a:pPr>
              <a:r>
                <a:rPr lang="en-US" altLang="zh-CN" sz="2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) </a:t>
              </a:r>
              <a:r>
                <a:rPr lang="en-US" altLang="zh-CN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O term enrichment analysis </a:t>
              </a:r>
              <a:r>
                <a:rPr lang="en-US" altLang="zh-CN" sz="2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r </a:t>
              </a:r>
              <a:r>
                <a:rPr lang="en-US" altLang="zh-CN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 </a:t>
              </a:r>
              <a:r>
                <a:rPr lang="en-US" altLang="zh-CN" sz="2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82 </a:t>
              </a:r>
              <a:r>
                <a:rPr lang="en-US" altLang="zh-CN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 </a:t>
              </a:r>
              <a:r>
                <a:rPr lang="en-US" altLang="zh-CN" sz="2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ycle-regulated </a:t>
              </a:r>
              <a:r>
                <a:rPr lang="en-US" altLang="zh-CN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enes described by </a:t>
              </a:r>
              <a:r>
                <a:rPr lang="en-US" altLang="zh-CN" sz="2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enges</a:t>
              </a:r>
              <a:r>
                <a:rPr lang="en-US" altLang="zh-CN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20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t </a:t>
              </a:r>
              <a:r>
                <a:rPr lang="en-US" altLang="zh-CN" sz="20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l</a:t>
              </a:r>
              <a:r>
                <a:rPr lang="en-US" altLang="zh-CN" sz="2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zh-CN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2003) in </a:t>
              </a:r>
              <a:r>
                <a:rPr lang="en-US" altLang="zh-CN" sz="20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rabidopsis</a:t>
              </a:r>
              <a:r>
                <a:rPr lang="en-US" altLang="zh-CN" sz="2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(B</a:t>
              </a:r>
              <a:r>
                <a:rPr lang="en-US" altLang="zh-CN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GO term enrichment analysis </a:t>
              </a:r>
              <a:r>
                <a:rPr lang="en-US" altLang="zh-CN" sz="2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f </a:t>
              </a:r>
              <a:r>
                <a:rPr lang="en-US" altLang="zh-CN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14 </a:t>
              </a:r>
              <a:r>
                <a:rPr lang="en-US" altLang="zh-CN" sz="20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etaria</a:t>
              </a:r>
              <a:r>
                <a:rPr lang="en-US" altLang="zh-CN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2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omologues differentially </a:t>
              </a:r>
              <a:r>
                <a:rPr lang="en-US" altLang="zh-CN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pressed between Yugu1 and </a:t>
              </a:r>
              <a:r>
                <a:rPr lang="en-US" altLang="zh-CN" sz="20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stl1. </a:t>
              </a:r>
              <a:r>
                <a:rPr lang="en-US" altLang="zh-CN" sz="2000" kern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2000" kern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C)</a:t>
              </a:r>
              <a:r>
                <a:rPr lang="en-US" altLang="zh-CN" sz="2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Number of genes down- and up-regulated of each enrich GO term in </a:t>
              </a:r>
              <a:r>
                <a:rPr lang="en-US" altLang="zh-CN" sz="20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stl1</a:t>
              </a:r>
              <a:r>
                <a:rPr lang="en-US" altLang="zh-CN" sz="2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endParaRPr lang="zh-CN" altLang="zh-CN" sz="2000" kern="100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2" name="组合 11"/>
            <p:cNvGrpSpPr/>
            <p:nvPr/>
          </p:nvGrpSpPr>
          <p:grpSpPr>
            <a:xfrm>
              <a:off x="2471708" y="1939569"/>
              <a:ext cx="14278068" cy="17001573"/>
              <a:chOff x="2471708" y="1939569"/>
              <a:chExt cx="14278068" cy="17001573"/>
            </a:xfrm>
          </p:grpSpPr>
          <p:grpSp>
            <p:nvGrpSpPr>
              <p:cNvPr id="10" name="组合 9"/>
              <p:cNvGrpSpPr/>
              <p:nvPr/>
            </p:nvGrpSpPr>
            <p:grpSpPr>
              <a:xfrm>
                <a:off x="2471708" y="1939569"/>
                <a:ext cx="13519156" cy="17001573"/>
                <a:chOff x="2460576" y="1874255"/>
                <a:chExt cx="13519156" cy="17001573"/>
              </a:xfrm>
            </p:grpSpPr>
            <p:pic>
              <p:nvPicPr>
                <p:cNvPr id="3" name="图片 2"/>
                <p:cNvPicPr>
                  <a:picLocks noChangeAspect="1"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460576" y="2453149"/>
                  <a:ext cx="7200000" cy="5979746"/>
                </a:xfrm>
                <a:prstGeom prst="rect">
                  <a:avLst/>
                </a:prstGeom>
              </p:spPr>
            </p:pic>
            <p:graphicFrame>
              <p:nvGraphicFramePr>
                <p:cNvPr id="5" name="图表 4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508603837"/>
                    </p:ext>
                  </p:extLst>
                </p:nvPr>
              </p:nvGraphicFramePr>
              <p:xfrm>
                <a:off x="4474028" y="8955409"/>
                <a:ext cx="11505704" cy="9920419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sp>
              <p:nvSpPr>
                <p:cNvPr id="7" name="文本框 6"/>
                <p:cNvSpPr txBox="1"/>
                <p:nvPr/>
              </p:nvSpPr>
              <p:spPr>
                <a:xfrm>
                  <a:off x="2678842" y="1874255"/>
                  <a:ext cx="416439" cy="5232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2800" b="1" dirty="0">
                      <a:latin typeface="Times New Roman" panose="02020603050405020304" pitchFamily="18" charset="0"/>
                    </a:rPr>
                    <a:t>A</a:t>
                  </a:r>
                  <a:endParaRPr lang="zh-CN" altLang="en-US" sz="2800" b="1" dirty="0">
                    <a:latin typeface="Times New Roman" panose="02020603050405020304" pitchFamily="18" charset="0"/>
                  </a:endParaRPr>
                </a:p>
              </p:txBody>
            </p:sp>
            <p:sp>
              <p:nvSpPr>
                <p:cNvPr id="8" name="文本框 7"/>
                <p:cNvSpPr txBox="1"/>
                <p:nvPr/>
              </p:nvSpPr>
              <p:spPr>
                <a:xfrm>
                  <a:off x="10018660" y="1874255"/>
                  <a:ext cx="416439" cy="5232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2800" b="1" dirty="0" smtClean="0">
                      <a:latin typeface="Times New Roman" panose="02020603050405020304" pitchFamily="18" charset="0"/>
                    </a:rPr>
                    <a:t>B</a:t>
                  </a:r>
                  <a:endParaRPr lang="zh-CN" altLang="en-US" sz="2800" b="1" dirty="0">
                    <a:latin typeface="Times New Roman" panose="02020603050405020304" pitchFamily="18" charset="0"/>
                  </a:endParaRPr>
                </a:p>
              </p:txBody>
            </p:sp>
            <p:sp>
              <p:nvSpPr>
                <p:cNvPr id="9" name="文本框 8"/>
                <p:cNvSpPr txBox="1"/>
                <p:nvPr/>
              </p:nvSpPr>
              <p:spPr>
                <a:xfrm>
                  <a:off x="2678842" y="8955409"/>
                  <a:ext cx="416439" cy="5232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2800" b="1" dirty="0" smtClean="0">
                      <a:latin typeface="Times New Roman" panose="02020603050405020304" pitchFamily="18" charset="0"/>
                    </a:rPr>
                    <a:t>C</a:t>
                  </a:r>
                  <a:endParaRPr lang="zh-CN" altLang="en-US" sz="2800" b="1" dirty="0">
                    <a:latin typeface="Times New Roman" panose="02020603050405020304" pitchFamily="18" charset="0"/>
                  </a:endParaRPr>
                </a:p>
              </p:txBody>
            </p:sp>
          </p:grpSp>
          <p:pic>
            <p:nvPicPr>
              <p:cNvPr id="11" name="图片 10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446231" y="2462789"/>
                <a:ext cx="6303545" cy="5979600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158066308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1379201" y="17803058"/>
            <a:ext cx="17672736" cy="45243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3200" b="1" kern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altLang="zh-CN" sz="3200" b="1" kern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. </a:t>
            </a:r>
            <a:r>
              <a:rPr lang="en-US" altLang="zh-CN" sz="3200" b="1" kern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erifying the relative expression level of </a:t>
            </a:r>
            <a:r>
              <a:rPr lang="en-US" altLang="zh-CN" sz="3200" b="1" i="1" kern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STL1</a:t>
            </a:r>
            <a:r>
              <a:rPr lang="en-US" altLang="zh-CN" sz="3200" b="1" kern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3200" b="1" i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STL1-2</a:t>
            </a:r>
            <a:r>
              <a:rPr lang="en-US" altLang="zh-CN" sz="3200" b="1" kern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3200" b="1" i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STL1-3</a:t>
            </a:r>
            <a:r>
              <a:rPr lang="en-US" altLang="zh-CN" sz="3200" b="1" kern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3200" b="1" i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2F1</a:t>
            </a:r>
            <a:r>
              <a:rPr lang="en-US" altLang="zh-CN" sz="3200" b="1" kern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zh-CN" sz="3200" b="1" i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2F2</a:t>
            </a:r>
            <a:r>
              <a:rPr lang="en-US" altLang="zh-CN" sz="3200" b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ong leaf developmental gradients in Yugu1 and </a:t>
            </a:r>
            <a:r>
              <a:rPr lang="en-US" altLang="zh-CN" sz="3200" b="1" i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stl1</a:t>
            </a:r>
            <a:r>
              <a:rPr lang="en-US" altLang="zh-CN" sz="3200" b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urth leaves with </a:t>
            </a:r>
            <a:r>
              <a:rPr lang="en-US" altLang="zh-CN" sz="3200" b="1" kern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mi-quantitative RT-PCR.</a:t>
            </a:r>
          </a:p>
          <a:p>
            <a:pPr>
              <a:lnSpc>
                <a:spcPct val="150000"/>
              </a:lnSpc>
            </a:pPr>
            <a:r>
              <a:rPr lang="en-US" altLang="zh-CN" sz="2400" dirty="0">
                <a:latin typeface="Times New Roman" panose="02020603050405020304" pitchFamily="18" charset="0"/>
              </a:rPr>
              <a:t>(A–C) Expression patterns of </a:t>
            </a:r>
            <a:r>
              <a:rPr lang="en-US" altLang="zh-CN" sz="2400" i="1" dirty="0">
                <a:latin typeface="Times New Roman" panose="02020603050405020304" pitchFamily="18" charset="0"/>
              </a:rPr>
              <a:t>SiSTL1</a:t>
            </a:r>
            <a:r>
              <a:rPr lang="en-US" altLang="zh-CN" sz="2400" dirty="0">
                <a:latin typeface="Times New Roman" panose="02020603050405020304" pitchFamily="18" charset="0"/>
              </a:rPr>
              <a:t> (A), </a:t>
            </a:r>
            <a:r>
              <a:rPr lang="en-US" altLang="zh-CN" sz="2400" i="1" dirty="0">
                <a:latin typeface="Times New Roman" panose="02020603050405020304" pitchFamily="18" charset="0"/>
              </a:rPr>
              <a:t>SiSTL1-2</a:t>
            </a:r>
            <a:r>
              <a:rPr lang="en-US" altLang="zh-CN" sz="2400" dirty="0">
                <a:latin typeface="Times New Roman" panose="02020603050405020304" pitchFamily="18" charset="0"/>
              </a:rPr>
              <a:t> (B) and </a:t>
            </a:r>
            <a:r>
              <a:rPr lang="en-US" altLang="zh-CN" sz="2400" i="1" dirty="0">
                <a:latin typeface="Times New Roman" panose="02020603050405020304" pitchFamily="18" charset="0"/>
              </a:rPr>
              <a:t>SiSTL1-3 </a:t>
            </a:r>
            <a:r>
              <a:rPr lang="en-US" altLang="zh-CN" sz="2400" dirty="0">
                <a:latin typeface="Times New Roman" panose="02020603050405020304" pitchFamily="18" charset="0"/>
              </a:rPr>
              <a:t>(C) along leaf developmental gradients in Yugu1 </a:t>
            </a:r>
            <a:r>
              <a:rPr lang="en-US" altLang="zh-CN" sz="2400" dirty="0" smtClean="0">
                <a:latin typeface="Times New Roman" panose="02020603050405020304" pitchFamily="18" charset="0"/>
              </a:rPr>
              <a:t>fourth </a:t>
            </a:r>
            <a:r>
              <a:rPr lang="en-US" altLang="zh-CN" sz="2400" dirty="0">
                <a:latin typeface="Times New Roman" panose="02020603050405020304" pitchFamily="18" charset="0"/>
              </a:rPr>
              <a:t>leaves. LB, basic 1-cm region above the fourth leaf sheath; LMB, 1-cm region beneath the third leaf sheath; LMA, 1-cm region above the third leaf sheath; LA, 1-cm region beneath the leaf tip. Error bars, ±SD (n=3). (D) </a:t>
            </a:r>
            <a:r>
              <a:rPr lang="en-US" altLang="zh-CN" sz="2400" dirty="0" smtClean="0">
                <a:latin typeface="Times New Roman" panose="02020603050405020304" pitchFamily="18" charset="0"/>
              </a:rPr>
              <a:t>Relative expression levels </a:t>
            </a:r>
            <a:r>
              <a:rPr lang="en-US" altLang="zh-CN" sz="2400" dirty="0">
                <a:latin typeface="Times New Roman" panose="02020603050405020304" pitchFamily="18" charset="0"/>
              </a:rPr>
              <a:t>of</a:t>
            </a:r>
            <a:r>
              <a:rPr lang="en-US" altLang="zh-CN" sz="2400" i="1" dirty="0">
                <a:latin typeface="Times New Roman" panose="02020603050405020304" pitchFamily="18" charset="0"/>
              </a:rPr>
              <a:t> </a:t>
            </a:r>
            <a:r>
              <a:rPr lang="en-US" altLang="zh-CN" sz="2400" i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STL1</a:t>
            </a:r>
            <a:r>
              <a:rPr lang="en-US" altLang="zh-CN" sz="24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2400" i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STL1-2</a:t>
            </a:r>
            <a:r>
              <a:rPr lang="en-US" altLang="zh-CN" sz="24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2400" i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STL1-3</a:t>
            </a:r>
            <a:r>
              <a:rPr lang="en-US" altLang="zh-CN" sz="24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2400" i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2F1</a:t>
            </a:r>
            <a:r>
              <a:rPr lang="en-US" altLang="zh-CN" sz="24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zh-CN" sz="2400" i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2F2 </a:t>
            </a:r>
            <a:r>
              <a:rPr lang="en-US" altLang="zh-CN" sz="2400" dirty="0" smtClean="0">
                <a:latin typeface="Times New Roman" panose="02020603050405020304" pitchFamily="18" charset="0"/>
              </a:rPr>
              <a:t>in </a:t>
            </a:r>
            <a:r>
              <a:rPr lang="en-US" altLang="zh-CN" sz="2400" dirty="0">
                <a:latin typeface="Times New Roman" panose="02020603050405020304" pitchFamily="18" charset="0"/>
              </a:rPr>
              <a:t>Yugu1 and </a:t>
            </a:r>
            <a:r>
              <a:rPr lang="en-US" altLang="zh-CN" sz="2400" i="1" dirty="0">
                <a:latin typeface="Times New Roman" panose="02020603050405020304" pitchFamily="18" charset="0"/>
              </a:rPr>
              <a:t>sistl1 </a:t>
            </a:r>
            <a:r>
              <a:rPr lang="en-US" altLang="zh-CN" sz="2400" dirty="0">
                <a:latin typeface="Times New Roman" panose="02020603050405020304" pitchFamily="18" charset="0"/>
              </a:rPr>
              <a:t>fourth-leaf bases</a:t>
            </a:r>
            <a:r>
              <a:rPr lang="en-US" altLang="zh-CN" sz="2400" dirty="0" smtClean="0">
                <a:latin typeface="Times New Roman" panose="02020603050405020304" pitchFamily="18" charset="0"/>
              </a:rPr>
              <a:t>. Error bars, ±SD (n=3).</a:t>
            </a:r>
            <a:endParaRPr lang="en-US" altLang="zh-CN" sz="3200" kern="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0" name="组合 59"/>
          <p:cNvGrpSpPr/>
          <p:nvPr/>
        </p:nvGrpSpPr>
        <p:grpSpPr>
          <a:xfrm>
            <a:off x="1170982" y="3428428"/>
            <a:ext cx="5639320" cy="5674750"/>
            <a:chOff x="2300832" y="3921611"/>
            <a:chExt cx="5639320" cy="5674750"/>
          </a:xfrm>
        </p:grpSpPr>
        <p:grpSp>
          <p:nvGrpSpPr>
            <p:cNvPr id="3" name="组合 2"/>
            <p:cNvGrpSpPr/>
            <p:nvPr/>
          </p:nvGrpSpPr>
          <p:grpSpPr>
            <a:xfrm>
              <a:off x="2846319" y="3921611"/>
              <a:ext cx="5093833" cy="5674750"/>
              <a:chOff x="2029891" y="-389132"/>
              <a:chExt cx="5093833" cy="5674750"/>
            </a:xfrm>
          </p:grpSpPr>
          <p:pic>
            <p:nvPicPr>
              <p:cNvPr id="4" name="图片 3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341526" y="3942921"/>
                <a:ext cx="3600000" cy="630000"/>
              </a:xfrm>
              <a:prstGeom prst="rect">
                <a:avLst/>
              </a:prstGeom>
            </p:spPr>
          </p:pic>
          <p:pic>
            <p:nvPicPr>
              <p:cNvPr id="5" name="图片 4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335587" y="4617144"/>
                <a:ext cx="3600000" cy="604919"/>
              </a:xfrm>
              <a:prstGeom prst="rect">
                <a:avLst/>
              </a:prstGeom>
            </p:spPr>
          </p:pic>
          <p:graphicFrame>
            <p:nvGraphicFramePr>
              <p:cNvPr id="6" name="图表 5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208263051"/>
                  </p:ext>
                </p:extLst>
              </p:nvPr>
            </p:nvGraphicFramePr>
            <p:xfrm>
              <a:off x="2684719" y="-389132"/>
              <a:ext cx="4439005" cy="425071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7" name="文本框 6"/>
              <p:cNvSpPr txBox="1"/>
              <p:nvPr/>
            </p:nvSpPr>
            <p:spPr>
              <a:xfrm rot="10800000">
                <a:off x="2029891" y="-225682"/>
                <a:ext cx="553998" cy="360371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2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 expression level </a:t>
                </a:r>
                <a:endParaRPr lang="zh-CN" altLang="en-US" sz="2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" name="文本框 7"/>
              <p:cNvSpPr txBox="1"/>
              <p:nvPr/>
            </p:nvSpPr>
            <p:spPr>
              <a:xfrm rot="16200000">
                <a:off x="2351362" y="3541871"/>
                <a:ext cx="800219" cy="1337049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2000" b="1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iSTL1</a:t>
                </a:r>
              </a:p>
              <a:p>
                <a:r>
                  <a:rPr lang="en-US" altLang="zh-CN" sz="2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35 cycles)</a:t>
                </a:r>
                <a:endParaRPr lang="zh-CN" alt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文本框 8"/>
              <p:cNvSpPr txBox="1"/>
              <p:nvPr/>
            </p:nvSpPr>
            <p:spPr>
              <a:xfrm rot="16200000">
                <a:off x="2294575" y="4252614"/>
                <a:ext cx="800219" cy="1265790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2000" b="1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tin</a:t>
                </a:r>
              </a:p>
              <a:p>
                <a:r>
                  <a:rPr lang="en-US" altLang="zh-CN" sz="2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33 cycles)</a:t>
                </a:r>
                <a:endParaRPr lang="zh-CN" alt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56" name="文本框 55"/>
            <p:cNvSpPr txBox="1"/>
            <p:nvPr/>
          </p:nvSpPr>
          <p:spPr>
            <a:xfrm>
              <a:off x="2300832" y="8242902"/>
              <a:ext cx="41643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800" b="1" dirty="0">
                  <a:latin typeface="Times New Roman" panose="02020603050405020304" pitchFamily="18" charset="0"/>
                </a:rPr>
                <a:t>A</a:t>
              </a:r>
              <a:endParaRPr lang="zh-CN" altLang="en-US" sz="2800" b="1" dirty="0">
                <a:latin typeface="Times New Roman" panose="02020603050405020304" pitchFamily="18" charset="0"/>
              </a:endParaRPr>
            </a:p>
          </p:txBody>
        </p:sp>
      </p:grpSp>
      <p:grpSp>
        <p:nvGrpSpPr>
          <p:cNvPr id="70" name="组合 69"/>
          <p:cNvGrpSpPr/>
          <p:nvPr/>
        </p:nvGrpSpPr>
        <p:grpSpPr>
          <a:xfrm>
            <a:off x="7062640" y="3262407"/>
            <a:ext cx="5554318" cy="5840773"/>
            <a:chOff x="7384634" y="2641923"/>
            <a:chExt cx="5554318" cy="5840773"/>
          </a:xfrm>
        </p:grpSpPr>
        <p:grpSp>
          <p:nvGrpSpPr>
            <p:cNvPr id="10" name="组合 9"/>
            <p:cNvGrpSpPr/>
            <p:nvPr/>
          </p:nvGrpSpPr>
          <p:grpSpPr>
            <a:xfrm>
              <a:off x="8065625" y="2641923"/>
              <a:ext cx="4873327" cy="5840773"/>
              <a:chOff x="7262734" y="-385080"/>
              <a:chExt cx="4469074" cy="5432191"/>
            </a:xfrm>
          </p:grpSpPr>
          <p:pic>
            <p:nvPicPr>
              <p:cNvPr id="11" name="图片 10"/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430436" y="3820774"/>
                <a:ext cx="3301372" cy="507905"/>
              </a:xfrm>
              <a:prstGeom prst="rect">
                <a:avLst/>
              </a:prstGeom>
            </p:spPr>
          </p:pic>
          <p:grpSp>
            <p:nvGrpSpPr>
              <p:cNvPr id="12" name="组合 11"/>
              <p:cNvGrpSpPr/>
              <p:nvPr/>
            </p:nvGrpSpPr>
            <p:grpSpPr>
              <a:xfrm>
                <a:off x="7262734" y="-385080"/>
                <a:ext cx="4469074" cy="5432191"/>
                <a:chOff x="6190069" y="-322192"/>
                <a:chExt cx="4469074" cy="5432191"/>
              </a:xfrm>
            </p:grpSpPr>
            <p:graphicFrame>
              <p:nvGraphicFramePr>
                <p:cNvPr id="13" name="图表 12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144838293"/>
                    </p:ext>
                  </p:extLst>
                </p:nvPr>
              </p:nvGraphicFramePr>
              <p:xfrm>
                <a:off x="6916578" y="-322192"/>
                <a:ext cx="3729736" cy="4320879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6"/>
                </a:graphicData>
              </a:graphic>
            </p:graphicFrame>
            <p:pic>
              <p:nvPicPr>
                <p:cNvPr id="14" name="图片 13"/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357771" y="4447156"/>
                  <a:ext cx="3301372" cy="554739"/>
                </a:xfrm>
                <a:prstGeom prst="rect">
                  <a:avLst/>
                </a:prstGeom>
              </p:spPr>
            </p:pic>
            <p:sp>
              <p:nvSpPr>
                <p:cNvPr id="15" name="文本框 14"/>
                <p:cNvSpPr txBox="1"/>
                <p:nvPr/>
              </p:nvSpPr>
              <p:spPr>
                <a:xfrm rot="10800000">
                  <a:off x="6277489" y="-173472"/>
                  <a:ext cx="508043" cy="3546287"/>
                </a:xfrm>
                <a:prstGeom prst="rect">
                  <a:avLst/>
                </a:prstGeom>
                <a:noFill/>
              </p:spPr>
              <p:txBody>
                <a:bodyPr vert="eaVert" wrap="square" rtlCol="0">
                  <a:spAutoFit/>
                </a:bodyPr>
                <a:lstStyle/>
                <a:p>
                  <a:r>
                    <a:rPr lang="en-US" altLang="zh-CN" sz="2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elative expression level </a:t>
                  </a:r>
                  <a:endParaRPr lang="zh-CN" altLang="en-US" sz="24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" name="文本框 15"/>
                <p:cNvSpPr txBox="1"/>
                <p:nvPr/>
              </p:nvSpPr>
              <p:spPr>
                <a:xfrm rot="16200000">
                  <a:off x="6410837" y="3601842"/>
                  <a:ext cx="744241" cy="1149630"/>
                </a:xfrm>
                <a:prstGeom prst="rect">
                  <a:avLst/>
                </a:prstGeom>
                <a:noFill/>
              </p:spPr>
              <p:txBody>
                <a:bodyPr vert="eaVert" wrap="square" rtlCol="0">
                  <a:spAutoFit/>
                </a:bodyPr>
                <a:lstStyle/>
                <a:p>
                  <a:r>
                    <a:rPr lang="en-US" altLang="zh-CN" sz="2000" b="1" i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iSTL1-2</a:t>
                  </a:r>
                </a:p>
                <a:p>
                  <a:r>
                    <a:rPr lang="en-US" altLang="zh-CN" sz="20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(35 cycles)</a:t>
                  </a:r>
                  <a:endParaRPr lang="zh-CN" altLang="en-US" sz="2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" name="文本框 16"/>
                <p:cNvSpPr txBox="1"/>
                <p:nvPr/>
              </p:nvSpPr>
              <p:spPr>
                <a:xfrm rot="16200000">
                  <a:off x="6392050" y="4163777"/>
                  <a:ext cx="744241" cy="1148203"/>
                </a:xfrm>
                <a:prstGeom prst="rect">
                  <a:avLst/>
                </a:prstGeom>
                <a:noFill/>
              </p:spPr>
              <p:txBody>
                <a:bodyPr vert="eaVert" wrap="square" rtlCol="0">
                  <a:spAutoFit/>
                </a:bodyPr>
                <a:lstStyle/>
                <a:p>
                  <a:r>
                    <a:rPr lang="en-US" altLang="zh-CN" sz="2000" b="1" i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ctin</a:t>
                  </a:r>
                </a:p>
                <a:p>
                  <a:r>
                    <a:rPr lang="en-US" altLang="zh-CN" sz="20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(33 cycles)</a:t>
                  </a:r>
                  <a:endParaRPr lang="zh-CN" altLang="en-US" sz="2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57" name="文本框 56"/>
            <p:cNvSpPr txBox="1"/>
            <p:nvPr/>
          </p:nvSpPr>
          <p:spPr>
            <a:xfrm>
              <a:off x="7384634" y="7127128"/>
              <a:ext cx="41643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800" b="1" dirty="0" smtClean="0">
                  <a:latin typeface="Times New Roman" panose="02020603050405020304" pitchFamily="18" charset="0"/>
                </a:rPr>
                <a:t>B</a:t>
              </a:r>
              <a:endParaRPr lang="zh-CN" altLang="en-US" sz="2800" b="1" dirty="0">
                <a:latin typeface="Times New Roman" panose="02020603050405020304" pitchFamily="18" charset="0"/>
              </a:endParaRPr>
            </a:p>
          </p:txBody>
        </p:sp>
      </p:grpSp>
      <p:grpSp>
        <p:nvGrpSpPr>
          <p:cNvPr id="71" name="组合 70"/>
          <p:cNvGrpSpPr/>
          <p:nvPr/>
        </p:nvGrpSpPr>
        <p:grpSpPr>
          <a:xfrm>
            <a:off x="13420054" y="3098414"/>
            <a:ext cx="5489393" cy="6042417"/>
            <a:chOff x="13420054" y="2477931"/>
            <a:chExt cx="5489393" cy="6042417"/>
          </a:xfrm>
        </p:grpSpPr>
        <p:grpSp>
          <p:nvGrpSpPr>
            <p:cNvPr id="18" name="组合 17"/>
            <p:cNvGrpSpPr/>
            <p:nvPr/>
          </p:nvGrpSpPr>
          <p:grpSpPr>
            <a:xfrm>
              <a:off x="13840205" y="2477931"/>
              <a:ext cx="5069242" cy="6042417"/>
              <a:chOff x="8803724" y="-397018"/>
              <a:chExt cx="4291895" cy="5115839"/>
            </a:xfrm>
          </p:grpSpPr>
          <p:grpSp>
            <p:nvGrpSpPr>
              <p:cNvPr id="19" name="组合 18"/>
              <p:cNvGrpSpPr/>
              <p:nvPr/>
            </p:nvGrpSpPr>
            <p:grpSpPr>
              <a:xfrm>
                <a:off x="9575781" y="-397018"/>
                <a:ext cx="3519838" cy="5030150"/>
                <a:chOff x="7977061" y="-114932"/>
                <a:chExt cx="3519838" cy="5030150"/>
              </a:xfrm>
            </p:grpSpPr>
            <p:pic>
              <p:nvPicPr>
                <p:cNvPr id="23" name="图片 22"/>
                <p:cNvPicPr>
                  <a:picLocks noChangeAspect="1"/>
                </p:cNvPicPr>
                <p:nvPr/>
              </p:nvPicPr>
              <p:blipFill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448943" y="3842536"/>
                  <a:ext cx="3047956" cy="533392"/>
                </a:xfrm>
                <a:prstGeom prst="rect">
                  <a:avLst/>
                </a:prstGeom>
              </p:spPr>
            </p:pic>
            <p:graphicFrame>
              <p:nvGraphicFramePr>
                <p:cNvPr id="24" name="图表 23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967039196"/>
                    </p:ext>
                  </p:extLst>
                </p:nvPr>
              </p:nvGraphicFramePr>
              <p:xfrm>
                <a:off x="7977061" y="-114932"/>
                <a:ext cx="3519838" cy="383138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8"/>
                </a:graphicData>
              </a:graphic>
            </p:graphicFrame>
            <p:pic>
              <p:nvPicPr>
                <p:cNvPr id="25" name="图片 24"/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448943" y="4403061"/>
                  <a:ext cx="3047956" cy="512157"/>
                </a:xfrm>
                <a:prstGeom prst="rect">
                  <a:avLst/>
                </a:prstGeom>
              </p:spPr>
            </p:pic>
          </p:grpSp>
          <p:sp>
            <p:nvSpPr>
              <p:cNvPr id="20" name="文本框 19"/>
              <p:cNvSpPr txBox="1"/>
              <p:nvPr/>
            </p:nvSpPr>
            <p:spPr>
              <a:xfrm rot="10800000">
                <a:off x="8803724" y="156684"/>
                <a:ext cx="469045" cy="2926064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2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 expression level </a:t>
                </a:r>
                <a:endParaRPr lang="zh-CN" altLang="en-US" sz="2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文本框 20"/>
              <p:cNvSpPr txBox="1"/>
              <p:nvPr/>
            </p:nvSpPr>
            <p:spPr>
              <a:xfrm rot="16200000">
                <a:off x="9261777" y="3200114"/>
                <a:ext cx="677509" cy="1172614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2000" b="1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iSTL1-3</a:t>
                </a:r>
              </a:p>
              <a:p>
                <a:r>
                  <a:rPr lang="en-US" altLang="zh-CN" sz="2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35 cycles)</a:t>
                </a:r>
                <a:endParaRPr lang="zh-CN" alt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文本框 21"/>
              <p:cNvSpPr txBox="1"/>
              <p:nvPr/>
            </p:nvSpPr>
            <p:spPr>
              <a:xfrm rot="16200000">
                <a:off x="9252775" y="3793760"/>
                <a:ext cx="677509" cy="1172614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2000" b="1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tin</a:t>
                </a:r>
              </a:p>
              <a:p>
                <a:r>
                  <a:rPr lang="en-US" altLang="zh-CN" sz="2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33 cycles)</a:t>
                </a:r>
                <a:endParaRPr lang="zh-CN" alt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58" name="文本框 57"/>
            <p:cNvSpPr txBox="1"/>
            <p:nvPr/>
          </p:nvSpPr>
          <p:spPr>
            <a:xfrm>
              <a:off x="13420054" y="7127128"/>
              <a:ext cx="41643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800" b="1" dirty="0" smtClean="0">
                  <a:latin typeface="Times New Roman" panose="02020603050405020304" pitchFamily="18" charset="0"/>
                </a:rPr>
                <a:t>C</a:t>
              </a:r>
              <a:endParaRPr lang="zh-CN" altLang="en-US" sz="2800" b="1" dirty="0">
                <a:latin typeface="Times New Roman" panose="02020603050405020304" pitchFamily="18" charset="0"/>
              </a:endParaRPr>
            </a:p>
          </p:txBody>
        </p:sp>
      </p:grpSp>
      <p:grpSp>
        <p:nvGrpSpPr>
          <p:cNvPr id="61" name="组合 60"/>
          <p:cNvGrpSpPr/>
          <p:nvPr/>
        </p:nvGrpSpPr>
        <p:grpSpPr>
          <a:xfrm>
            <a:off x="1170982" y="10080900"/>
            <a:ext cx="7549540" cy="7207379"/>
            <a:chOff x="2479189" y="8672066"/>
            <a:chExt cx="7549540" cy="7207379"/>
          </a:xfrm>
        </p:grpSpPr>
        <p:grpSp>
          <p:nvGrpSpPr>
            <p:cNvPr id="26" name="组合 25"/>
            <p:cNvGrpSpPr/>
            <p:nvPr/>
          </p:nvGrpSpPr>
          <p:grpSpPr>
            <a:xfrm>
              <a:off x="3310550" y="8672066"/>
              <a:ext cx="6718179" cy="7207379"/>
              <a:chOff x="0" y="2178028"/>
              <a:chExt cx="5687975" cy="6102161"/>
            </a:xfrm>
          </p:grpSpPr>
          <p:grpSp>
            <p:nvGrpSpPr>
              <p:cNvPr id="27" name="组合 26"/>
              <p:cNvGrpSpPr/>
              <p:nvPr/>
            </p:nvGrpSpPr>
            <p:grpSpPr>
              <a:xfrm>
                <a:off x="531965" y="2178028"/>
                <a:ext cx="5156010" cy="4049037"/>
                <a:chOff x="531965" y="2178028"/>
                <a:chExt cx="5156010" cy="4049037"/>
              </a:xfrm>
            </p:grpSpPr>
            <p:graphicFrame>
              <p:nvGraphicFramePr>
                <p:cNvPr id="53" name="图表 52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9020559"/>
                    </p:ext>
                  </p:extLst>
                </p:nvPr>
              </p:nvGraphicFramePr>
              <p:xfrm>
                <a:off x="1115975" y="2178028"/>
                <a:ext cx="4572000" cy="4049037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9"/>
                </a:graphicData>
              </a:graphic>
            </p:graphicFrame>
            <p:sp>
              <p:nvSpPr>
                <p:cNvPr id="54" name="文本框 53"/>
                <p:cNvSpPr txBox="1"/>
                <p:nvPr/>
              </p:nvSpPr>
              <p:spPr>
                <a:xfrm rot="10800000">
                  <a:off x="531965" y="2648421"/>
                  <a:ext cx="469045" cy="3144577"/>
                </a:xfrm>
                <a:prstGeom prst="rect">
                  <a:avLst/>
                </a:prstGeom>
                <a:noFill/>
              </p:spPr>
              <p:txBody>
                <a:bodyPr vert="eaVert" wrap="square" rtlCol="0">
                  <a:spAutoFit/>
                </a:bodyPr>
                <a:lstStyle/>
                <a:p>
                  <a:r>
                    <a:rPr lang="en-US" altLang="zh-CN" sz="2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elative expression level </a:t>
                  </a:r>
                  <a:endParaRPr lang="zh-CN" altLang="en-US" sz="24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28" name="组合 27"/>
              <p:cNvGrpSpPr/>
              <p:nvPr/>
            </p:nvGrpSpPr>
            <p:grpSpPr>
              <a:xfrm>
                <a:off x="0" y="6502299"/>
                <a:ext cx="5641041" cy="1777890"/>
                <a:chOff x="70243" y="6418381"/>
                <a:chExt cx="5641041" cy="1777890"/>
              </a:xfrm>
            </p:grpSpPr>
            <p:sp>
              <p:nvSpPr>
                <p:cNvPr id="30" name="文本框 29"/>
                <p:cNvSpPr txBox="1"/>
                <p:nvPr/>
              </p:nvSpPr>
              <p:spPr>
                <a:xfrm rot="16200000">
                  <a:off x="304164" y="6742968"/>
                  <a:ext cx="416929" cy="884771"/>
                </a:xfrm>
                <a:prstGeom prst="rect">
                  <a:avLst/>
                </a:prstGeom>
                <a:noFill/>
              </p:spPr>
              <p:txBody>
                <a:bodyPr vert="eaVert" wrap="square" rtlCol="0">
                  <a:spAutoFit/>
                </a:bodyPr>
                <a:lstStyle/>
                <a:p>
                  <a:r>
                    <a:rPr lang="en-US" altLang="zh-CN" sz="2000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istl1</a:t>
                  </a:r>
                  <a:endParaRPr lang="zh-CN" altLang="en-US" sz="20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1" name="文本框 30"/>
                <p:cNvSpPr txBox="1"/>
                <p:nvPr/>
              </p:nvSpPr>
              <p:spPr>
                <a:xfrm rot="16200000">
                  <a:off x="245022" y="6243603"/>
                  <a:ext cx="416929" cy="766486"/>
                </a:xfrm>
                <a:prstGeom prst="rect">
                  <a:avLst/>
                </a:prstGeom>
                <a:noFill/>
              </p:spPr>
              <p:txBody>
                <a:bodyPr vert="eaVert" wrap="square" rtlCol="0">
                  <a:spAutoFit/>
                </a:bodyPr>
                <a:lstStyle/>
                <a:p>
                  <a:r>
                    <a:rPr lang="en-US" altLang="zh-CN" sz="2000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Yugu1</a:t>
                  </a:r>
                  <a:endParaRPr lang="zh-CN" altLang="en-US" sz="20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32" name="组合 31"/>
                <p:cNvGrpSpPr/>
                <p:nvPr/>
              </p:nvGrpSpPr>
              <p:grpSpPr>
                <a:xfrm>
                  <a:off x="852087" y="7373581"/>
                  <a:ext cx="4859197" cy="822690"/>
                  <a:chOff x="852087" y="7373581"/>
                  <a:chExt cx="4859197" cy="822690"/>
                </a:xfrm>
              </p:grpSpPr>
              <p:sp>
                <p:nvSpPr>
                  <p:cNvPr id="33" name="文本框 32"/>
                  <p:cNvSpPr txBox="1"/>
                  <p:nvPr/>
                </p:nvSpPr>
                <p:spPr>
                  <a:xfrm rot="16200000">
                    <a:off x="995756" y="7229912"/>
                    <a:ext cx="469045" cy="756384"/>
                  </a:xfrm>
                  <a:prstGeom prst="rect">
                    <a:avLst/>
                  </a:prstGeom>
                  <a:noFill/>
                </p:spPr>
                <p:txBody>
                  <a:bodyPr vert="eaVert" wrap="square" rtlCol="0">
                    <a:spAutoFit/>
                  </a:bodyPr>
                  <a:lstStyle/>
                  <a:p>
                    <a:r>
                      <a:rPr lang="en-US" altLang="zh-CN" sz="2400" b="1" i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ctin</a:t>
                    </a:r>
                  </a:p>
                </p:txBody>
              </p:sp>
              <p:sp>
                <p:nvSpPr>
                  <p:cNvPr id="34" name="文本框 33"/>
                  <p:cNvSpPr txBox="1"/>
                  <p:nvPr/>
                </p:nvSpPr>
                <p:spPr>
                  <a:xfrm rot="16200000">
                    <a:off x="1711629" y="7420967"/>
                    <a:ext cx="781741" cy="768868"/>
                  </a:xfrm>
                  <a:prstGeom prst="rect">
                    <a:avLst/>
                  </a:prstGeom>
                  <a:noFill/>
                </p:spPr>
                <p:txBody>
                  <a:bodyPr vert="eaVert" wrap="square" rtlCol="0">
                    <a:spAutoFit/>
                  </a:bodyPr>
                  <a:lstStyle/>
                  <a:p>
                    <a:r>
                      <a:rPr lang="en-US" altLang="zh-CN" sz="2000" b="1" i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iSTL1     </a:t>
                    </a:r>
                  </a:p>
                </p:txBody>
              </p:sp>
              <p:sp>
                <p:nvSpPr>
                  <p:cNvPr id="35" name="文本框 34"/>
                  <p:cNvSpPr txBox="1"/>
                  <p:nvPr/>
                </p:nvSpPr>
                <p:spPr>
                  <a:xfrm rot="16200000">
                    <a:off x="2802492" y="7079110"/>
                    <a:ext cx="416929" cy="1074091"/>
                  </a:xfrm>
                  <a:prstGeom prst="rect">
                    <a:avLst/>
                  </a:prstGeom>
                  <a:noFill/>
                </p:spPr>
                <p:txBody>
                  <a:bodyPr vert="eaVert" wrap="square" rtlCol="0">
                    <a:spAutoFit/>
                  </a:bodyPr>
                  <a:lstStyle/>
                  <a:p>
                    <a:r>
                      <a:rPr lang="en-US" altLang="zh-CN" sz="2000" b="1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iSTL1-2</a:t>
                    </a:r>
                    <a:endParaRPr lang="zh-CN" altLang="en-US" sz="2000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6" name="文本框 35"/>
                  <p:cNvSpPr txBox="1"/>
                  <p:nvPr/>
                </p:nvSpPr>
                <p:spPr>
                  <a:xfrm rot="16200000">
                    <a:off x="3716821" y="7090799"/>
                    <a:ext cx="416929" cy="1049030"/>
                  </a:xfrm>
                  <a:prstGeom prst="rect">
                    <a:avLst/>
                  </a:prstGeom>
                  <a:noFill/>
                </p:spPr>
                <p:txBody>
                  <a:bodyPr vert="eaVert" wrap="square" rtlCol="0">
                    <a:spAutoFit/>
                  </a:bodyPr>
                  <a:lstStyle/>
                  <a:p>
                    <a:r>
                      <a:rPr lang="en-US" altLang="zh-CN" sz="2000" b="1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iSTL1-3</a:t>
                    </a:r>
                    <a:endParaRPr lang="zh-CN" altLang="en-US" sz="2000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7" name="文本框 36"/>
                  <p:cNvSpPr txBox="1"/>
                  <p:nvPr/>
                </p:nvSpPr>
                <p:spPr>
                  <a:xfrm rot="16200000">
                    <a:off x="4431192" y="7324457"/>
                    <a:ext cx="416929" cy="581719"/>
                  </a:xfrm>
                  <a:prstGeom prst="rect">
                    <a:avLst/>
                  </a:prstGeom>
                  <a:noFill/>
                </p:spPr>
                <p:txBody>
                  <a:bodyPr vert="eaVert" wrap="square" rtlCol="0">
                    <a:spAutoFit/>
                  </a:bodyPr>
                  <a:lstStyle/>
                  <a:p>
                    <a:r>
                      <a:rPr lang="en-US" altLang="zh-CN" sz="2000" b="1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E2F1</a:t>
                    </a:r>
                    <a:endParaRPr lang="zh-CN" altLang="en-US" sz="2000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8" name="文本框 37"/>
                  <p:cNvSpPr txBox="1"/>
                  <p:nvPr/>
                </p:nvSpPr>
                <p:spPr>
                  <a:xfrm rot="16200000">
                    <a:off x="5182704" y="7295200"/>
                    <a:ext cx="416929" cy="640231"/>
                  </a:xfrm>
                  <a:prstGeom prst="rect">
                    <a:avLst/>
                  </a:prstGeom>
                  <a:noFill/>
                </p:spPr>
                <p:txBody>
                  <a:bodyPr vert="eaVert" wrap="square" rtlCol="0">
                    <a:spAutoFit/>
                  </a:bodyPr>
                  <a:lstStyle/>
                  <a:p>
                    <a:r>
                      <a:rPr lang="en-US" altLang="zh-CN" sz="2000" b="1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E2F2</a:t>
                    </a:r>
                    <a:endParaRPr lang="zh-CN" altLang="en-US" sz="2000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</p:grpSp>
        </p:grpSp>
        <p:sp>
          <p:nvSpPr>
            <p:cNvPr id="59" name="文本框 58"/>
            <p:cNvSpPr txBox="1"/>
            <p:nvPr/>
          </p:nvSpPr>
          <p:spPr>
            <a:xfrm>
              <a:off x="2479189" y="13689016"/>
              <a:ext cx="41643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800" b="1" dirty="0" smtClean="0">
                  <a:latin typeface="Times New Roman" panose="02020603050405020304" pitchFamily="18" charset="0"/>
                </a:rPr>
                <a:t>D</a:t>
              </a:r>
              <a:endParaRPr lang="zh-CN" altLang="en-US" sz="2800" b="1" dirty="0">
                <a:latin typeface="Times New Roman" panose="02020603050405020304" pitchFamily="18" charset="0"/>
              </a:endParaRPr>
            </a:p>
          </p:txBody>
        </p:sp>
      </p:grpSp>
      <p:sp>
        <p:nvSpPr>
          <p:cNvPr id="63" name="文本框 62"/>
          <p:cNvSpPr txBox="1"/>
          <p:nvPr/>
        </p:nvSpPr>
        <p:spPr>
          <a:xfrm>
            <a:off x="4323548" y="12740669"/>
            <a:ext cx="620485" cy="5207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800" b="1" dirty="0" smtClean="0">
                <a:solidFill>
                  <a:srgbClr val="FF0000"/>
                </a:solidFill>
              </a:rPr>
              <a:t>**</a:t>
            </a:r>
            <a:endParaRPr lang="zh-CN" altLang="en-US" sz="2800" b="1" dirty="0">
              <a:solidFill>
                <a:srgbClr val="FF0000"/>
              </a:solidFill>
            </a:endParaRPr>
          </a:p>
        </p:txBody>
      </p:sp>
      <p:sp>
        <p:nvSpPr>
          <p:cNvPr id="64" name="文本框 63"/>
          <p:cNvSpPr txBox="1"/>
          <p:nvPr/>
        </p:nvSpPr>
        <p:spPr>
          <a:xfrm>
            <a:off x="5292377" y="13522710"/>
            <a:ext cx="620485" cy="5207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800" b="1" dirty="0" smtClean="0">
                <a:solidFill>
                  <a:srgbClr val="FF0000"/>
                </a:solidFill>
              </a:rPr>
              <a:t>**</a:t>
            </a:r>
            <a:endParaRPr lang="zh-CN" altLang="en-US" sz="2800" b="1" dirty="0">
              <a:solidFill>
                <a:srgbClr val="FF0000"/>
              </a:solidFill>
            </a:endParaRPr>
          </a:p>
        </p:txBody>
      </p:sp>
      <p:sp>
        <p:nvSpPr>
          <p:cNvPr id="65" name="文本框 64"/>
          <p:cNvSpPr txBox="1"/>
          <p:nvPr/>
        </p:nvSpPr>
        <p:spPr>
          <a:xfrm>
            <a:off x="7219148" y="13489187"/>
            <a:ext cx="620485" cy="5207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800" b="1" dirty="0" smtClean="0">
                <a:solidFill>
                  <a:srgbClr val="FF0000"/>
                </a:solidFill>
              </a:rPr>
              <a:t>**</a:t>
            </a:r>
            <a:endParaRPr lang="zh-CN" altLang="en-US" sz="2800" b="1" dirty="0">
              <a:solidFill>
                <a:srgbClr val="FF0000"/>
              </a:solidFill>
            </a:endParaRPr>
          </a:p>
        </p:txBody>
      </p:sp>
      <p:sp>
        <p:nvSpPr>
          <p:cNvPr id="66" name="文本框 65"/>
          <p:cNvSpPr txBox="1"/>
          <p:nvPr/>
        </p:nvSpPr>
        <p:spPr>
          <a:xfrm>
            <a:off x="8166205" y="13618950"/>
            <a:ext cx="620485" cy="5207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800" b="1" dirty="0" smtClean="0">
                <a:solidFill>
                  <a:srgbClr val="FF0000"/>
                </a:solidFill>
              </a:rPr>
              <a:t>**</a:t>
            </a:r>
            <a:endParaRPr lang="zh-CN" altLang="en-US" sz="2800" b="1" dirty="0">
              <a:solidFill>
                <a:srgbClr val="FF0000"/>
              </a:solidFill>
            </a:endParaRPr>
          </a:p>
        </p:txBody>
      </p:sp>
      <p:pic>
        <p:nvPicPr>
          <p:cNvPr id="76" name="图片 75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7656" y="15187782"/>
            <a:ext cx="5815432" cy="1146018"/>
          </a:xfrm>
          <a:prstGeom prst="rect">
            <a:avLst/>
          </a:prstGeom>
        </p:spPr>
      </p:pic>
      <p:grpSp>
        <p:nvGrpSpPr>
          <p:cNvPr id="43" name="组合 42"/>
          <p:cNvGrpSpPr/>
          <p:nvPr/>
        </p:nvGrpSpPr>
        <p:grpSpPr>
          <a:xfrm>
            <a:off x="2768886" y="16867720"/>
            <a:ext cx="5923606" cy="395565"/>
            <a:chOff x="2768886" y="16867720"/>
            <a:chExt cx="5923606" cy="395565"/>
          </a:xfrm>
        </p:grpSpPr>
        <p:sp>
          <p:nvSpPr>
            <p:cNvPr id="29" name="矩形 28"/>
            <p:cNvSpPr/>
            <p:nvPr/>
          </p:nvSpPr>
          <p:spPr>
            <a:xfrm>
              <a:off x="2768886" y="16890415"/>
              <a:ext cx="1050288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2 cycles</a:t>
              </a:r>
              <a:endParaRPr lang="zh-CN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0" name="直接连接符 39"/>
            <p:cNvCxnSpPr/>
            <p:nvPr/>
          </p:nvCxnSpPr>
          <p:spPr>
            <a:xfrm flipH="1">
              <a:off x="2913755" y="16867720"/>
              <a:ext cx="864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直接连接符 61"/>
            <p:cNvCxnSpPr/>
            <p:nvPr/>
          </p:nvCxnSpPr>
          <p:spPr>
            <a:xfrm flipH="1">
              <a:off x="4012492" y="16871258"/>
              <a:ext cx="4680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矩形 66"/>
            <p:cNvSpPr/>
            <p:nvPr/>
          </p:nvSpPr>
          <p:spPr>
            <a:xfrm>
              <a:off x="5813462" y="16893953"/>
              <a:ext cx="1050288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 cycles</a:t>
              </a:r>
              <a:endParaRPr lang="zh-CN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346364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组合 12"/>
          <p:cNvGrpSpPr/>
          <p:nvPr/>
        </p:nvGrpSpPr>
        <p:grpSpPr>
          <a:xfrm>
            <a:off x="1794636" y="1902354"/>
            <a:ext cx="16614836" cy="19171839"/>
            <a:chOff x="2121208" y="1347183"/>
            <a:chExt cx="16614836" cy="19171839"/>
          </a:xfrm>
        </p:grpSpPr>
        <p:graphicFrame>
          <p:nvGraphicFramePr>
            <p:cNvPr id="2" name="图表 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136048486"/>
                </p:ext>
              </p:extLst>
            </p:nvPr>
          </p:nvGraphicFramePr>
          <p:xfrm>
            <a:off x="2744575" y="6735614"/>
            <a:ext cx="7451484" cy="546447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3" name="图表 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052910137"/>
                </p:ext>
              </p:extLst>
            </p:nvPr>
          </p:nvGraphicFramePr>
          <p:xfrm>
            <a:off x="2840038" y="1347183"/>
            <a:ext cx="6964136" cy="511075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4" name="图表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828472823"/>
                </p:ext>
              </p:extLst>
            </p:nvPr>
          </p:nvGraphicFramePr>
          <p:xfrm>
            <a:off x="10812170" y="6670297"/>
            <a:ext cx="6929404" cy="590270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5" name="图表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98215050"/>
                </p:ext>
              </p:extLst>
            </p:nvPr>
          </p:nvGraphicFramePr>
          <p:xfrm>
            <a:off x="10771062" y="1347183"/>
            <a:ext cx="7003169" cy="511720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6" name="图表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71636599"/>
                </p:ext>
              </p:extLst>
            </p:nvPr>
          </p:nvGraphicFramePr>
          <p:xfrm>
            <a:off x="2803251" y="12483269"/>
            <a:ext cx="7166022" cy="517063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7" name="矩形 6"/>
            <p:cNvSpPr/>
            <p:nvPr/>
          </p:nvSpPr>
          <p:spPr>
            <a:xfrm>
              <a:off x="2121208" y="17841366"/>
              <a:ext cx="16614836" cy="267765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altLang="zh-CN" sz="3200" b="1" kern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l figure 7</a:t>
              </a:r>
              <a:r>
                <a:rPr lang="en-US" altLang="zh-CN" sz="3200" b="1" kern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Relative expression levels of </a:t>
              </a:r>
              <a:r>
                <a:rPr lang="en-US" altLang="zh-CN" sz="32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RNRL1</a:t>
              </a:r>
              <a:r>
                <a:rPr lang="en-US" altLang="zh-CN" sz="3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</a:t>
              </a:r>
              <a:r>
                <a:rPr lang="en-US" altLang="zh-CN" sz="32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E2F1</a:t>
              </a:r>
              <a:r>
                <a:rPr lang="en-US" altLang="zh-CN" sz="3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</a:t>
              </a:r>
              <a:r>
                <a:rPr lang="en-US" altLang="zh-CN" sz="32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sCDK2</a:t>
              </a:r>
              <a:r>
                <a:rPr lang="en-US" altLang="zh-CN" sz="3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</a:t>
              </a:r>
              <a:r>
                <a:rPr lang="en-US" altLang="zh-CN" sz="32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sCycA1:1 </a:t>
              </a:r>
              <a:r>
                <a:rPr lang="en-US" altLang="zh-CN" sz="3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</a:t>
              </a:r>
              <a:r>
                <a:rPr lang="en-US" altLang="zh-CN" sz="32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32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CycB1:1</a:t>
              </a:r>
              <a:r>
                <a:rPr lang="en-US" altLang="zh-CN" sz="3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3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 T</a:t>
              </a:r>
              <a:r>
                <a:rPr lang="en-US" altLang="zh-CN" sz="3200" b="1" baseline="-25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lang="en-US" altLang="zh-CN" sz="3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descendants of </a:t>
              </a:r>
              <a:r>
                <a:rPr lang="en-US" altLang="zh-CN" sz="32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C1-4 </a:t>
              </a:r>
              <a:r>
                <a:rPr lang="en-US" altLang="zh-CN" sz="3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</a:t>
              </a:r>
              <a:r>
                <a:rPr lang="en-US" altLang="zh-CN" sz="32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sC2-12, </a:t>
              </a:r>
              <a:r>
                <a:rPr lang="en-US" altLang="zh-CN" sz="3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 T</a:t>
              </a:r>
              <a:r>
                <a:rPr lang="en-US" altLang="zh-CN" sz="3200" b="1" baseline="-25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altLang="zh-CN" sz="3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descendants of </a:t>
              </a:r>
              <a:r>
                <a:rPr lang="en-US" altLang="zh-CN" sz="32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C1-8</a:t>
              </a:r>
              <a:r>
                <a:rPr lang="en-US" altLang="zh-CN" sz="3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</a:p>
            <a:p>
              <a:pPr>
                <a:lnSpc>
                  <a:spcPct val="150000"/>
                </a:lnSpc>
              </a:pPr>
              <a:r>
                <a:rPr lang="en-US" altLang="zh-CN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C1-4 T1-W, OsC2-12 T1-W and OsC1-8 T2-W were normal green descendants, </a:t>
              </a:r>
              <a:r>
                <a:rPr lang="en-US" altLang="zh-CN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C1-4 </a:t>
              </a:r>
              <a:r>
                <a:rPr lang="en-US" altLang="zh-CN" sz="2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1-1, </a:t>
              </a:r>
              <a:r>
                <a:rPr lang="en-US" altLang="zh-CN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C1-4 </a:t>
              </a:r>
              <a:r>
                <a:rPr lang="en-US" altLang="zh-CN" sz="2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1-2</a:t>
              </a:r>
              <a:r>
                <a:rPr lang="en-US" altLang="zh-CN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</a:t>
              </a:r>
              <a:r>
                <a:rPr lang="en-US" altLang="zh-CN" sz="2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C2-12 T1-1, </a:t>
              </a:r>
              <a:r>
                <a:rPr lang="en-US" altLang="zh-CN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C2-12 </a:t>
              </a:r>
              <a:r>
                <a:rPr lang="en-US" altLang="zh-CN" sz="2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1-2, </a:t>
              </a:r>
              <a:r>
                <a:rPr lang="en-US" altLang="zh-CN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C1-8 </a:t>
              </a:r>
              <a:r>
                <a:rPr lang="en-US" altLang="zh-CN" sz="2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2-1 and </a:t>
              </a:r>
              <a:r>
                <a:rPr lang="en-US" altLang="zh-CN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C1-8 </a:t>
              </a:r>
              <a:r>
                <a:rPr lang="en-US" altLang="zh-CN" sz="2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2-2 were striped descendants. </a:t>
              </a:r>
              <a:r>
                <a:rPr lang="en-US" altLang="zh-CN" sz="2000" dirty="0">
                  <a:latin typeface="Times New Roman" panose="02020603050405020304" pitchFamily="18" charset="0"/>
                </a:rPr>
                <a:t>Error bars, ±SD (n=3).</a:t>
              </a:r>
              <a:endParaRPr lang="zh-CN" altLang="zh-CN" sz="2000" kern="100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矩形 7"/>
            <p:cNvSpPr/>
            <p:nvPr/>
          </p:nvSpPr>
          <p:spPr>
            <a:xfrm rot="16200000">
              <a:off x="1031090" y="8822095"/>
              <a:ext cx="3395481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2400" b="1" kern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expression level</a:t>
              </a:r>
              <a:endParaRPr lang="zh-CN" altLang="en-US" sz="2400" dirty="0"/>
            </a:p>
          </p:txBody>
        </p:sp>
        <p:sp>
          <p:nvSpPr>
            <p:cNvPr id="9" name="矩形 8"/>
            <p:cNvSpPr/>
            <p:nvPr/>
          </p:nvSpPr>
          <p:spPr>
            <a:xfrm rot="16200000">
              <a:off x="1031090" y="3334077"/>
              <a:ext cx="3395481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2400" b="1" kern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expression level</a:t>
              </a:r>
              <a:endParaRPr lang="zh-CN" altLang="en-US" sz="2400" dirty="0"/>
            </a:p>
          </p:txBody>
        </p:sp>
        <p:sp>
          <p:nvSpPr>
            <p:cNvPr id="10" name="矩形 9"/>
            <p:cNvSpPr/>
            <p:nvPr/>
          </p:nvSpPr>
          <p:spPr>
            <a:xfrm rot="16200000">
              <a:off x="8961718" y="3334077"/>
              <a:ext cx="3395481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2400" b="1" kern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expression level</a:t>
              </a:r>
              <a:endParaRPr lang="zh-CN" altLang="en-US" sz="2400" dirty="0"/>
            </a:p>
          </p:txBody>
        </p:sp>
        <p:sp>
          <p:nvSpPr>
            <p:cNvPr id="11" name="矩形 10"/>
            <p:cNvSpPr/>
            <p:nvPr/>
          </p:nvSpPr>
          <p:spPr>
            <a:xfrm rot="16200000">
              <a:off x="8961718" y="8822095"/>
              <a:ext cx="3395481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2400" b="1" kern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expression level</a:t>
              </a:r>
              <a:endParaRPr lang="zh-CN" altLang="en-US" sz="2400" dirty="0"/>
            </a:p>
          </p:txBody>
        </p:sp>
        <p:sp>
          <p:nvSpPr>
            <p:cNvPr id="12" name="矩形 11"/>
            <p:cNvSpPr/>
            <p:nvPr/>
          </p:nvSpPr>
          <p:spPr>
            <a:xfrm rot="16200000">
              <a:off x="1031089" y="14310113"/>
              <a:ext cx="3395481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2400" b="1" kern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expression level</a:t>
              </a:r>
              <a:endParaRPr lang="zh-CN" altLang="en-US" sz="2400" dirty="0"/>
            </a:p>
          </p:txBody>
        </p:sp>
      </p:grpSp>
    </p:spTree>
    <p:extLst>
      <p:ext uri="{BB962C8B-B14F-4D97-AF65-F5344CB8AC3E}">
        <p14:creationId xmlns:p14="http://schemas.microsoft.com/office/powerpoint/2010/main" val="12121599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549</TotalTime>
  <Words>1119</Words>
  <Application>Microsoft Office PowerPoint</Application>
  <PresentationFormat>自定义</PresentationFormat>
  <Paragraphs>183</Paragraphs>
  <Slides>7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3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Tcj</dc:creator>
  <cp:lastModifiedBy>Tcj</cp:lastModifiedBy>
  <cp:revision>123</cp:revision>
  <dcterms:created xsi:type="dcterms:W3CDTF">2018-07-24T01:26:54Z</dcterms:created>
  <dcterms:modified xsi:type="dcterms:W3CDTF">2019-01-25T13:43:09Z</dcterms:modified>
</cp:coreProperties>
</file>